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uichao Zeng" initials="RZ" lastIdx="1" clrIdx="0">
    <p:extLst>
      <p:ext uri="{19B8F6BF-5375-455C-9EA6-DF929625EA0E}">
        <p15:presenceInfo xmlns:p15="http://schemas.microsoft.com/office/powerpoint/2012/main" userId="Ruichao Ze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808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91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DF6830-C390-4BC2-AC16-DFFF51C833FF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C55AAD-D353-4F02-A09B-422F43ACA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611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36397A-081A-55FE-0834-3FC5608215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003F56-EFC2-4783-0C2F-D2AFAFB92F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3F8FF-45DB-539D-466D-EC412980A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590AB-CFFF-2DF8-DCAA-9D25127CE2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060954-151C-9CCF-10E4-66FD25234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758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624237-E482-3877-BBF3-C0E893D41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00D7B0-EC3F-EAA5-EA1C-A29158AFCF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15AAE3-7958-463D-ED25-51998A8CD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D5D3E-2E48-189C-76E8-817922E2A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3F01E4-4AC7-5294-77F5-29568666E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276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E4FA51-1B43-F91D-35AE-5F8E59A744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070178-2F21-891C-8ED6-E5DB8F1C9D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7F6B8D-E29B-5218-DB6F-75DF7623D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A74B2B-05AE-80E9-5BFE-B803FE2C6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25E41-E650-3651-40A4-051498636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295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5EA62-91C5-1AA1-07B9-7A74D05B1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83C7C4-5C7A-B8E3-1044-746AEDAD05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217164-0EF5-D1D4-35BE-04E743217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F8D73-A5D8-F9A4-1DFE-08FE90E55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03BAE6-2788-313F-818C-15B03E95B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6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869BF-6B48-0C57-423B-6C49A44102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3ADA4B-3D0D-0F53-66DA-1750D01CBE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D0952-A5D4-6C1F-71C6-98CADFDA7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1A2FC6-DF14-6F32-EF46-2D4763902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D32226-41F1-3194-AB50-64E37EE53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378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958314-16F3-D890-3BD2-8A3C49EA2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AF8D7-3EFA-DFDF-4993-CC3182EF61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CC8924-DFF8-9CBB-8E81-CB276CF862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88AD78-481B-49C2-7C82-BEE8AEEEC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0183F3-97AD-8BFC-55E8-8AF02A792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B8F95C-F7EC-E5F3-47F7-74B197D0E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496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3F0F5-A995-CFC8-74E0-8D460315E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50DCE3-9D20-58BD-CD67-BEA2D1F4D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4B578D-2442-96B4-FF15-6F70FACF90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3C06E5-7BF9-4A36-7568-7F4294BD7A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BA1DF9-BFA9-3771-4778-7ECB4254F8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9C7BA3-EE8B-C91F-26A5-66A9922E5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D0FEC6-84E9-56B0-BBA0-9A2D2A7A7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054F65-BAC6-D59B-66D1-F058EB4F1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225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BB63F-E3AB-C112-2002-FC5B7942E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D01597-A2B5-6CDB-D884-01EEFC6329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7F0E25-BD67-1AE1-E36A-A17B175B9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591F91-ECE2-1870-897D-D54E9ED0B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789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98887F-BC80-3956-4A9E-683CB9D3D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8D1E0F-46D0-331A-F428-08D14BD09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86A072-6AAE-9360-5923-E49889235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085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4F9A2-927F-FC2B-409E-351E0CF8DE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9C5112-8284-B33A-2157-1D5DE1AFCF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0D0952-B28A-BCBC-EB28-C4D66FEE3D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9980EE-CB0F-6E21-18EA-75FDDA694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C11D9A-7A57-3EE2-0C19-CE446A1BC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5DE3FD-9BC8-0391-DC99-E18B1A92A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47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4B9CF-FF44-E859-A8CF-E9850C402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800439-BC09-2E75-93F1-27A68DCBE2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5DC5B3-DEF7-3393-21BF-071218F3DE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806927-2B7E-2AEE-22B6-113B20E55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CEB3BB-4437-BF40-7357-6D7940963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73573A-2797-0BA8-0D0F-1881FD4C9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67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7DC9A8-F296-086C-9613-F3D5A6F82A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952FC2-D134-F95E-E91F-927E2CFEC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D31F7F-C2CC-C1F7-50C0-BEB2ED5EE3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02EEA-822E-4047-9629-2C6E3DF7ED46}" type="datetimeFigureOut">
              <a:rPr lang="en-US" smtClean="0"/>
              <a:t>3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ED9DF3-70B1-D1F2-4A39-84922CC128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074C3-3C9B-EFE5-3DF9-3135B49C5A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1EBD2-F7CE-4CCC-8E11-AB6C24249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757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: Shape 8">
            <a:extLst>
              <a:ext uri="{FF2B5EF4-FFF2-40B4-BE49-F238E27FC236}">
                <a16:creationId xmlns:a16="http://schemas.microsoft.com/office/drawing/2014/main" id="{7092B91E-086A-3DDE-099A-35903FCBF5F7}"/>
              </a:ext>
            </a:extLst>
          </p:cNvPr>
          <p:cNvSpPr/>
          <p:nvPr/>
        </p:nvSpPr>
        <p:spPr>
          <a:xfrm>
            <a:off x="1602239" y="460600"/>
            <a:ext cx="7794948" cy="5843161"/>
          </a:xfrm>
          <a:custGeom>
            <a:avLst/>
            <a:gdLst>
              <a:gd name="connsiteX0" fmla="*/ 0 w 7794948"/>
              <a:gd name="connsiteY0" fmla="*/ 0 h 5843161"/>
              <a:gd name="connsiteX1" fmla="*/ 7794949 w 7794948"/>
              <a:gd name="connsiteY1" fmla="*/ 0 h 5843161"/>
              <a:gd name="connsiteX2" fmla="*/ 7794949 w 7794948"/>
              <a:gd name="connsiteY2" fmla="*/ 5843162 h 5843161"/>
              <a:gd name="connsiteX3" fmla="*/ 0 w 7794948"/>
              <a:gd name="connsiteY3" fmla="*/ 5843162 h 58431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794948" h="5843161">
                <a:moveTo>
                  <a:pt x="0" y="0"/>
                </a:moveTo>
                <a:lnTo>
                  <a:pt x="7794949" y="0"/>
                </a:lnTo>
                <a:lnTo>
                  <a:pt x="7794949" y="5843162"/>
                </a:lnTo>
                <a:lnTo>
                  <a:pt x="0" y="5843162"/>
                </a:lnTo>
                <a:close/>
              </a:path>
            </a:pathLst>
          </a:custGeom>
          <a:solidFill>
            <a:srgbClr val="FFFF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787648EB-D3BF-D2FE-641C-67A5D7BE2E42}"/>
              </a:ext>
            </a:extLst>
          </p:cNvPr>
          <p:cNvSpPr/>
          <p:nvPr/>
        </p:nvSpPr>
        <p:spPr>
          <a:xfrm>
            <a:off x="1602239" y="460600"/>
            <a:ext cx="7794948" cy="5843161"/>
          </a:xfrm>
          <a:custGeom>
            <a:avLst/>
            <a:gdLst>
              <a:gd name="connsiteX0" fmla="*/ 0 w 7794948"/>
              <a:gd name="connsiteY0" fmla="*/ 0 h 5843161"/>
              <a:gd name="connsiteX1" fmla="*/ 7794949 w 7794948"/>
              <a:gd name="connsiteY1" fmla="*/ 0 h 5843161"/>
              <a:gd name="connsiteX2" fmla="*/ 7794949 w 7794948"/>
              <a:gd name="connsiteY2" fmla="*/ 5843162 h 5843161"/>
              <a:gd name="connsiteX3" fmla="*/ 0 w 7794948"/>
              <a:gd name="connsiteY3" fmla="*/ 5843162 h 58431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794948" h="5843161">
                <a:moveTo>
                  <a:pt x="0" y="0"/>
                </a:moveTo>
                <a:lnTo>
                  <a:pt x="7794949" y="0"/>
                </a:lnTo>
                <a:lnTo>
                  <a:pt x="7794949" y="5843162"/>
                </a:lnTo>
                <a:lnTo>
                  <a:pt x="0" y="5843162"/>
                </a:lnTo>
                <a:close/>
              </a:path>
            </a:pathLst>
          </a:custGeom>
          <a:solidFill>
            <a:srgbClr val="FFFF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78D8C0FF-6C16-9D93-DB33-C4E0F4B48D3D}"/>
              </a:ext>
            </a:extLst>
          </p:cNvPr>
          <p:cNvSpPr/>
          <p:nvPr/>
        </p:nvSpPr>
        <p:spPr>
          <a:xfrm>
            <a:off x="1602239" y="460600"/>
            <a:ext cx="7794948" cy="5843161"/>
          </a:xfrm>
          <a:custGeom>
            <a:avLst/>
            <a:gdLst>
              <a:gd name="connsiteX0" fmla="*/ 0 w 7794948"/>
              <a:gd name="connsiteY0" fmla="*/ 0 h 5843161"/>
              <a:gd name="connsiteX1" fmla="*/ 7794949 w 7794948"/>
              <a:gd name="connsiteY1" fmla="*/ 0 h 5843161"/>
              <a:gd name="connsiteX2" fmla="*/ 7794949 w 7794948"/>
              <a:gd name="connsiteY2" fmla="*/ 5843162 h 5843161"/>
              <a:gd name="connsiteX3" fmla="*/ 0 w 7794948"/>
              <a:gd name="connsiteY3" fmla="*/ 5843162 h 58431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794948" h="5843161">
                <a:moveTo>
                  <a:pt x="0" y="0"/>
                </a:moveTo>
                <a:lnTo>
                  <a:pt x="7794949" y="0"/>
                </a:lnTo>
                <a:lnTo>
                  <a:pt x="7794949" y="5843162"/>
                </a:lnTo>
                <a:lnTo>
                  <a:pt x="0" y="5843162"/>
                </a:lnTo>
                <a:close/>
              </a:path>
            </a:pathLst>
          </a:custGeom>
          <a:noFill/>
          <a:ln w="12185" cap="flat">
            <a:solidFill>
              <a:srgbClr val="00000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grpSp>
        <p:nvGrpSpPr>
          <p:cNvPr id="12" name="Graphic 4">
            <a:extLst>
              <a:ext uri="{FF2B5EF4-FFF2-40B4-BE49-F238E27FC236}">
                <a16:creationId xmlns:a16="http://schemas.microsoft.com/office/drawing/2014/main" id="{0EF187F3-8F1C-6DF8-9F90-C926CC3C3432}"/>
              </a:ext>
            </a:extLst>
          </p:cNvPr>
          <p:cNvGrpSpPr/>
          <p:nvPr/>
        </p:nvGrpSpPr>
        <p:grpSpPr>
          <a:xfrm>
            <a:off x="1747069" y="569527"/>
            <a:ext cx="7515952" cy="5600048"/>
            <a:chOff x="1314363" y="540954"/>
            <a:chExt cx="7515952" cy="5600048"/>
          </a:xfrm>
        </p:grpSpPr>
        <p:grpSp>
          <p:nvGrpSpPr>
            <p:cNvPr id="13" name="Graphic 4">
              <a:extLst>
                <a:ext uri="{FF2B5EF4-FFF2-40B4-BE49-F238E27FC236}">
                  <a16:creationId xmlns:a16="http://schemas.microsoft.com/office/drawing/2014/main" id="{11260CA6-9839-2723-001C-29A97D519FA4}"/>
                </a:ext>
              </a:extLst>
            </p:cNvPr>
            <p:cNvGrpSpPr/>
            <p:nvPr/>
          </p:nvGrpSpPr>
          <p:grpSpPr>
            <a:xfrm>
              <a:off x="1314363" y="540954"/>
              <a:ext cx="7515952" cy="5241491"/>
              <a:chOff x="1314363" y="540954"/>
              <a:chExt cx="7515952" cy="5241491"/>
            </a:xfrm>
          </p:grpSpPr>
          <p:sp>
            <p:nvSpPr>
              <p:cNvPr id="14" name="Freeform: Shape 13">
                <a:extLst>
                  <a:ext uri="{FF2B5EF4-FFF2-40B4-BE49-F238E27FC236}">
                    <a16:creationId xmlns:a16="http://schemas.microsoft.com/office/drawing/2014/main" id="{1199D7E7-9A97-EB5C-33AC-C1415088C79A}"/>
                  </a:ext>
                </a:extLst>
              </p:cNvPr>
              <p:cNvSpPr/>
              <p:nvPr/>
            </p:nvSpPr>
            <p:spPr>
              <a:xfrm>
                <a:off x="1498581" y="540954"/>
                <a:ext cx="7331734" cy="4698427"/>
              </a:xfrm>
              <a:custGeom>
                <a:avLst/>
                <a:gdLst>
                  <a:gd name="connsiteX0" fmla="*/ 11 w 7331734"/>
                  <a:gd name="connsiteY0" fmla="*/ 11 h 4698427"/>
                  <a:gd name="connsiteX1" fmla="*/ 7331745 w 7331734"/>
                  <a:gd name="connsiteY1" fmla="*/ 11 h 4698427"/>
                  <a:gd name="connsiteX2" fmla="*/ 7331745 w 7331734"/>
                  <a:gd name="connsiteY2" fmla="*/ 4698438 h 4698427"/>
                  <a:gd name="connsiteX3" fmla="*/ 11 w 7331734"/>
                  <a:gd name="connsiteY3" fmla="*/ 4698438 h 4698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331734" h="4698427">
                    <a:moveTo>
                      <a:pt x="11" y="11"/>
                    </a:moveTo>
                    <a:lnTo>
                      <a:pt x="7331745" y="11"/>
                    </a:lnTo>
                    <a:lnTo>
                      <a:pt x="7331745" y="4698438"/>
                    </a:lnTo>
                    <a:lnTo>
                      <a:pt x="11" y="4698438"/>
                    </a:lnTo>
                    <a:close/>
                  </a:path>
                </a:pathLst>
              </a:custGeom>
              <a:solidFill>
                <a:srgbClr val="FFFFFF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grpSp>
            <p:nvGrpSpPr>
              <p:cNvPr id="15" name="Graphic 4">
                <a:extLst>
                  <a:ext uri="{FF2B5EF4-FFF2-40B4-BE49-F238E27FC236}">
                    <a16:creationId xmlns:a16="http://schemas.microsoft.com/office/drawing/2014/main" id="{BF219AEE-7E38-6386-D228-E0BED50FB3AB}"/>
                  </a:ext>
                </a:extLst>
              </p:cNvPr>
              <p:cNvGrpSpPr/>
              <p:nvPr/>
            </p:nvGrpSpPr>
            <p:grpSpPr>
              <a:xfrm>
                <a:off x="1522958" y="700105"/>
                <a:ext cx="6860287" cy="3857482"/>
                <a:chOff x="1522958" y="700105"/>
                <a:chExt cx="6860287" cy="3857482"/>
              </a:xfrm>
            </p:grpSpPr>
            <p:sp>
              <p:nvSpPr>
                <p:cNvPr id="16" name="Freeform: Shape 15">
                  <a:extLst>
                    <a:ext uri="{FF2B5EF4-FFF2-40B4-BE49-F238E27FC236}">
                      <a16:creationId xmlns:a16="http://schemas.microsoft.com/office/drawing/2014/main" id="{B452C8C8-5B05-C4F6-8907-B884E68BB0EA}"/>
                    </a:ext>
                  </a:extLst>
                </p:cNvPr>
                <p:cNvSpPr/>
                <p:nvPr/>
              </p:nvSpPr>
              <p:spPr>
                <a:xfrm>
                  <a:off x="2114464" y="1913836"/>
                  <a:ext cx="6268781" cy="194753"/>
                </a:xfrm>
                <a:custGeom>
                  <a:avLst/>
                  <a:gdLst>
                    <a:gd name="connsiteX0" fmla="*/ 11 w 6268781"/>
                    <a:gd name="connsiteY0" fmla="*/ 146076 h 194753"/>
                    <a:gd name="connsiteX1" fmla="*/ 6084743 w 6268781"/>
                    <a:gd name="connsiteY1" fmla="*/ 146076 h 194753"/>
                    <a:gd name="connsiteX2" fmla="*/ 6084743 w 6268781"/>
                    <a:gd name="connsiteY2" fmla="*/ 194764 h 194753"/>
                    <a:gd name="connsiteX3" fmla="*/ 6268793 w 6268781"/>
                    <a:gd name="connsiteY3" fmla="*/ 97388 h 194753"/>
                    <a:gd name="connsiteX4" fmla="*/ 6084743 w 6268781"/>
                    <a:gd name="connsiteY4" fmla="*/ 11 h 194753"/>
                    <a:gd name="connsiteX5" fmla="*/ 6084743 w 6268781"/>
                    <a:gd name="connsiteY5" fmla="*/ 48699 h 194753"/>
                    <a:gd name="connsiteX6" fmla="*/ 11 w 6268781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6268781" h="194753">
                      <a:moveTo>
                        <a:pt x="11" y="146076"/>
                      </a:moveTo>
                      <a:lnTo>
                        <a:pt x="6084743" y="146076"/>
                      </a:lnTo>
                      <a:lnTo>
                        <a:pt x="6084743" y="194764"/>
                      </a:lnTo>
                      <a:lnTo>
                        <a:pt x="6268793" y="97388"/>
                      </a:lnTo>
                      <a:lnTo>
                        <a:pt x="6084743" y="11"/>
                      </a:lnTo>
                      <a:lnTo>
                        <a:pt x="6084743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" name="Freeform: Shape 16">
                  <a:extLst>
                    <a:ext uri="{FF2B5EF4-FFF2-40B4-BE49-F238E27FC236}">
                      <a16:creationId xmlns:a16="http://schemas.microsoft.com/office/drawing/2014/main" id="{9DF7F1C6-D335-379E-7CD1-D24888C12C7A}"/>
                    </a:ext>
                  </a:extLst>
                </p:cNvPr>
                <p:cNvSpPr/>
                <p:nvPr/>
              </p:nvSpPr>
              <p:spPr>
                <a:xfrm>
                  <a:off x="2114464" y="4341299"/>
                  <a:ext cx="6268781" cy="194753"/>
                </a:xfrm>
                <a:custGeom>
                  <a:avLst/>
                  <a:gdLst>
                    <a:gd name="connsiteX0" fmla="*/ 11 w 6268781"/>
                    <a:gd name="connsiteY0" fmla="*/ 146076 h 194753"/>
                    <a:gd name="connsiteX1" fmla="*/ 6084743 w 6268781"/>
                    <a:gd name="connsiteY1" fmla="*/ 146076 h 194753"/>
                    <a:gd name="connsiteX2" fmla="*/ 6084743 w 6268781"/>
                    <a:gd name="connsiteY2" fmla="*/ 194765 h 194753"/>
                    <a:gd name="connsiteX3" fmla="*/ 6268793 w 6268781"/>
                    <a:gd name="connsiteY3" fmla="*/ 97388 h 194753"/>
                    <a:gd name="connsiteX4" fmla="*/ 6084743 w 6268781"/>
                    <a:gd name="connsiteY4" fmla="*/ 11 h 194753"/>
                    <a:gd name="connsiteX5" fmla="*/ 6084743 w 6268781"/>
                    <a:gd name="connsiteY5" fmla="*/ 48699 h 194753"/>
                    <a:gd name="connsiteX6" fmla="*/ 11 w 6268781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6268781" h="194753">
                      <a:moveTo>
                        <a:pt x="11" y="146076"/>
                      </a:moveTo>
                      <a:lnTo>
                        <a:pt x="6084743" y="146076"/>
                      </a:lnTo>
                      <a:lnTo>
                        <a:pt x="6084743" y="194765"/>
                      </a:lnTo>
                      <a:lnTo>
                        <a:pt x="6268793" y="97388"/>
                      </a:lnTo>
                      <a:lnTo>
                        <a:pt x="6084743" y="11"/>
                      </a:lnTo>
                      <a:lnTo>
                        <a:pt x="6084743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" name="Freeform: Shape 17">
                  <a:extLst>
                    <a:ext uri="{FF2B5EF4-FFF2-40B4-BE49-F238E27FC236}">
                      <a16:creationId xmlns:a16="http://schemas.microsoft.com/office/drawing/2014/main" id="{450F4317-43B3-075F-4679-299C52333EDF}"/>
                    </a:ext>
                  </a:extLst>
                </p:cNvPr>
                <p:cNvSpPr/>
                <p:nvPr/>
              </p:nvSpPr>
              <p:spPr>
                <a:xfrm>
                  <a:off x="2114464" y="1610403"/>
                  <a:ext cx="6268781" cy="194753"/>
                </a:xfrm>
                <a:custGeom>
                  <a:avLst/>
                  <a:gdLst>
                    <a:gd name="connsiteX0" fmla="*/ 11 w 6268781"/>
                    <a:gd name="connsiteY0" fmla="*/ 146076 h 194753"/>
                    <a:gd name="connsiteX1" fmla="*/ 6084743 w 6268781"/>
                    <a:gd name="connsiteY1" fmla="*/ 146076 h 194753"/>
                    <a:gd name="connsiteX2" fmla="*/ 6084743 w 6268781"/>
                    <a:gd name="connsiteY2" fmla="*/ 194764 h 194753"/>
                    <a:gd name="connsiteX3" fmla="*/ 6268793 w 6268781"/>
                    <a:gd name="connsiteY3" fmla="*/ 97388 h 194753"/>
                    <a:gd name="connsiteX4" fmla="*/ 6084743 w 6268781"/>
                    <a:gd name="connsiteY4" fmla="*/ 11 h 194753"/>
                    <a:gd name="connsiteX5" fmla="*/ 6084743 w 6268781"/>
                    <a:gd name="connsiteY5" fmla="*/ 48699 h 194753"/>
                    <a:gd name="connsiteX6" fmla="*/ 11 w 6268781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6268781" h="194753">
                      <a:moveTo>
                        <a:pt x="11" y="146076"/>
                      </a:moveTo>
                      <a:lnTo>
                        <a:pt x="6084743" y="146076"/>
                      </a:lnTo>
                      <a:lnTo>
                        <a:pt x="6084743" y="194764"/>
                      </a:lnTo>
                      <a:lnTo>
                        <a:pt x="6268793" y="97388"/>
                      </a:lnTo>
                      <a:lnTo>
                        <a:pt x="6084743" y="11"/>
                      </a:lnTo>
                      <a:lnTo>
                        <a:pt x="6084743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" name="Freeform: Shape 18">
                  <a:extLst>
                    <a:ext uri="{FF2B5EF4-FFF2-40B4-BE49-F238E27FC236}">
                      <a16:creationId xmlns:a16="http://schemas.microsoft.com/office/drawing/2014/main" id="{B9E63552-5563-C0BC-04FE-06AA63F7FBAA}"/>
                    </a:ext>
                  </a:extLst>
                </p:cNvPr>
                <p:cNvSpPr/>
                <p:nvPr/>
              </p:nvSpPr>
              <p:spPr>
                <a:xfrm>
                  <a:off x="2114464" y="4086554"/>
                  <a:ext cx="3964082" cy="97376"/>
                </a:xfrm>
                <a:custGeom>
                  <a:avLst/>
                  <a:gdLst>
                    <a:gd name="connsiteX0" fmla="*/ 11 w 3964082"/>
                    <a:gd name="connsiteY0" fmla="*/ 11 h 97376"/>
                    <a:gd name="connsiteX1" fmla="*/ 3964094 w 3964082"/>
                    <a:gd name="connsiteY1" fmla="*/ 11 h 97376"/>
                    <a:gd name="connsiteX2" fmla="*/ 3964094 w 3964082"/>
                    <a:gd name="connsiteY2" fmla="*/ 97388 h 97376"/>
                    <a:gd name="connsiteX3" fmla="*/ 11 w 3964082"/>
                    <a:gd name="connsiteY3" fmla="*/ 97388 h 973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3964082" h="97376">
                      <a:moveTo>
                        <a:pt x="11" y="11"/>
                      </a:moveTo>
                      <a:lnTo>
                        <a:pt x="3964094" y="11"/>
                      </a:lnTo>
                      <a:lnTo>
                        <a:pt x="3964094" y="97388"/>
                      </a:lnTo>
                      <a:lnTo>
                        <a:pt x="11" y="97388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" name="Freeform: Shape 19">
                  <a:extLst>
                    <a:ext uri="{FF2B5EF4-FFF2-40B4-BE49-F238E27FC236}">
                      <a16:creationId xmlns:a16="http://schemas.microsoft.com/office/drawing/2014/main" id="{967AE8DE-8F42-BB68-A2CA-EE63D9576423}"/>
                    </a:ext>
                  </a:extLst>
                </p:cNvPr>
                <p:cNvSpPr/>
                <p:nvPr/>
              </p:nvSpPr>
              <p:spPr>
                <a:xfrm>
                  <a:off x="2114464" y="1355659"/>
                  <a:ext cx="4148458" cy="97376"/>
                </a:xfrm>
                <a:custGeom>
                  <a:avLst/>
                  <a:gdLst>
                    <a:gd name="connsiteX0" fmla="*/ 11 w 4148458"/>
                    <a:gd name="connsiteY0" fmla="*/ 11 h 97376"/>
                    <a:gd name="connsiteX1" fmla="*/ 4148470 w 4148458"/>
                    <a:gd name="connsiteY1" fmla="*/ 11 h 97376"/>
                    <a:gd name="connsiteX2" fmla="*/ 4148470 w 4148458"/>
                    <a:gd name="connsiteY2" fmla="*/ 97388 h 97376"/>
                    <a:gd name="connsiteX3" fmla="*/ 11 w 4148458"/>
                    <a:gd name="connsiteY3" fmla="*/ 97388 h 973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4148458" h="97376">
                      <a:moveTo>
                        <a:pt x="11" y="11"/>
                      </a:moveTo>
                      <a:lnTo>
                        <a:pt x="4148470" y="11"/>
                      </a:lnTo>
                      <a:lnTo>
                        <a:pt x="4148470" y="97388"/>
                      </a:lnTo>
                      <a:lnTo>
                        <a:pt x="11" y="97388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" name="Freeform: Shape 20">
                  <a:extLst>
                    <a:ext uri="{FF2B5EF4-FFF2-40B4-BE49-F238E27FC236}">
                      <a16:creationId xmlns:a16="http://schemas.microsoft.com/office/drawing/2014/main" id="{41FC159D-5E44-1F11-24DF-7C9208C01165}"/>
                    </a:ext>
                  </a:extLst>
                </p:cNvPr>
                <p:cNvSpPr/>
                <p:nvPr/>
              </p:nvSpPr>
              <p:spPr>
                <a:xfrm>
                  <a:off x="2114464" y="1003538"/>
                  <a:ext cx="6084405" cy="194753"/>
                </a:xfrm>
                <a:custGeom>
                  <a:avLst/>
                  <a:gdLst>
                    <a:gd name="connsiteX0" fmla="*/ 11 w 6084405"/>
                    <a:gd name="connsiteY0" fmla="*/ 146076 h 194753"/>
                    <a:gd name="connsiteX1" fmla="*/ 5900367 w 6084405"/>
                    <a:gd name="connsiteY1" fmla="*/ 146076 h 194753"/>
                    <a:gd name="connsiteX2" fmla="*/ 5900367 w 6084405"/>
                    <a:gd name="connsiteY2" fmla="*/ 194764 h 194753"/>
                    <a:gd name="connsiteX3" fmla="*/ 6084417 w 6084405"/>
                    <a:gd name="connsiteY3" fmla="*/ 97388 h 194753"/>
                    <a:gd name="connsiteX4" fmla="*/ 5900367 w 6084405"/>
                    <a:gd name="connsiteY4" fmla="*/ 11 h 194753"/>
                    <a:gd name="connsiteX5" fmla="*/ 5900367 w 6084405"/>
                    <a:gd name="connsiteY5" fmla="*/ 48699 h 194753"/>
                    <a:gd name="connsiteX6" fmla="*/ 11 w 6084405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6084405" h="194753">
                      <a:moveTo>
                        <a:pt x="11" y="146076"/>
                      </a:moveTo>
                      <a:lnTo>
                        <a:pt x="5900367" y="146076"/>
                      </a:lnTo>
                      <a:lnTo>
                        <a:pt x="5900367" y="194764"/>
                      </a:lnTo>
                      <a:lnTo>
                        <a:pt x="6084417" y="97388"/>
                      </a:lnTo>
                      <a:lnTo>
                        <a:pt x="5900367" y="11"/>
                      </a:lnTo>
                      <a:lnTo>
                        <a:pt x="5900367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" name="Freeform: Shape 21">
                  <a:extLst>
                    <a:ext uri="{FF2B5EF4-FFF2-40B4-BE49-F238E27FC236}">
                      <a16:creationId xmlns:a16="http://schemas.microsoft.com/office/drawing/2014/main" id="{95ACBFCA-7167-0B3A-B87C-0991ECD557B3}"/>
                    </a:ext>
                  </a:extLst>
                </p:cNvPr>
                <p:cNvSpPr/>
                <p:nvPr/>
              </p:nvSpPr>
              <p:spPr>
                <a:xfrm>
                  <a:off x="2114464" y="3734433"/>
                  <a:ext cx="5992217" cy="194753"/>
                </a:xfrm>
                <a:custGeom>
                  <a:avLst/>
                  <a:gdLst>
                    <a:gd name="connsiteX0" fmla="*/ 11 w 5992217"/>
                    <a:gd name="connsiteY0" fmla="*/ 146076 h 194753"/>
                    <a:gd name="connsiteX1" fmla="*/ 5808179 w 5992217"/>
                    <a:gd name="connsiteY1" fmla="*/ 146076 h 194753"/>
                    <a:gd name="connsiteX2" fmla="*/ 5808179 w 5992217"/>
                    <a:gd name="connsiteY2" fmla="*/ 194765 h 194753"/>
                    <a:gd name="connsiteX3" fmla="*/ 5992229 w 5992217"/>
                    <a:gd name="connsiteY3" fmla="*/ 97388 h 194753"/>
                    <a:gd name="connsiteX4" fmla="*/ 5808179 w 5992217"/>
                    <a:gd name="connsiteY4" fmla="*/ 11 h 194753"/>
                    <a:gd name="connsiteX5" fmla="*/ 5808179 w 5992217"/>
                    <a:gd name="connsiteY5" fmla="*/ 48700 h 194753"/>
                    <a:gd name="connsiteX6" fmla="*/ 11 w 5992217"/>
                    <a:gd name="connsiteY6" fmla="*/ 48700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992217" h="194753">
                      <a:moveTo>
                        <a:pt x="11" y="146076"/>
                      </a:moveTo>
                      <a:lnTo>
                        <a:pt x="5808179" y="146076"/>
                      </a:lnTo>
                      <a:lnTo>
                        <a:pt x="5808179" y="194765"/>
                      </a:lnTo>
                      <a:lnTo>
                        <a:pt x="5992229" y="97388"/>
                      </a:lnTo>
                      <a:lnTo>
                        <a:pt x="5808179" y="11"/>
                      </a:lnTo>
                      <a:lnTo>
                        <a:pt x="5808179" y="48700"/>
                      </a:lnTo>
                      <a:lnTo>
                        <a:pt x="11" y="48700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" name="Freeform: Shape 22">
                  <a:extLst>
                    <a:ext uri="{FF2B5EF4-FFF2-40B4-BE49-F238E27FC236}">
                      <a16:creationId xmlns:a16="http://schemas.microsoft.com/office/drawing/2014/main" id="{DB323E37-C4B4-D111-479D-31813EB9CAA2}"/>
                    </a:ext>
                  </a:extLst>
                </p:cNvPr>
                <p:cNvSpPr/>
                <p:nvPr/>
              </p:nvSpPr>
              <p:spPr>
                <a:xfrm>
                  <a:off x="2114464" y="3479689"/>
                  <a:ext cx="5807841" cy="97376"/>
                </a:xfrm>
                <a:custGeom>
                  <a:avLst/>
                  <a:gdLst>
                    <a:gd name="connsiteX0" fmla="*/ 11 w 5807841"/>
                    <a:gd name="connsiteY0" fmla="*/ 11 h 97376"/>
                    <a:gd name="connsiteX1" fmla="*/ 5807853 w 5807841"/>
                    <a:gd name="connsiteY1" fmla="*/ 11 h 97376"/>
                    <a:gd name="connsiteX2" fmla="*/ 5807853 w 5807841"/>
                    <a:gd name="connsiteY2" fmla="*/ 97388 h 97376"/>
                    <a:gd name="connsiteX3" fmla="*/ 11 w 5807841"/>
                    <a:gd name="connsiteY3" fmla="*/ 97388 h 973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807841" h="97376">
                      <a:moveTo>
                        <a:pt x="11" y="11"/>
                      </a:moveTo>
                      <a:lnTo>
                        <a:pt x="5807853" y="11"/>
                      </a:lnTo>
                      <a:lnTo>
                        <a:pt x="5807853" y="97388"/>
                      </a:lnTo>
                      <a:lnTo>
                        <a:pt x="11" y="97388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" name="Freeform: Shape 23">
                  <a:extLst>
                    <a:ext uri="{FF2B5EF4-FFF2-40B4-BE49-F238E27FC236}">
                      <a16:creationId xmlns:a16="http://schemas.microsoft.com/office/drawing/2014/main" id="{2E5B0E32-7279-387C-ADCA-72842B32AB35}"/>
                    </a:ext>
                  </a:extLst>
                </p:cNvPr>
                <p:cNvSpPr/>
                <p:nvPr/>
              </p:nvSpPr>
              <p:spPr>
                <a:xfrm>
                  <a:off x="2114464" y="3127568"/>
                  <a:ext cx="5715653" cy="194753"/>
                </a:xfrm>
                <a:custGeom>
                  <a:avLst/>
                  <a:gdLst>
                    <a:gd name="connsiteX0" fmla="*/ 11 w 5715653"/>
                    <a:gd name="connsiteY0" fmla="*/ 146076 h 194753"/>
                    <a:gd name="connsiteX1" fmla="*/ 5531615 w 5715653"/>
                    <a:gd name="connsiteY1" fmla="*/ 146076 h 194753"/>
                    <a:gd name="connsiteX2" fmla="*/ 5531615 w 5715653"/>
                    <a:gd name="connsiteY2" fmla="*/ 194764 h 194753"/>
                    <a:gd name="connsiteX3" fmla="*/ 5715665 w 5715653"/>
                    <a:gd name="connsiteY3" fmla="*/ 97388 h 194753"/>
                    <a:gd name="connsiteX4" fmla="*/ 5531615 w 5715653"/>
                    <a:gd name="connsiteY4" fmla="*/ 11 h 194753"/>
                    <a:gd name="connsiteX5" fmla="*/ 5531615 w 5715653"/>
                    <a:gd name="connsiteY5" fmla="*/ 48699 h 194753"/>
                    <a:gd name="connsiteX6" fmla="*/ 11 w 5715653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715653" h="194753">
                      <a:moveTo>
                        <a:pt x="11" y="146076"/>
                      </a:moveTo>
                      <a:lnTo>
                        <a:pt x="5531615" y="146076"/>
                      </a:lnTo>
                      <a:lnTo>
                        <a:pt x="5531615" y="194764"/>
                      </a:lnTo>
                      <a:lnTo>
                        <a:pt x="5715665" y="97388"/>
                      </a:lnTo>
                      <a:lnTo>
                        <a:pt x="5531615" y="11"/>
                      </a:lnTo>
                      <a:lnTo>
                        <a:pt x="5531615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" name="Freeform: Shape 24">
                  <a:extLst>
                    <a:ext uri="{FF2B5EF4-FFF2-40B4-BE49-F238E27FC236}">
                      <a16:creationId xmlns:a16="http://schemas.microsoft.com/office/drawing/2014/main" id="{98842038-02EB-1E67-2104-5F72957B08C6}"/>
                    </a:ext>
                  </a:extLst>
                </p:cNvPr>
                <p:cNvSpPr/>
                <p:nvPr/>
              </p:nvSpPr>
              <p:spPr>
                <a:xfrm>
                  <a:off x="2114464" y="2824135"/>
                  <a:ext cx="5715653" cy="194753"/>
                </a:xfrm>
                <a:custGeom>
                  <a:avLst/>
                  <a:gdLst>
                    <a:gd name="connsiteX0" fmla="*/ 11 w 5715653"/>
                    <a:gd name="connsiteY0" fmla="*/ 146076 h 194753"/>
                    <a:gd name="connsiteX1" fmla="*/ 5531615 w 5715653"/>
                    <a:gd name="connsiteY1" fmla="*/ 146076 h 194753"/>
                    <a:gd name="connsiteX2" fmla="*/ 5531615 w 5715653"/>
                    <a:gd name="connsiteY2" fmla="*/ 194765 h 194753"/>
                    <a:gd name="connsiteX3" fmla="*/ 5715665 w 5715653"/>
                    <a:gd name="connsiteY3" fmla="*/ 97388 h 194753"/>
                    <a:gd name="connsiteX4" fmla="*/ 5531615 w 5715653"/>
                    <a:gd name="connsiteY4" fmla="*/ 11 h 194753"/>
                    <a:gd name="connsiteX5" fmla="*/ 5531615 w 5715653"/>
                    <a:gd name="connsiteY5" fmla="*/ 48699 h 194753"/>
                    <a:gd name="connsiteX6" fmla="*/ 11 w 5715653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715653" h="194753">
                      <a:moveTo>
                        <a:pt x="11" y="146076"/>
                      </a:moveTo>
                      <a:lnTo>
                        <a:pt x="5531615" y="146076"/>
                      </a:lnTo>
                      <a:lnTo>
                        <a:pt x="5531615" y="194765"/>
                      </a:lnTo>
                      <a:lnTo>
                        <a:pt x="5715665" y="97388"/>
                      </a:lnTo>
                      <a:lnTo>
                        <a:pt x="5531615" y="11"/>
                      </a:lnTo>
                      <a:lnTo>
                        <a:pt x="5531615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" name="Freeform: Shape 25">
                  <a:extLst>
                    <a:ext uri="{FF2B5EF4-FFF2-40B4-BE49-F238E27FC236}">
                      <a16:creationId xmlns:a16="http://schemas.microsoft.com/office/drawing/2014/main" id="{B3DA6604-A250-CDBC-28BB-9E450ACF2A78}"/>
                    </a:ext>
                  </a:extLst>
                </p:cNvPr>
                <p:cNvSpPr/>
                <p:nvPr/>
              </p:nvSpPr>
              <p:spPr>
                <a:xfrm>
                  <a:off x="2114464" y="700105"/>
                  <a:ext cx="5715653" cy="194753"/>
                </a:xfrm>
                <a:custGeom>
                  <a:avLst/>
                  <a:gdLst>
                    <a:gd name="connsiteX0" fmla="*/ 11 w 5715653"/>
                    <a:gd name="connsiteY0" fmla="*/ 146076 h 194753"/>
                    <a:gd name="connsiteX1" fmla="*/ 5531615 w 5715653"/>
                    <a:gd name="connsiteY1" fmla="*/ 146076 h 194753"/>
                    <a:gd name="connsiteX2" fmla="*/ 5531615 w 5715653"/>
                    <a:gd name="connsiteY2" fmla="*/ 194764 h 194753"/>
                    <a:gd name="connsiteX3" fmla="*/ 5715665 w 5715653"/>
                    <a:gd name="connsiteY3" fmla="*/ 97388 h 194753"/>
                    <a:gd name="connsiteX4" fmla="*/ 5531615 w 5715653"/>
                    <a:gd name="connsiteY4" fmla="*/ 11 h 194753"/>
                    <a:gd name="connsiteX5" fmla="*/ 5531615 w 5715653"/>
                    <a:gd name="connsiteY5" fmla="*/ 48699 h 194753"/>
                    <a:gd name="connsiteX6" fmla="*/ 11 w 5715653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715653" h="194753">
                      <a:moveTo>
                        <a:pt x="11" y="146076"/>
                      </a:moveTo>
                      <a:lnTo>
                        <a:pt x="5531615" y="146076"/>
                      </a:lnTo>
                      <a:lnTo>
                        <a:pt x="5531615" y="194764"/>
                      </a:lnTo>
                      <a:lnTo>
                        <a:pt x="5715665" y="97388"/>
                      </a:lnTo>
                      <a:lnTo>
                        <a:pt x="5531615" y="11"/>
                      </a:lnTo>
                      <a:lnTo>
                        <a:pt x="5531615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" name="Freeform: Shape 26">
                  <a:extLst>
                    <a:ext uri="{FF2B5EF4-FFF2-40B4-BE49-F238E27FC236}">
                      <a16:creationId xmlns:a16="http://schemas.microsoft.com/office/drawing/2014/main" id="{356C734B-1DEB-44CA-51B4-302217F53615}"/>
                    </a:ext>
                  </a:extLst>
                </p:cNvPr>
                <p:cNvSpPr/>
                <p:nvPr/>
              </p:nvSpPr>
              <p:spPr>
                <a:xfrm>
                  <a:off x="2114464" y="2520702"/>
                  <a:ext cx="5715653" cy="194753"/>
                </a:xfrm>
                <a:custGeom>
                  <a:avLst/>
                  <a:gdLst>
                    <a:gd name="connsiteX0" fmla="*/ 11 w 5715653"/>
                    <a:gd name="connsiteY0" fmla="*/ 146076 h 194753"/>
                    <a:gd name="connsiteX1" fmla="*/ 5531615 w 5715653"/>
                    <a:gd name="connsiteY1" fmla="*/ 146076 h 194753"/>
                    <a:gd name="connsiteX2" fmla="*/ 5531615 w 5715653"/>
                    <a:gd name="connsiteY2" fmla="*/ 194764 h 194753"/>
                    <a:gd name="connsiteX3" fmla="*/ 5715665 w 5715653"/>
                    <a:gd name="connsiteY3" fmla="*/ 97388 h 194753"/>
                    <a:gd name="connsiteX4" fmla="*/ 5531615 w 5715653"/>
                    <a:gd name="connsiteY4" fmla="*/ 11 h 194753"/>
                    <a:gd name="connsiteX5" fmla="*/ 5531615 w 5715653"/>
                    <a:gd name="connsiteY5" fmla="*/ 48699 h 194753"/>
                    <a:gd name="connsiteX6" fmla="*/ 11 w 5715653"/>
                    <a:gd name="connsiteY6" fmla="*/ 48699 h 19475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5715653" h="194753">
                      <a:moveTo>
                        <a:pt x="11" y="146076"/>
                      </a:moveTo>
                      <a:lnTo>
                        <a:pt x="5531615" y="146076"/>
                      </a:lnTo>
                      <a:lnTo>
                        <a:pt x="5531615" y="194764"/>
                      </a:lnTo>
                      <a:lnTo>
                        <a:pt x="5715665" y="97388"/>
                      </a:lnTo>
                      <a:lnTo>
                        <a:pt x="5531615" y="11"/>
                      </a:lnTo>
                      <a:lnTo>
                        <a:pt x="5531615" y="48699"/>
                      </a:lnTo>
                      <a:lnTo>
                        <a:pt x="11" y="48699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" name="Freeform: Shape 27">
                  <a:extLst>
                    <a:ext uri="{FF2B5EF4-FFF2-40B4-BE49-F238E27FC236}">
                      <a16:creationId xmlns:a16="http://schemas.microsoft.com/office/drawing/2014/main" id="{640BB4FB-2FE8-573F-C87B-95C7DBF0578A}"/>
                    </a:ext>
                  </a:extLst>
                </p:cNvPr>
                <p:cNvSpPr/>
                <p:nvPr/>
              </p:nvSpPr>
              <p:spPr>
                <a:xfrm>
                  <a:off x="2114464" y="2265957"/>
                  <a:ext cx="5346901" cy="97376"/>
                </a:xfrm>
                <a:custGeom>
                  <a:avLst/>
                  <a:gdLst>
                    <a:gd name="connsiteX0" fmla="*/ 11 w 5346901"/>
                    <a:gd name="connsiteY0" fmla="*/ 11 h 97376"/>
                    <a:gd name="connsiteX1" fmla="*/ 5346913 w 5346901"/>
                    <a:gd name="connsiteY1" fmla="*/ 11 h 97376"/>
                    <a:gd name="connsiteX2" fmla="*/ 5346913 w 5346901"/>
                    <a:gd name="connsiteY2" fmla="*/ 97388 h 97376"/>
                    <a:gd name="connsiteX3" fmla="*/ 11 w 5346901"/>
                    <a:gd name="connsiteY3" fmla="*/ 97388 h 9737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5346901" h="97376">
                      <a:moveTo>
                        <a:pt x="11" y="11"/>
                      </a:moveTo>
                      <a:lnTo>
                        <a:pt x="5346913" y="11"/>
                      </a:lnTo>
                      <a:lnTo>
                        <a:pt x="5346913" y="97388"/>
                      </a:lnTo>
                      <a:lnTo>
                        <a:pt x="11" y="97388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25189E62-52F9-2B7A-3167-B005F9E4431C}"/>
                    </a:ext>
                  </a:extLst>
                </p:cNvPr>
                <p:cNvSpPr txBox="1"/>
                <p:nvPr/>
              </p:nvSpPr>
              <p:spPr>
                <a:xfrm>
                  <a:off x="1522958" y="1916698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36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3E06B57-E532-E22E-BEDC-C503FC8FD66E}"/>
                    </a:ext>
                  </a:extLst>
                </p:cNvPr>
                <p:cNvSpPr txBox="1"/>
                <p:nvPr/>
              </p:nvSpPr>
              <p:spPr>
                <a:xfrm>
                  <a:off x="1522958" y="4344161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39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672B8040-E527-828B-C1F1-596191F6A78D}"/>
                    </a:ext>
                  </a:extLst>
                </p:cNvPr>
                <p:cNvSpPr txBox="1"/>
                <p:nvPr/>
              </p:nvSpPr>
              <p:spPr>
                <a:xfrm>
                  <a:off x="1522958" y="1613265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44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7F0F1BD7-CE10-AD4D-071A-304BB91CA655}"/>
                    </a:ext>
                  </a:extLst>
                </p:cNvPr>
                <p:cNvSpPr txBox="1"/>
                <p:nvPr/>
              </p:nvSpPr>
              <p:spPr>
                <a:xfrm>
                  <a:off x="1522958" y="4040728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47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A771BA18-1EA2-594E-A6F8-039708F54BFA}"/>
                    </a:ext>
                  </a:extLst>
                </p:cNvPr>
                <p:cNvSpPr txBox="1"/>
                <p:nvPr/>
              </p:nvSpPr>
              <p:spPr>
                <a:xfrm>
                  <a:off x="1522958" y="1309832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49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953CBEC1-37EA-D649-DC1F-BC10FF8D3652}"/>
                    </a:ext>
                  </a:extLst>
                </p:cNvPr>
                <p:cNvSpPr txBox="1"/>
                <p:nvPr/>
              </p:nvSpPr>
              <p:spPr>
                <a:xfrm>
                  <a:off x="1522958" y="1006400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59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FC35D0FA-1224-83DC-0E62-3CF1DEAA1353}"/>
                    </a:ext>
                  </a:extLst>
                </p:cNvPr>
                <p:cNvSpPr txBox="1"/>
                <p:nvPr/>
              </p:nvSpPr>
              <p:spPr>
                <a:xfrm>
                  <a:off x="1522958" y="3737295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66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DC9748D8-139A-31BA-105F-94013A87C81C}"/>
                    </a:ext>
                  </a:extLst>
                </p:cNvPr>
                <p:cNvSpPr txBox="1"/>
                <p:nvPr/>
              </p:nvSpPr>
              <p:spPr>
                <a:xfrm>
                  <a:off x="1522958" y="3433862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075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CC70AA04-341D-8EC9-A2BE-68B290A9B5E0}"/>
                    </a:ext>
                  </a:extLst>
                </p:cNvPr>
                <p:cNvSpPr txBox="1"/>
                <p:nvPr/>
              </p:nvSpPr>
              <p:spPr>
                <a:xfrm>
                  <a:off x="1522958" y="3130430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100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A79D62F5-52CE-80DB-8CD8-B9EAF2541998}"/>
                    </a:ext>
                  </a:extLst>
                </p:cNvPr>
                <p:cNvSpPr txBox="1"/>
                <p:nvPr/>
              </p:nvSpPr>
              <p:spPr>
                <a:xfrm>
                  <a:off x="1522958" y="2826997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104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4DF5FF1D-1D85-077C-CB26-F556A8CDEA67}"/>
                    </a:ext>
                  </a:extLst>
                </p:cNvPr>
                <p:cNvSpPr txBox="1"/>
                <p:nvPr/>
              </p:nvSpPr>
              <p:spPr>
                <a:xfrm>
                  <a:off x="1522958" y="702967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1109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6B22794A-5766-0902-B4ED-C1AB6945D5D4}"/>
                    </a:ext>
                  </a:extLst>
                </p:cNvPr>
                <p:cNvSpPr txBox="1"/>
                <p:nvPr/>
              </p:nvSpPr>
              <p:spPr>
                <a:xfrm>
                  <a:off x="1522958" y="2523564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2015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60505651-446D-2220-0F38-339CDDA1A598}"/>
                    </a:ext>
                  </a:extLst>
                </p:cNvPr>
                <p:cNvSpPr txBox="1"/>
                <p:nvPr/>
              </p:nvSpPr>
              <p:spPr>
                <a:xfrm>
                  <a:off x="1522958" y="2220131"/>
                  <a:ext cx="634230" cy="2134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75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S04001</a:t>
                  </a:r>
                </a:p>
              </p:txBody>
            </p:sp>
            <p:sp>
              <p:nvSpPr>
                <p:cNvPr id="42" name="Freeform: Shape 41">
                  <a:extLst>
                    <a:ext uri="{FF2B5EF4-FFF2-40B4-BE49-F238E27FC236}">
                      <a16:creationId xmlns:a16="http://schemas.microsoft.com/office/drawing/2014/main" id="{BA3BBFBD-6ED0-D5C1-F064-5F5E723CA9D4}"/>
                    </a:ext>
                  </a:extLst>
                </p:cNvPr>
                <p:cNvSpPr/>
                <p:nvPr/>
              </p:nvSpPr>
              <p:spPr>
                <a:xfrm>
                  <a:off x="2329849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3" name="Freeform: Shape 42">
                  <a:extLst>
                    <a:ext uri="{FF2B5EF4-FFF2-40B4-BE49-F238E27FC236}">
                      <a16:creationId xmlns:a16="http://schemas.microsoft.com/office/drawing/2014/main" id="{2E5980FE-FF2D-C92E-991D-FB8C832FB172}"/>
                    </a:ext>
                  </a:extLst>
                </p:cNvPr>
                <p:cNvSpPr/>
                <p:nvPr/>
              </p:nvSpPr>
              <p:spPr>
                <a:xfrm>
                  <a:off x="2501933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4" name="Freeform: Shape 43">
                  <a:extLst>
                    <a:ext uri="{FF2B5EF4-FFF2-40B4-BE49-F238E27FC236}">
                      <a16:creationId xmlns:a16="http://schemas.microsoft.com/office/drawing/2014/main" id="{4FAD9223-73CC-B9E7-12F6-10CF20A52050}"/>
                    </a:ext>
                  </a:extLst>
                </p:cNvPr>
                <p:cNvSpPr/>
                <p:nvPr/>
              </p:nvSpPr>
              <p:spPr>
                <a:xfrm>
                  <a:off x="2677090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5" name="Freeform: Shape 44">
                  <a:extLst>
                    <a:ext uri="{FF2B5EF4-FFF2-40B4-BE49-F238E27FC236}">
                      <a16:creationId xmlns:a16="http://schemas.microsoft.com/office/drawing/2014/main" id="{36393AF0-AA9F-A901-B8CC-93B3E8FA0C29}"/>
                    </a:ext>
                  </a:extLst>
                </p:cNvPr>
                <p:cNvSpPr/>
                <p:nvPr/>
              </p:nvSpPr>
              <p:spPr>
                <a:xfrm>
                  <a:off x="2846101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6" name="Freeform: Shape 45">
                  <a:extLst>
                    <a:ext uri="{FF2B5EF4-FFF2-40B4-BE49-F238E27FC236}">
                      <a16:creationId xmlns:a16="http://schemas.microsoft.com/office/drawing/2014/main" id="{152C050A-6096-7E31-2048-535AD7C29A26}"/>
                    </a:ext>
                  </a:extLst>
                </p:cNvPr>
                <p:cNvSpPr/>
                <p:nvPr/>
              </p:nvSpPr>
              <p:spPr>
                <a:xfrm>
                  <a:off x="3018186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7" name="Freeform: Shape 46">
                  <a:extLst>
                    <a:ext uri="{FF2B5EF4-FFF2-40B4-BE49-F238E27FC236}">
                      <a16:creationId xmlns:a16="http://schemas.microsoft.com/office/drawing/2014/main" id="{833342F8-1990-D2C2-CB24-F01CC80368A1}"/>
                    </a:ext>
                  </a:extLst>
                </p:cNvPr>
                <p:cNvSpPr/>
                <p:nvPr/>
              </p:nvSpPr>
              <p:spPr>
                <a:xfrm>
                  <a:off x="3276312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8" name="Freeform: Shape 47">
                  <a:extLst>
                    <a:ext uri="{FF2B5EF4-FFF2-40B4-BE49-F238E27FC236}">
                      <a16:creationId xmlns:a16="http://schemas.microsoft.com/office/drawing/2014/main" id="{BB5230DE-FDB9-0BB7-C8DF-B5A9DB80DE5C}"/>
                    </a:ext>
                  </a:extLst>
                </p:cNvPr>
                <p:cNvSpPr/>
                <p:nvPr/>
              </p:nvSpPr>
              <p:spPr>
                <a:xfrm>
                  <a:off x="3540587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49" name="Freeform: Shape 48">
                  <a:extLst>
                    <a:ext uri="{FF2B5EF4-FFF2-40B4-BE49-F238E27FC236}">
                      <a16:creationId xmlns:a16="http://schemas.microsoft.com/office/drawing/2014/main" id="{CFC50779-B552-770F-683F-8C41ECE14162}"/>
                    </a:ext>
                  </a:extLst>
                </p:cNvPr>
                <p:cNvSpPr/>
                <p:nvPr/>
              </p:nvSpPr>
              <p:spPr>
                <a:xfrm>
                  <a:off x="3795634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0" name="Freeform: Shape 49">
                  <a:extLst>
                    <a:ext uri="{FF2B5EF4-FFF2-40B4-BE49-F238E27FC236}">
                      <a16:creationId xmlns:a16="http://schemas.microsoft.com/office/drawing/2014/main" id="{7382BCA6-F70F-45DA-1AF2-502135F94002}"/>
                    </a:ext>
                  </a:extLst>
                </p:cNvPr>
                <p:cNvSpPr/>
                <p:nvPr/>
              </p:nvSpPr>
              <p:spPr>
                <a:xfrm>
                  <a:off x="4066059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1" name="Freeform: Shape 50">
                  <a:extLst>
                    <a:ext uri="{FF2B5EF4-FFF2-40B4-BE49-F238E27FC236}">
                      <a16:creationId xmlns:a16="http://schemas.microsoft.com/office/drawing/2014/main" id="{8068F60E-F44F-0C5E-474D-A73C38C35F70}"/>
                    </a:ext>
                  </a:extLst>
                </p:cNvPr>
                <p:cNvSpPr/>
                <p:nvPr/>
              </p:nvSpPr>
              <p:spPr>
                <a:xfrm>
                  <a:off x="4391786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2" name="Freeform: Shape 51">
                  <a:extLst>
                    <a:ext uri="{FF2B5EF4-FFF2-40B4-BE49-F238E27FC236}">
                      <a16:creationId xmlns:a16="http://schemas.microsoft.com/office/drawing/2014/main" id="{31D70F5D-CD7A-45BB-497B-A2DA4A6B70B9}"/>
                    </a:ext>
                  </a:extLst>
                </p:cNvPr>
                <p:cNvSpPr/>
                <p:nvPr/>
              </p:nvSpPr>
              <p:spPr>
                <a:xfrm>
                  <a:off x="2160838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3" name="Freeform: Shape 52">
                  <a:extLst>
                    <a:ext uri="{FF2B5EF4-FFF2-40B4-BE49-F238E27FC236}">
                      <a16:creationId xmlns:a16="http://schemas.microsoft.com/office/drawing/2014/main" id="{6A6EF8BE-42A4-1A4D-4030-B32F3B9C8B22}"/>
                    </a:ext>
                  </a:extLst>
                </p:cNvPr>
                <p:cNvSpPr/>
                <p:nvPr/>
              </p:nvSpPr>
              <p:spPr>
                <a:xfrm>
                  <a:off x="2335995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4" name="Freeform: Shape 53">
                  <a:extLst>
                    <a:ext uri="{FF2B5EF4-FFF2-40B4-BE49-F238E27FC236}">
                      <a16:creationId xmlns:a16="http://schemas.microsoft.com/office/drawing/2014/main" id="{991C24A9-7757-BF63-5A15-1E4CF475D0DE}"/>
                    </a:ext>
                  </a:extLst>
                </p:cNvPr>
                <p:cNvSpPr/>
                <p:nvPr/>
              </p:nvSpPr>
              <p:spPr>
                <a:xfrm>
                  <a:off x="2160838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5" name="Freeform: Shape 54">
                  <a:extLst>
                    <a:ext uri="{FF2B5EF4-FFF2-40B4-BE49-F238E27FC236}">
                      <a16:creationId xmlns:a16="http://schemas.microsoft.com/office/drawing/2014/main" id="{A351145D-9634-5A06-E331-7FAF0FF61F75}"/>
                    </a:ext>
                  </a:extLst>
                </p:cNvPr>
                <p:cNvSpPr/>
                <p:nvPr/>
              </p:nvSpPr>
              <p:spPr>
                <a:xfrm>
                  <a:off x="2677090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6" name="Freeform: Shape 55">
                  <a:extLst>
                    <a:ext uri="{FF2B5EF4-FFF2-40B4-BE49-F238E27FC236}">
                      <a16:creationId xmlns:a16="http://schemas.microsoft.com/office/drawing/2014/main" id="{C90484D9-1714-67A8-4A3E-7E85295D8D78}"/>
                    </a:ext>
                  </a:extLst>
                </p:cNvPr>
                <p:cNvSpPr/>
                <p:nvPr/>
              </p:nvSpPr>
              <p:spPr>
                <a:xfrm>
                  <a:off x="3543657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7" name="Freeform: Shape 56">
                  <a:extLst>
                    <a:ext uri="{FF2B5EF4-FFF2-40B4-BE49-F238E27FC236}">
                      <a16:creationId xmlns:a16="http://schemas.microsoft.com/office/drawing/2014/main" id="{2580DAA1-098B-2AAD-7533-35105F705832}"/>
                    </a:ext>
                  </a:extLst>
                </p:cNvPr>
                <p:cNvSpPr/>
                <p:nvPr/>
              </p:nvSpPr>
              <p:spPr>
                <a:xfrm>
                  <a:off x="2160838" y="379521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8" name="Freeform: Shape 57">
                  <a:extLst>
                    <a:ext uri="{FF2B5EF4-FFF2-40B4-BE49-F238E27FC236}">
                      <a16:creationId xmlns:a16="http://schemas.microsoft.com/office/drawing/2014/main" id="{7E04CF82-E5F0-E970-CD53-27DD11411225}"/>
                    </a:ext>
                  </a:extLst>
                </p:cNvPr>
                <p:cNvSpPr/>
                <p:nvPr/>
              </p:nvSpPr>
              <p:spPr>
                <a:xfrm>
                  <a:off x="2505003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59" name="Freeform: Shape 58">
                  <a:extLst>
                    <a:ext uri="{FF2B5EF4-FFF2-40B4-BE49-F238E27FC236}">
                      <a16:creationId xmlns:a16="http://schemas.microsoft.com/office/drawing/2014/main" id="{A82B1F32-736A-4A6F-A6CB-A0D4ABCD8654}"/>
                    </a:ext>
                  </a:extLst>
                </p:cNvPr>
                <p:cNvSpPr/>
                <p:nvPr/>
              </p:nvSpPr>
              <p:spPr>
                <a:xfrm>
                  <a:off x="2505003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0" name="Freeform: Shape 59">
                  <a:extLst>
                    <a:ext uri="{FF2B5EF4-FFF2-40B4-BE49-F238E27FC236}">
                      <a16:creationId xmlns:a16="http://schemas.microsoft.com/office/drawing/2014/main" id="{155B58B2-E613-DEA4-9FC0-EFD3690C0994}"/>
                    </a:ext>
                  </a:extLst>
                </p:cNvPr>
                <p:cNvSpPr/>
                <p:nvPr/>
              </p:nvSpPr>
              <p:spPr>
                <a:xfrm>
                  <a:off x="2160838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1" name="Freeform: Shape 60">
                  <a:extLst>
                    <a:ext uri="{FF2B5EF4-FFF2-40B4-BE49-F238E27FC236}">
                      <a16:creationId xmlns:a16="http://schemas.microsoft.com/office/drawing/2014/main" id="{802A2343-D1AF-9A76-8895-22D31853F9D9}"/>
                    </a:ext>
                  </a:extLst>
                </p:cNvPr>
                <p:cNvSpPr/>
                <p:nvPr/>
              </p:nvSpPr>
              <p:spPr>
                <a:xfrm>
                  <a:off x="215776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2" name="Freeform: Shape 61">
                  <a:extLst>
                    <a:ext uri="{FF2B5EF4-FFF2-40B4-BE49-F238E27FC236}">
                      <a16:creationId xmlns:a16="http://schemas.microsoft.com/office/drawing/2014/main" id="{FE4C6254-B22A-1954-D335-DB5014879B12}"/>
                    </a:ext>
                  </a:extLst>
                </p:cNvPr>
                <p:cNvSpPr/>
                <p:nvPr/>
              </p:nvSpPr>
              <p:spPr>
                <a:xfrm>
                  <a:off x="2170056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3" name="Freeform: Shape 62">
                  <a:extLst>
                    <a:ext uri="{FF2B5EF4-FFF2-40B4-BE49-F238E27FC236}">
                      <a16:creationId xmlns:a16="http://schemas.microsoft.com/office/drawing/2014/main" id="{ADE73C81-5EC3-9AAB-73D7-5D804A41C328}"/>
                    </a:ext>
                  </a:extLst>
                </p:cNvPr>
                <p:cNvSpPr/>
                <p:nvPr/>
              </p:nvSpPr>
              <p:spPr>
                <a:xfrm>
                  <a:off x="2329846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4" name="Freeform: Shape 63">
                  <a:extLst>
                    <a:ext uri="{FF2B5EF4-FFF2-40B4-BE49-F238E27FC236}">
                      <a16:creationId xmlns:a16="http://schemas.microsoft.com/office/drawing/2014/main" id="{4648F56A-9335-E8E8-3207-B021D6EC5743}"/>
                    </a:ext>
                  </a:extLst>
                </p:cNvPr>
                <p:cNvSpPr/>
                <p:nvPr/>
              </p:nvSpPr>
              <p:spPr>
                <a:xfrm>
                  <a:off x="2508082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5" name="Freeform: Shape 64">
                  <a:extLst>
                    <a:ext uri="{FF2B5EF4-FFF2-40B4-BE49-F238E27FC236}">
                      <a16:creationId xmlns:a16="http://schemas.microsoft.com/office/drawing/2014/main" id="{594576F3-54D1-075D-1CC7-D2FE80660A8A}"/>
                    </a:ext>
                  </a:extLst>
                </p:cNvPr>
                <p:cNvSpPr/>
                <p:nvPr/>
              </p:nvSpPr>
              <p:spPr>
                <a:xfrm>
                  <a:off x="2329846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6" name="Freeform: Shape 65">
                  <a:extLst>
                    <a:ext uri="{FF2B5EF4-FFF2-40B4-BE49-F238E27FC236}">
                      <a16:creationId xmlns:a16="http://schemas.microsoft.com/office/drawing/2014/main" id="{72E0E21E-E6BF-78F7-8601-F2983A6E6EB3}"/>
                    </a:ext>
                  </a:extLst>
                </p:cNvPr>
                <p:cNvSpPr/>
                <p:nvPr/>
              </p:nvSpPr>
              <p:spPr>
                <a:xfrm>
                  <a:off x="2849178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7" name="Freeform: Shape 66">
                  <a:extLst>
                    <a:ext uri="{FF2B5EF4-FFF2-40B4-BE49-F238E27FC236}">
                      <a16:creationId xmlns:a16="http://schemas.microsoft.com/office/drawing/2014/main" id="{779AA864-490F-BDEB-1DC5-0E767926B39D}"/>
                    </a:ext>
                  </a:extLst>
                </p:cNvPr>
                <p:cNvSpPr/>
                <p:nvPr/>
              </p:nvSpPr>
              <p:spPr>
                <a:xfrm>
                  <a:off x="3795634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8" name="Freeform: Shape 67">
                  <a:extLst>
                    <a:ext uri="{FF2B5EF4-FFF2-40B4-BE49-F238E27FC236}">
                      <a16:creationId xmlns:a16="http://schemas.microsoft.com/office/drawing/2014/main" id="{6F22E45E-2CFD-A8E7-FEDC-8AFEBC90E7D2}"/>
                    </a:ext>
                  </a:extLst>
                </p:cNvPr>
                <p:cNvSpPr/>
                <p:nvPr/>
              </p:nvSpPr>
              <p:spPr>
                <a:xfrm>
                  <a:off x="2677090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69" name="Freeform: Shape 68">
                  <a:extLst>
                    <a:ext uri="{FF2B5EF4-FFF2-40B4-BE49-F238E27FC236}">
                      <a16:creationId xmlns:a16="http://schemas.microsoft.com/office/drawing/2014/main" id="{D73A4B6F-E43E-AB3E-6DD7-8A733AC3AA1E}"/>
                    </a:ext>
                  </a:extLst>
                </p:cNvPr>
                <p:cNvSpPr/>
                <p:nvPr/>
              </p:nvSpPr>
              <p:spPr>
                <a:xfrm>
                  <a:off x="2677090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0" name="Freeform: Shape 69">
                  <a:extLst>
                    <a:ext uri="{FF2B5EF4-FFF2-40B4-BE49-F238E27FC236}">
                      <a16:creationId xmlns:a16="http://schemas.microsoft.com/office/drawing/2014/main" id="{11B77780-350E-B8B0-33D2-1656BE58C3F1}"/>
                    </a:ext>
                  </a:extLst>
                </p:cNvPr>
                <p:cNvSpPr/>
                <p:nvPr/>
              </p:nvSpPr>
              <p:spPr>
                <a:xfrm>
                  <a:off x="2332925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1" name="Freeform: Shape 70">
                  <a:extLst>
                    <a:ext uri="{FF2B5EF4-FFF2-40B4-BE49-F238E27FC236}">
                      <a16:creationId xmlns:a16="http://schemas.microsoft.com/office/drawing/2014/main" id="{34DC9CB7-9A19-C364-9F5C-7E6507CC32A0}"/>
                    </a:ext>
                  </a:extLst>
                </p:cNvPr>
                <p:cNvSpPr/>
                <p:nvPr/>
              </p:nvSpPr>
              <p:spPr>
                <a:xfrm>
                  <a:off x="2329846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2" name="Freeform: Shape 71">
                  <a:extLst>
                    <a:ext uri="{FF2B5EF4-FFF2-40B4-BE49-F238E27FC236}">
                      <a16:creationId xmlns:a16="http://schemas.microsoft.com/office/drawing/2014/main" id="{D916B87D-2035-1BE8-F658-F02A46E0C461}"/>
                    </a:ext>
                  </a:extLst>
                </p:cNvPr>
                <p:cNvSpPr/>
                <p:nvPr/>
              </p:nvSpPr>
              <p:spPr>
                <a:xfrm>
                  <a:off x="2342144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3" name="Freeform: Shape 72">
                  <a:extLst>
                    <a:ext uri="{FF2B5EF4-FFF2-40B4-BE49-F238E27FC236}">
                      <a16:creationId xmlns:a16="http://schemas.microsoft.com/office/drawing/2014/main" id="{04B17BC7-60E1-47FD-F17A-BDDD512587C3}"/>
                    </a:ext>
                  </a:extLst>
                </p:cNvPr>
                <p:cNvSpPr/>
                <p:nvPr/>
              </p:nvSpPr>
              <p:spPr>
                <a:xfrm>
                  <a:off x="2501933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4" name="Freeform: Shape 73">
                  <a:extLst>
                    <a:ext uri="{FF2B5EF4-FFF2-40B4-BE49-F238E27FC236}">
                      <a16:creationId xmlns:a16="http://schemas.microsoft.com/office/drawing/2014/main" id="{7BA08412-84C3-A79F-3BF1-1E0C06822769}"/>
                    </a:ext>
                  </a:extLst>
                </p:cNvPr>
                <p:cNvSpPr/>
                <p:nvPr/>
              </p:nvSpPr>
              <p:spPr>
                <a:xfrm>
                  <a:off x="2680160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5" name="Freeform: Shape 74">
                  <a:extLst>
                    <a:ext uri="{FF2B5EF4-FFF2-40B4-BE49-F238E27FC236}">
                      <a16:creationId xmlns:a16="http://schemas.microsoft.com/office/drawing/2014/main" id="{DE9A25D8-4045-1B08-18F8-540EEFC83B80}"/>
                    </a:ext>
                  </a:extLst>
                </p:cNvPr>
                <p:cNvSpPr/>
                <p:nvPr/>
              </p:nvSpPr>
              <p:spPr>
                <a:xfrm>
                  <a:off x="2501933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6" name="Freeform: Shape 75">
                  <a:extLst>
                    <a:ext uri="{FF2B5EF4-FFF2-40B4-BE49-F238E27FC236}">
                      <a16:creationId xmlns:a16="http://schemas.microsoft.com/office/drawing/2014/main" id="{E8F6125F-A211-1E14-37A0-1408E62AC14C}"/>
                    </a:ext>
                  </a:extLst>
                </p:cNvPr>
                <p:cNvSpPr/>
                <p:nvPr/>
              </p:nvSpPr>
              <p:spPr>
                <a:xfrm>
                  <a:off x="3015116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7" name="Freeform: Shape 76">
                  <a:extLst>
                    <a:ext uri="{FF2B5EF4-FFF2-40B4-BE49-F238E27FC236}">
                      <a16:creationId xmlns:a16="http://schemas.microsoft.com/office/drawing/2014/main" id="{D6A4AC48-EA65-D08C-1386-66EF8A69152F}"/>
                    </a:ext>
                  </a:extLst>
                </p:cNvPr>
                <p:cNvSpPr/>
                <p:nvPr/>
              </p:nvSpPr>
              <p:spPr>
                <a:xfrm>
                  <a:off x="4053761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8" name="Freeform: Shape 77">
                  <a:extLst>
                    <a:ext uri="{FF2B5EF4-FFF2-40B4-BE49-F238E27FC236}">
                      <a16:creationId xmlns:a16="http://schemas.microsoft.com/office/drawing/2014/main" id="{67D46368-D52E-FE3F-309C-D213400133DB}"/>
                    </a:ext>
                  </a:extLst>
                </p:cNvPr>
                <p:cNvSpPr/>
                <p:nvPr/>
              </p:nvSpPr>
              <p:spPr>
                <a:xfrm>
                  <a:off x="2830740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79" name="Freeform: Shape 78">
                  <a:extLst>
                    <a:ext uri="{FF2B5EF4-FFF2-40B4-BE49-F238E27FC236}">
                      <a16:creationId xmlns:a16="http://schemas.microsoft.com/office/drawing/2014/main" id="{367B2E4C-F7D4-A9EE-7E5F-98776F63F478}"/>
                    </a:ext>
                  </a:extLst>
                </p:cNvPr>
                <p:cNvSpPr/>
                <p:nvPr/>
              </p:nvSpPr>
              <p:spPr>
                <a:xfrm>
                  <a:off x="2870685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0" name="Freeform: Shape 79">
                  <a:extLst>
                    <a:ext uri="{FF2B5EF4-FFF2-40B4-BE49-F238E27FC236}">
                      <a16:creationId xmlns:a16="http://schemas.microsoft.com/office/drawing/2014/main" id="{DB56D9E8-1A22-4E37-4589-0A1855D00B94}"/>
                    </a:ext>
                  </a:extLst>
                </p:cNvPr>
                <p:cNvSpPr/>
                <p:nvPr/>
              </p:nvSpPr>
              <p:spPr>
                <a:xfrm>
                  <a:off x="2505003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1" name="Freeform: Shape 80">
                  <a:extLst>
                    <a:ext uri="{FF2B5EF4-FFF2-40B4-BE49-F238E27FC236}">
                      <a16:creationId xmlns:a16="http://schemas.microsoft.com/office/drawing/2014/main" id="{C6DBEC4F-4132-E0DE-BAD1-D8FACF27D019}"/>
                    </a:ext>
                  </a:extLst>
                </p:cNvPr>
                <p:cNvSpPr/>
                <p:nvPr/>
              </p:nvSpPr>
              <p:spPr>
                <a:xfrm>
                  <a:off x="2495784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2" name="Freeform: Shape 81">
                  <a:extLst>
                    <a:ext uri="{FF2B5EF4-FFF2-40B4-BE49-F238E27FC236}">
                      <a16:creationId xmlns:a16="http://schemas.microsoft.com/office/drawing/2014/main" id="{DA1BBAD0-EB62-FE5F-B2D6-24CBC1A3881B}"/>
                    </a:ext>
                  </a:extLst>
                </p:cNvPr>
                <p:cNvSpPr/>
                <p:nvPr/>
              </p:nvSpPr>
              <p:spPr>
                <a:xfrm>
                  <a:off x="2501933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3" name="Freeform: Shape 82">
                  <a:extLst>
                    <a:ext uri="{FF2B5EF4-FFF2-40B4-BE49-F238E27FC236}">
                      <a16:creationId xmlns:a16="http://schemas.microsoft.com/office/drawing/2014/main" id="{591FAD04-CC05-EA2D-408D-DCAA6C00C657}"/>
                    </a:ext>
                  </a:extLst>
                </p:cNvPr>
                <p:cNvSpPr/>
                <p:nvPr/>
              </p:nvSpPr>
              <p:spPr>
                <a:xfrm>
                  <a:off x="2674020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4" name="Freeform: Shape 83">
                  <a:extLst>
                    <a:ext uri="{FF2B5EF4-FFF2-40B4-BE49-F238E27FC236}">
                      <a16:creationId xmlns:a16="http://schemas.microsoft.com/office/drawing/2014/main" id="{8AFF9C0E-F2D4-2D8F-607F-1C73E3619F74}"/>
                    </a:ext>
                  </a:extLst>
                </p:cNvPr>
                <p:cNvSpPr/>
                <p:nvPr/>
              </p:nvSpPr>
              <p:spPr>
                <a:xfrm>
                  <a:off x="2852247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5" name="Freeform: Shape 84">
                  <a:extLst>
                    <a:ext uri="{FF2B5EF4-FFF2-40B4-BE49-F238E27FC236}">
                      <a16:creationId xmlns:a16="http://schemas.microsoft.com/office/drawing/2014/main" id="{E56D91E4-7185-3AF4-B3EE-48AB50DB8D31}"/>
                    </a:ext>
                  </a:extLst>
                </p:cNvPr>
                <p:cNvSpPr/>
                <p:nvPr/>
              </p:nvSpPr>
              <p:spPr>
                <a:xfrm>
                  <a:off x="2674020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6" name="Freeform: Shape 85">
                  <a:extLst>
                    <a:ext uri="{FF2B5EF4-FFF2-40B4-BE49-F238E27FC236}">
                      <a16:creationId xmlns:a16="http://schemas.microsoft.com/office/drawing/2014/main" id="{DDEB896C-AD55-BA91-27D1-0A4C2AEFFF35}"/>
                    </a:ext>
                  </a:extLst>
                </p:cNvPr>
                <p:cNvSpPr/>
                <p:nvPr/>
              </p:nvSpPr>
              <p:spPr>
                <a:xfrm>
                  <a:off x="3279382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7" name="Freeform: Shape 86">
                  <a:extLst>
                    <a:ext uri="{FF2B5EF4-FFF2-40B4-BE49-F238E27FC236}">
                      <a16:creationId xmlns:a16="http://schemas.microsoft.com/office/drawing/2014/main" id="{400DBB46-D367-A4B8-6ACB-17F5197A980E}"/>
                    </a:ext>
                  </a:extLst>
                </p:cNvPr>
                <p:cNvSpPr/>
                <p:nvPr/>
              </p:nvSpPr>
              <p:spPr>
                <a:xfrm>
                  <a:off x="4401005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89" name="Freeform: Shape 88">
                  <a:extLst>
                    <a:ext uri="{FF2B5EF4-FFF2-40B4-BE49-F238E27FC236}">
                      <a16:creationId xmlns:a16="http://schemas.microsoft.com/office/drawing/2014/main" id="{87DC0211-2B6A-9889-E351-4307E28A83B5}"/>
                    </a:ext>
                  </a:extLst>
                </p:cNvPr>
                <p:cNvSpPr/>
                <p:nvPr/>
              </p:nvSpPr>
              <p:spPr>
                <a:xfrm>
                  <a:off x="3042772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0" name="Freeform: Shape 89">
                  <a:extLst>
                    <a:ext uri="{FF2B5EF4-FFF2-40B4-BE49-F238E27FC236}">
                      <a16:creationId xmlns:a16="http://schemas.microsoft.com/office/drawing/2014/main" id="{E1CF800F-11D2-4CFE-D26E-7772740ECB57}"/>
                    </a:ext>
                  </a:extLst>
                </p:cNvPr>
                <p:cNvSpPr/>
                <p:nvPr/>
              </p:nvSpPr>
              <p:spPr>
                <a:xfrm>
                  <a:off x="2674020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1" name="Freeform: Shape 90">
                  <a:extLst>
                    <a:ext uri="{FF2B5EF4-FFF2-40B4-BE49-F238E27FC236}">
                      <a16:creationId xmlns:a16="http://schemas.microsoft.com/office/drawing/2014/main" id="{A108A733-1695-3197-7454-95167F99BA53}"/>
                    </a:ext>
                  </a:extLst>
                </p:cNvPr>
                <p:cNvSpPr/>
                <p:nvPr/>
              </p:nvSpPr>
              <p:spPr>
                <a:xfrm>
                  <a:off x="2674020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2" name="Freeform: Shape 91">
                  <a:extLst>
                    <a:ext uri="{FF2B5EF4-FFF2-40B4-BE49-F238E27FC236}">
                      <a16:creationId xmlns:a16="http://schemas.microsoft.com/office/drawing/2014/main" id="{C33EB80B-41E9-E305-C7FA-2916A441E9DE}"/>
                    </a:ext>
                  </a:extLst>
                </p:cNvPr>
                <p:cNvSpPr/>
                <p:nvPr/>
              </p:nvSpPr>
              <p:spPr>
                <a:xfrm>
                  <a:off x="2680160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3" name="Freeform: Shape 92">
                  <a:extLst>
                    <a:ext uri="{FF2B5EF4-FFF2-40B4-BE49-F238E27FC236}">
                      <a16:creationId xmlns:a16="http://schemas.microsoft.com/office/drawing/2014/main" id="{02E0B243-94D9-B415-3DC4-E14F21131C6A}"/>
                    </a:ext>
                  </a:extLst>
                </p:cNvPr>
                <p:cNvSpPr/>
                <p:nvPr/>
              </p:nvSpPr>
              <p:spPr>
                <a:xfrm>
                  <a:off x="2846098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4" name="Freeform: Shape 93">
                  <a:extLst>
                    <a:ext uri="{FF2B5EF4-FFF2-40B4-BE49-F238E27FC236}">
                      <a16:creationId xmlns:a16="http://schemas.microsoft.com/office/drawing/2014/main" id="{399DC850-54DD-370D-B093-00514A4866BB}"/>
                    </a:ext>
                  </a:extLst>
                </p:cNvPr>
                <p:cNvSpPr/>
                <p:nvPr/>
              </p:nvSpPr>
              <p:spPr>
                <a:xfrm>
                  <a:off x="3024335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5" name="Freeform: Shape 94">
                  <a:extLst>
                    <a:ext uri="{FF2B5EF4-FFF2-40B4-BE49-F238E27FC236}">
                      <a16:creationId xmlns:a16="http://schemas.microsoft.com/office/drawing/2014/main" id="{C6F4803C-E20B-6047-B2F6-60F0BD9F9FC3}"/>
                    </a:ext>
                  </a:extLst>
                </p:cNvPr>
                <p:cNvSpPr/>
                <p:nvPr/>
              </p:nvSpPr>
              <p:spPr>
                <a:xfrm>
                  <a:off x="3279382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6" name="Freeform: Shape 95">
                  <a:extLst>
                    <a:ext uri="{FF2B5EF4-FFF2-40B4-BE49-F238E27FC236}">
                      <a16:creationId xmlns:a16="http://schemas.microsoft.com/office/drawing/2014/main" id="{AAB121EE-C004-1095-C237-6A0D840406DE}"/>
                    </a:ext>
                  </a:extLst>
                </p:cNvPr>
                <p:cNvSpPr/>
                <p:nvPr/>
              </p:nvSpPr>
              <p:spPr>
                <a:xfrm>
                  <a:off x="3537508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8" name="Freeform: Shape 97">
                  <a:extLst>
                    <a:ext uri="{FF2B5EF4-FFF2-40B4-BE49-F238E27FC236}">
                      <a16:creationId xmlns:a16="http://schemas.microsoft.com/office/drawing/2014/main" id="{3E0B69E0-C000-2481-7039-C59EEBEA652C}"/>
                    </a:ext>
                  </a:extLst>
                </p:cNvPr>
                <p:cNvSpPr/>
                <p:nvPr/>
              </p:nvSpPr>
              <p:spPr>
                <a:xfrm>
                  <a:off x="3300898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99" name="Freeform: Shape 98">
                  <a:extLst>
                    <a:ext uri="{FF2B5EF4-FFF2-40B4-BE49-F238E27FC236}">
                      <a16:creationId xmlns:a16="http://schemas.microsoft.com/office/drawing/2014/main" id="{519DCD97-E126-58A4-8E81-B970D76123AF}"/>
                    </a:ext>
                  </a:extLst>
                </p:cNvPr>
                <p:cNvSpPr/>
                <p:nvPr/>
              </p:nvSpPr>
              <p:spPr>
                <a:xfrm>
                  <a:off x="2849178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0" name="Freeform: Shape 99">
                  <a:extLst>
                    <a:ext uri="{FF2B5EF4-FFF2-40B4-BE49-F238E27FC236}">
                      <a16:creationId xmlns:a16="http://schemas.microsoft.com/office/drawing/2014/main" id="{3662B688-EEC6-A06D-6FF9-6D0DFFE2B3A2}"/>
                    </a:ext>
                  </a:extLst>
                </p:cNvPr>
                <p:cNvSpPr/>
                <p:nvPr/>
              </p:nvSpPr>
              <p:spPr>
                <a:xfrm>
                  <a:off x="284609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1" name="Freeform: Shape 100">
                  <a:extLst>
                    <a:ext uri="{FF2B5EF4-FFF2-40B4-BE49-F238E27FC236}">
                      <a16:creationId xmlns:a16="http://schemas.microsoft.com/office/drawing/2014/main" id="{CB9B3B78-ABD1-7D5D-A86F-7519774E9E5D}"/>
                    </a:ext>
                  </a:extLst>
                </p:cNvPr>
                <p:cNvSpPr/>
                <p:nvPr/>
              </p:nvSpPr>
              <p:spPr>
                <a:xfrm>
                  <a:off x="2849178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2" name="Freeform: Shape 101">
                  <a:extLst>
                    <a:ext uri="{FF2B5EF4-FFF2-40B4-BE49-F238E27FC236}">
                      <a16:creationId xmlns:a16="http://schemas.microsoft.com/office/drawing/2014/main" id="{EFD5748D-BD63-8FA5-66AD-DD02159B2A11}"/>
                    </a:ext>
                  </a:extLst>
                </p:cNvPr>
                <p:cNvSpPr/>
                <p:nvPr/>
              </p:nvSpPr>
              <p:spPr>
                <a:xfrm>
                  <a:off x="3018186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3" name="Freeform: Shape 102">
                  <a:extLst>
                    <a:ext uri="{FF2B5EF4-FFF2-40B4-BE49-F238E27FC236}">
                      <a16:creationId xmlns:a16="http://schemas.microsoft.com/office/drawing/2014/main" id="{6F5CCD93-6AC6-C350-0F41-774BB3AF60F4}"/>
                    </a:ext>
                  </a:extLst>
                </p:cNvPr>
                <p:cNvSpPr/>
                <p:nvPr/>
              </p:nvSpPr>
              <p:spPr>
                <a:xfrm>
                  <a:off x="3285531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4" name="Freeform: Shape 103">
                  <a:extLst>
                    <a:ext uri="{FF2B5EF4-FFF2-40B4-BE49-F238E27FC236}">
                      <a16:creationId xmlns:a16="http://schemas.microsoft.com/office/drawing/2014/main" id="{A2B2DA8B-DFF3-26F5-6DAF-6646B0758659}"/>
                    </a:ext>
                  </a:extLst>
                </p:cNvPr>
                <p:cNvSpPr/>
                <p:nvPr/>
              </p:nvSpPr>
              <p:spPr>
                <a:xfrm>
                  <a:off x="3534438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5" name="Freeform: Shape 104">
                  <a:extLst>
                    <a:ext uri="{FF2B5EF4-FFF2-40B4-BE49-F238E27FC236}">
                      <a16:creationId xmlns:a16="http://schemas.microsoft.com/office/drawing/2014/main" id="{F728D885-101F-07DA-43A0-3C56070ACC27}"/>
                    </a:ext>
                  </a:extLst>
                </p:cNvPr>
                <p:cNvSpPr/>
                <p:nvPr/>
              </p:nvSpPr>
              <p:spPr>
                <a:xfrm>
                  <a:off x="3795634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7" name="Freeform: Shape 106">
                  <a:extLst>
                    <a:ext uri="{FF2B5EF4-FFF2-40B4-BE49-F238E27FC236}">
                      <a16:creationId xmlns:a16="http://schemas.microsoft.com/office/drawing/2014/main" id="{4CAC050D-944E-B906-9E8B-48D8C83AE499}"/>
                    </a:ext>
                  </a:extLst>
                </p:cNvPr>
                <p:cNvSpPr/>
                <p:nvPr/>
              </p:nvSpPr>
              <p:spPr>
                <a:xfrm>
                  <a:off x="3559025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8" name="Freeform: Shape 107">
                  <a:extLst>
                    <a:ext uri="{FF2B5EF4-FFF2-40B4-BE49-F238E27FC236}">
                      <a16:creationId xmlns:a16="http://schemas.microsoft.com/office/drawing/2014/main" id="{974CC269-098A-46FA-C745-487E2B706824}"/>
                    </a:ext>
                  </a:extLst>
                </p:cNvPr>
                <p:cNvSpPr/>
                <p:nvPr/>
              </p:nvSpPr>
              <p:spPr>
                <a:xfrm>
                  <a:off x="3021255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09" name="Freeform: Shape 108">
                  <a:extLst>
                    <a:ext uri="{FF2B5EF4-FFF2-40B4-BE49-F238E27FC236}">
                      <a16:creationId xmlns:a16="http://schemas.microsoft.com/office/drawing/2014/main" id="{858BEB2F-2E10-D9C0-D117-CF559EB585AD}"/>
                    </a:ext>
                  </a:extLst>
                </p:cNvPr>
                <p:cNvSpPr/>
                <p:nvPr/>
              </p:nvSpPr>
              <p:spPr>
                <a:xfrm>
                  <a:off x="3021255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0" name="Freeform: Shape 109">
                  <a:extLst>
                    <a:ext uri="{FF2B5EF4-FFF2-40B4-BE49-F238E27FC236}">
                      <a16:creationId xmlns:a16="http://schemas.microsoft.com/office/drawing/2014/main" id="{36516316-8761-D964-405D-E7831409FFFD}"/>
                    </a:ext>
                  </a:extLst>
                </p:cNvPr>
                <p:cNvSpPr/>
                <p:nvPr/>
              </p:nvSpPr>
              <p:spPr>
                <a:xfrm>
                  <a:off x="3021255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1" name="Freeform: Shape 110">
                  <a:extLst>
                    <a:ext uri="{FF2B5EF4-FFF2-40B4-BE49-F238E27FC236}">
                      <a16:creationId xmlns:a16="http://schemas.microsoft.com/office/drawing/2014/main" id="{92E3B728-B5C8-1F87-A263-534F6E84FAFC}"/>
                    </a:ext>
                  </a:extLst>
                </p:cNvPr>
                <p:cNvSpPr/>
                <p:nvPr/>
              </p:nvSpPr>
              <p:spPr>
                <a:xfrm>
                  <a:off x="3279382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2" name="Freeform: Shape 111">
                  <a:extLst>
                    <a:ext uri="{FF2B5EF4-FFF2-40B4-BE49-F238E27FC236}">
                      <a16:creationId xmlns:a16="http://schemas.microsoft.com/office/drawing/2014/main" id="{B32BB581-9E21-3ABB-8CFD-821BAD152103}"/>
                    </a:ext>
                  </a:extLst>
                </p:cNvPr>
                <p:cNvSpPr/>
                <p:nvPr/>
              </p:nvSpPr>
              <p:spPr>
                <a:xfrm>
                  <a:off x="3540587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3" name="Freeform: Shape 112">
                  <a:extLst>
                    <a:ext uri="{FF2B5EF4-FFF2-40B4-BE49-F238E27FC236}">
                      <a16:creationId xmlns:a16="http://schemas.microsoft.com/office/drawing/2014/main" id="{E6CCE826-285B-E738-3CD2-C104D9901797}"/>
                    </a:ext>
                  </a:extLst>
                </p:cNvPr>
                <p:cNvSpPr/>
                <p:nvPr/>
              </p:nvSpPr>
              <p:spPr>
                <a:xfrm>
                  <a:off x="3777197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4" name="Freeform: Shape 113">
                  <a:extLst>
                    <a:ext uri="{FF2B5EF4-FFF2-40B4-BE49-F238E27FC236}">
                      <a16:creationId xmlns:a16="http://schemas.microsoft.com/office/drawing/2014/main" id="{D513B95E-5C5C-D7B7-A396-E24482EB9925}"/>
                    </a:ext>
                  </a:extLst>
                </p:cNvPr>
                <p:cNvSpPr/>
                <p:nvPr/>
              </p:nvSpPr>
              <p:spPr>
                <a:xfrm>
                  <a:off x="4053761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6" name="Freeform: Shape 115">
                  <a:extLst>
                    <a:ext uri="{FF2B5EF4-FFF2-40B4-BE49-F238E27FC236}">
                      <a16:creationId xmlns:a16="http://schemas.microsoft.com/office/drawing/2014/main" id="{B25327FA-B358-3550-EC8B-F38769D1BDF2}"/>
                    </a:ext>
                  </a:extLst>
                </p:cNvPr>
                <p:cNvSpPr/>
                <p:nvPr/>
              </p:nvSpPr>
              <p:spPr>
                <a:xfrm>
                  <a:off x="3817151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7" name="Freeform: Shape 116">
                  <a:extLst>
                    <a:ext uri="{FF2B5EF4-FFF2-40B4-BE49-F238E27FC236}">
                      <a16:creationId xmlns:a16="http://schemas.microsoft.com/office/drawing/2014/main" id="{54DF1882-7F6A-09A2-729C-8C5C80C8605B}"/>
                    </a:ext>
                  </a:extLst>
                </p:cNvPr>
                <p:cNvSpPr/>
                <p:nvPr/>
              </p:nvSpPr>
              <p:spPr>
                <a:xfrm>
                  <a:off x="3276312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8" name="Freeform: Shape 117">
                  <a:extLst>
                    <a:ext uri="{FF2B5EF4-FFF2-40B4-BE49-F238E27FC236}">
                      <a16:creationId xmlns:a16="http://schemas.microsoft.com/office/drawing/2014/main" id="{2A3B7E95-D480-E54E-E80B-AA679A82FE12}"/>
                    </a:ext>
                  </a:extLst>
                </p:cNvPr>
                <p:cNvSpPr/>
                <p:nvPr/>
              </p:nvSpPr>
              <p:spPr>
                <a:xfrm>
                  <a:off x="3276312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19" name="Freeform: Shape 118">
                  <a:extLst>
                    <a:ext uri="{FF2B5EF4-FFF2-40B4-BE49-F238E27FC236}">
                      <a16:creationId xmlns:a16="http://schemas.microsoft.com/office/drawing/2014/main" id="{3B7BDBD1-9191-83D3-D93B-50245249A0E8}"/>
                    </a:ext>
                  </a:extLst>
                </p:cNvPr>
                <p:cNvSpPr/>
                <p:nvPr/>
              </p:nvSpPr>
              <p:spPr>
                <a:xfrm>
                  <a:off x="3196413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0" name="Freeform: Shape 119">
                  <a:extLst>
                    <a:ext uri="{FF2B5EF4-FFF2-40B4-BE49-F238E27FC236}">
                      <a16:creationId xmlns:a16="http://schemas.microsoft.com/office/drawing/2014/main" id="{2408D98F-67F6-92E4-105D-5625E14A1FD5}"/>
                    </a:ext>
                  </a:extLst>
                </p:cNvPr>
                <p:cNvSpPr/>
                <p:nvPr/>
              </p:nvSpPr>
              <p:spPr>
                <a:xfrm>
                  <a:off x="3534438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1" name="Freeform: Shape 120">
                  <a:extLst>
                    <a:ext uri="{FF2B5EF4-FFF2-40B4-BE49-F238E27FC236}">
                      <a16:creationId xmlns:a16="http://schemas.microsoft.com/office/drawing/2014/main" id="{0A6CF664-D65E-9B12-DBE7-040EB694039D}"/>
                    </a:ext>
                  </a:extLst>
                </p:cNvPr>
                <p:cNvSpPr/>
                <p:nvPr/>
              </p:nvSpPr>
              <p:spPr>
                <a:xfrm>
                  <a:off x="3798714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2" name="Freeform: Shape 121">
                  <a:extLst>
                    <a:ext uri="{FF2B5EF4-FFF2-40B4-BE49-F238E27FC236}">
                      <a16:creationId xmlns:a16="http://schemas.microsoft.com/office/drawing/2014/main" id="{05CAA4FE-7C65-13C4-22F7-0CC9C3A49B6F}"/>
                    </a:ext>
                  </a:extLst>
                </p:cNvPr>
                <p:cNvSpPr/>
                <p:nvPr/>
              </p:nvSpPr>
              <p:spPr>
                <a:xfrm>
                  <a:off x="4044542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3" name="Freeform: Shape 122">
                  <a:extLst>
                    <a:ext uri="{FF2B5EF4-FFF2-40B4-BE49-F238E27FC236}">
                      <a16:creationId xmlns:a16="http://schemas.microsoft.com/office/drawing/2014/main" id="{6D78B547-813A-D83F-C742-A0C316DE350A}"/>
                    </a:ext>
                  </a:extLst>
                </p:cNvPr>
                <p:cNvSpPr/>
                <p:nvPr/>
              </p:nvSpPr>
              <p:spPr>
                <a:xfrm>
                  <a:off x="4397935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5" name="Freeform: Shape 124">
                  <a:extLst>
                    <a:ext uri="{FF2B5EF4-FFF2-40B4-BE49-F238E27FC236}">
                      <a16:creationId xmlns:a16="http://schemas.microsoft.com/office/drawing/2014/main" id="{A4796FA2-0E9D-944C-8474-2D81C278B46B}"/>
                    </a:ext>
                  </a:extLst>
                </p:cNvPr>
                <p:cNvSpPr/>
                <p:nvPr/>
              </p:nvSpPr>
              <p:spPr>
                <a:xfrm>
                  <a:off x="4075277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6" name="Freeform: Shape 125">
                  <a:extLst>
                    <a:ext uri="{FF2B5EF4-FFF2-40B4-BE49-F238E27FC236}">
                      <a16:creationId xmlns:a16="http://schemas.microsoft.com/office/drawing/2014/main" id="{69344A35-F9F3-62AA-0FB1-B50E0E4A8CA9}"/>
                    </a:ext>
                  </a:extLst>
                </p:cNvPr>
                <p:cNvSpPr/>
                <p:nvPr/>
              </p:nvSpPr>
              <p:spPr>
                <a:xfrm>
                  <a:off x="3534438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7" name="Freeform: Shape 126">
                  <a:extLst>
                    <a:ext uri="{FF2B5EF4-FFF2-40B4-BE49-F238E27FC236}">
                      <a16:creationId xmlns:a16="http://schemas.microsoft.com/office/drawing/2014/main" id="{739CF5B2-8F92-FCE0-2ACA-9AAB9A239D0B}"/>
                    </a:ext>
                  </a:extLst>
                </p:cNvPr>
                <p:cNvSpPr/>
                <p:nvPr/>
              </p:nvSpPr>
              <p:spPr>
                <a:xfrm>
                  <a:off x="353443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8" name="Freeform: Shape 127">
                  <a:extLst>
                    <a:ext uri="{FF2B5EF4-FFF2-40B4-BE49-F238E27FC236}">
                      <a16:creationId xmlns:a16="http://schemas.microsoft.com/office/drawing/2014/main" id="{25B20E79-ED27-4AC7-9329-EBD5817BAA2D}"/>
                    </a:ext>
                  </a:extLst>
                </p:cNvPr>
                <p:cNvSpPr/>
                <p:nvPr/>
              </p:nvSpPr>
              <p:spPr>
                <a:xfrm>
                  <a:off x="3362351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29" name="Freeform: Shape 128">
                  <a:extLst>
                    <a:ext uri="{FF2B5EF4-FFF2-40B4-BE49-F238E27FC236}">
                      <a16:creationId xmlns:a16="http://schemas.microsoft.com/office/drawing/2014/main" id="{5631175F-9E60-8462-6DAF-2B6F091DE700}"/>
                    </a:ext>
                  </a:extLst>
                </p:cNvPr>
                <p:cNvSpPr/>
                <p:nvPr/>
              </p:nvSpPr>
              <p:spPr>
                <a:xfrm>
                  <a:off x="3777197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0" name="Freeform: Shape 129">
                  <a:extLst>
                    <a:ext uri="{FF2B5EF4-FFF2-40B4-BE49-F238E27FC236}">
                      <a16:creationId xmlns:a16="http://schemas.microsoft.com/office/drawing/2014/main" id="{4559EF09-D8A5-F7E7-04F1-FE4DF0AAE574}"/>
                    </a:ext>
                  </a:extLst>
                </p:cNvPr>
                <p:cNvSpPr/>
                <p:nvPr/>
              </p:nvSpPr>
              <p:spPr>
                <a:xfrm>
                  <a:off x="4056840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3" name="Freeform: Shape 132">
                  <a:extLst>
                    <a:ext uri="{FF2B5EF4-FFF2-40B4-BE49-F238E27FC236}">
                      <a16:creationId xmlns:a16="http://schemas.microsoft.com/office/drawing/2014/main" id="{7B1D57BA-00A2-4F4F-6F4F-10F8A8558846}"/>
                    </a:ext>
                  </a:extLst>
                </p:cNvPr>
                <p:cNvSpPr/>
                <p:nvPr/>
              </p:nvSpPr>
              <p:spPr>
                <a:xfrm>
                  <a:off x="4250435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4" name="Freeform: Shape 133">
                  <a:extLst>
                    <a:ext uri="{FF2B5EF4-FFF2-40B4-BE49-F238E27FC236}">
                      <a16:creationId xmlns:a16="http://schemas.microsoft.com/office/drawing/2014/main" id="{BF01A6F1-BE75-924C-29E9-75563348DBF9}"/>
                    </a:ext>
                  </a:extLst>
                </p:cNvPr>
                <p:cNvSpPr/>
                <p:nvPr/>
              </p:nvSpPr>
              <p:spPr>
                <a:xfrm>
                  <a:off x="3789495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6" name="Freeform: Shape 135">
                  <a:extLst>
                    <a:ext uri="{FF2B5EF4-FFF2-40B4-BE49-F238E27FC236}">
                      <a16:creationId xmlns:a16="http://schemas.microsoft.com/office/drawing/2014/main" id="{3428AF78-B8C3-25D3-63AA-00D1E16119CD}"/>
                    </a:ext>
                  </a:extLst>
                </p:cNvPr>
                <p:cNvSpPr/>
                <p:nvPr/>
              </p:nvSpPr>
              <p:spPr>
                <a:xfrm>
                  <a:off x="3666571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7" name="Freeform: Shape 136">
                  <a:extLst>
                    <a:ext uri="{FF2B5EF4-FFF2-40B4-BE49-F238E27FC236}">
                      <a16:creationId xmlns:a16="http://schemas.microsoft.com/office/drawing/2014/main" id="{1FC93424-0421-FEFA-B4A3-D5E21E51BF62}"/>
                    </a:ext>
                  </a:extLst>
                </p:cNvPr>
                <p:cNvSpPr/>
                <p:nvPr/>
              </p:nvSpPr>
              <p:spPr>
                <a:xfrm>
                  <a:off x="4044542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38" name="Freeform: Shape 137">
                  <a:extLst>
                    <a:ext uri="{FF2B5EF4-FFF2-40B4-BE49-F238E27FC236}">
                      <a16:creationId xmlns:a16="http://schemas.microsoft.com/office/drawing/2014/main" id="{DE9611B1-8597-45B6-E140-4BAB9D3A1B1A}"/>
                    </a:ext>
                  </a:extLst>
                </p:cNvPr>
                <p:cNvSpPr/>
                <p:nvPr/>
              </p:nvSpPr>
              <p:spPr>
                <a:xfrm>
                  <a:off x="4729812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1" name="Freeform: Shape 140">
                  <a:extLst>
                    <a:ext uri="{FF2B5EF4-FFF2-40B4-BE49-F238E27FC236}">
                      <a16:creationId xmlns:a16="http://schemas.microsoft.com/office/drawing/2014/main" id="{155FBC54-005F-A633-C55B-A3429D2F8141}"/>
                    </a:ext>
                  </a:extLst>
                </p:cNvPr>
                <p:cNvSpPr/>
                <p:nvPr/>
              </p:nvSpPr>
              <p:spPr>
                <a:xfrm>
                  <a:off x="4047621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3" name="Freeform: Shape 142">
                  <a:extLst>
                    <a:ext uri="{FF2B5EF4-FFF2-40B4-BE49-F238E27FC236}">
                      <a16:creationId xmlns:a16="http://schemas.microsoft.com/office/drawing/2014/main" id="{E579E387-4EBF-86E1-2562-C6AC325F03E1}"/>
                    </a:ext>
                  </a:extLst>
                </p:cNvPr>
                <p:cNvSpPr/>
                <p:nvPr/>
              </p:nvSpPr>
              <p:spPr>
                <a:xfrm>
                  <a:off x="3958503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4" name="Freeform: Shape 143">
                  <a:extLst>
                    <a:ext uri="{FF2B5EF4-FFF2-40B4-BE49-F238E27FC236}">
                      <a16:creationId xmlns:a16="http://schemas.microsoft.com/office/drawing/2014/main" id="{18E2754C-9232-B20D-A9FF-C3149170B2CC}"/>
                    </a:ext>
                  </a:extLst>
                </p:cNvPr>
                <p:cNvSpPr/>
                <p:nvPr/>
              </p:nvSpPr>
              <p:spPr>
                <a:xfrm>
                  <a:off x="4388717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7" name="Freeform: Shape 146">
                  <a:extLst>
                    <a:ext uri="{FF2B5EF4-FFF2-40B4-BE49-F238E27FC236}">
                      <a16:creationId xmlns:a16="http://schemas.microsoft.com/office/drawing/2014/main" id="{83EA8F7C-81B6-5ABF-AA43-E5F8E5A970E5}"/>
                    </a:ext>
                  </a:extLst>
                </p:cNvPr>
                <p:cNvSpPr/>
                <p:nvPr/>
              </p:nvSpPr>
              <p:spPr>
                <a:xfrm>
                  <a:off x="4244286" y="288491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49" name="Freeform: Shape 148">
                  <a:extLst>
                    <a:ext uri="{FF2B5EF4-FFF2-40B4-BE49-F238E27FC236}">
                      <a16:creationId xmlns:a16="http://schemas.microsoft.com/office/drawing/2014/main" id="{48BBE139-F7EF-579F-40FB-8AC52BB9DA57}"/>
                    </a:ext>
                  </a:extLst>
                </p:cNvPr>
                <p:cNvSpPr/>
                <p:nvPr/>
              </p:nvSpPr>
              <p:spPr>
                <a:xfrm>
                  <a:off x="4225848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0" name="Freeform: Shape 149">
                  <a:extLst>
                    <a:ext uri="{FF2B5EF4-FFF2-40B4-BE49-F238E27FC236}">
                      <a16:creationId xmlns:a16="http://schemas.microsoft.com/office/drawing/2014/main" id="{EB30EFDD-6988-1A82-0E0E-FA4E7A143AD9}"/>
                    </a:ext>
                  </a:extLst>
                </p:cNvPr>
                <p:cNvSpPr/>
                <p:nvPr/>
              </p:nvSpPr>
              <p:spPr>
                <a:xfrm>
                  <a:off x="4720593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4" name="Freeform: Shape 153">
                  <a:extLst>
                    <a:ext uri="{FF2B5EF4-FFF2-40B4-BE49-F238E27FC236}">
                      <a16:creationId xmlns:a16="http://schemas.microsoft.com/office/drawing/2014/main" id="{77D8606C-E82D-054F-1821-2A4DF00E5B9C}"/>
                    </a:ext>
                  </a:extLst>
                </p:cNvPr>
                <p:cNvSpPr/>
                <p:nvPr/>
              </p:nvSpPr>
              <p:spPr>
                <a:xfrm>
                  <a:off x="4434811" y="25814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58" name="Freeform: Shape 157">
                  <a:extLst>
                    <a:ext uri="{FF2B5EF4-FFF2-40B4-BE49-F238E27FC236}">
                      <a16:creationId xmlns:a16="http://schemas.microsoft.com/office/drawing/2014/main" id="{E67E75D2-D8D4-241D-1725-4C7812E4C980}"/>
                    </a:ext>
                  </a:extLst>
                </p:cNvPr>
                <p:cNvSpPr/>
                <p:nvPr/>
              </p:nvSpPr>
              <p:spPr>
                <a:xfrm>
                  <a:off x="5504811" y="77040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0" name="Freeform: Shape 159">
                  <a:extLst>
                    <a:ext uri="{FF2B5EF4-FFF2-40B4-BE49-F238E27FC236}">
                      <a16:creationId xmlns:a16="http://schemas.microsoft.com/office/drawing/2014/main" id="{F0DF6D63-BF69-4B4C-189B-CC0359DCE932}"/>
                    </a:ext>
                  </a:extLst>
                </p:cNvPr>
                <p:cNvSpPr/>
                <p:nvPr/>
              </p:nvSpPr>
              <p:spPr>
                <a:xfrm>
                  <a:off x="6058496" y="166996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1" name="Freeform: Shape 160">
                  <a:extLst>
                    <a:ext uri="{FF2B5EF4-FFF2-40B4-BE49-F238E27FC236}">
                      <a16:creationId xmlns:a16="http://schemas.microsoft.com/office/drawing/2014/main" id="{117204F0-1AA3-C7F0-1524-0503D9188BF7}"/>
                    </a:ext>
                  </a:extLst>
                </p:cNvPr>
                <p:cNvSpPr/>
                <p:nvPr/>
              </p:nvSpPr>
              <p:spPr>
                <a:xfrm>
                  <a:off x="6030079" y="77279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2" name="Freeform: Shape 161">
                  <a:extLst>
                    <a:ext uri="{FF2B5EF4-FFF2-40B4-BE49-F238E27FC236}">
                      <a16:creationId xmlns:a16="http://schemas.microsoft.com/office/drawing/2014/main" id="{66AF94A9-7415-A46F-223F-6AE08F2482B5}"/>
                    </a:ext>
                  </a:extLst>
                </p:cNvPr>
                <p:cNvSpPr/>
                <p:nvPr/>
              </p:nvSpPr>
              <p:spPr>
                <a:xfrm>
                  <a:off x="6084473" y="197884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dirty="0"/>
                </a:p>
              </p:txBody>
            </p:sp>
            <p:sp>
              <p:nvSpPr>
                <p:cNvPr id="163" name="Freeform: Shape 162">
                  <a:extLst>
                    <a:ext uri="{FF2B5EF4-FFF2-40B4-BE49-F238E27FC236}">
                      <a16:creationId xmlns:a16="http://schemas.microsoft.com/office/drawing/2014/main" id="{38446E02-FC73-2228-F37E-14322F70376A}"/>
                    </a:ext>
                  </a:extLst>
                </p:cNvPr>
                <p:cNvSpPr/>
                <p:nvPr/>
              </p:nvSpPr>
              <p:spPr>
                <a:xfrm>
                  <a:off x="6872861" y="166996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4" name="Freeform: Shape 163">
                  <a:extLst>
                    <a:ext uri="{FF2B5EF4-FFF2-40B4-BE49-F238E27FC236}">
                      <a16:creationId xmlns:a16="http://schemas.microsoft.com/office/drawing/2014/main" id="{035E8B21-4A10-80E5-1DEA-E902AEDCBB28}"/>
                    </a:ext>
                  </a:extLst>
                </p:cNvPr>
                <p:cNvSpPr/>
                <p:nvPr/>
              </p:nvSpPr>
              <p:spPr>
                <a:xfrm>
                  <a:off x="6320592" y="77279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5" name="Freeform: Shape 164">
                  <a:extLst>
                    <a:ext uri="{FF2B5EF4-FFF2-40B4-BE49-F238E27FC236}">
                      <a16:creationId xmlns:a16="http://schemas.microsoft.com/office/drawing/2014/main" id="{14420A85-1C7D-44A1-4D1B-17C9B843CB84}"/>
                    </a:ext>
                  </a:extLst>
                </p:cNvPr>
                <p:cNvSpPr/>
                <p:nvPr/>
              </p:nvSpPr>
              <p:spPr>
                <a:xfrm>
                  <a:off x="6355193" y="197884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6" name="Freeform: Shape 165">
                  <a:extLst>
                    <a:ext uri="{FF2B5EF4-FFF2-40B4-BE49-F238E27FC236}">
                      <a16:creationId xmlns:a16="http://schemas.microsoft.com/office/drawing/2014/main" id="{40221932-F120-80DC-E621-C1ACB42C0F14}"/>
                    </a:ext>
                  </a:extLst>
                </p:cNvPr>
                <p:cNvSpPr/>
                <p:nvPr/>
              </p:nvSpPr>
              <p:spPr>
                <a:xfrm>
                  <a:off x="7148139" y="166906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7" name="Freeform: Shape 166">
                  <a:extLst>
                    <a:ext uri="{FF2B5EF4-FFF2-40B4-BE49-F238E27FC236}">
                      <a16:creationId xmlns:a16="http://schemas.microsoft.com/office/drawing/2014/main" id="{77AE55CB-9F2C-7224-11E7-82B8CAE86F40}"/>
                    </a:ext>
                  </a:extLst>
                </p:cNvPr>
                <p:cNvSpPr/>
                <p:nvPr/>
              </p:nvSpPr>
              <p:spPr>
                <a:xfrm>
                  <a:off x="6880962" y="768832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8" name="Freeform: Shape 167">
                  <a:extLst>
                    <a:ext uri="{FF2B5EF4-FFF2-40B4-BE49-F238E27FC236}">
                      <a16:creationId xmlns:a16="http://schemas.microsoft.com/office/drawing/2014/main" id="{0AAADF03-2169-86E1-C195-C21FF79F3A06}"/>
                    </a:ext>
                  </a:extLst>
                </p:cNvPr>
                <p:cNvSpPr/>
                <p:nvPr/>
              </p:nvSpPr>
              <p:spPr>
                <a:xfrm>
                  <a:off x="6622759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69" name="Freeform: Shape 168">
                  <a:extLst>
                    <a:ext uri="{FF2B5EF4-FFF2-40B4-BE49-F238E27FC236}">
                      <a16:creationId xmlns:a16="http://schemas.microsoft.com/office/drawing/2014/main" id="{22C897CA-2DE6-24A2-AC8A-B39996917D19}"/>
                    </a:ext>
                  </a:extLst>
                </p:cNvPr>
                <p:cNvSpPr/>
                <p:nvPr/>
              </p:nvSpPr>
              <p:spPr>
                <a:xfrm>
                  <a:off x="7430934" y="1668546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0" name="Freeform: Shape 169">
                  <a:extLst>
                    <a:ext uri="{FF2B5EF4-FFF2-40B4-BE49-F238E27FC236}">
                      <a16:creationId xmlns:a16="http://schemas.microsoft.com/office/drawing/2014/main" id="{C0DBB5A4-64F5-EF30-D768-4A9F2E937816}"/>
                    </a:ext>
                  </a:extLst>
                </p:cNvPr>
                <p:cNvSpPr/>
                <p:nvPr/>
              </p:nvSpPr>
              <p:spPr>
                <a:xfrm>
                  <a:off x="7087214" y="77279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1" name="Freeform: Shape 170">
                  <a:extLst>
                    <a:ext uri="{FF2B5EF4-FFF2-40B4-BE49-F238E27FC236}">
                      <a16:creationId xmlns:a16="http://schemas.microsoft.com/office/drawing/2014/main" id="{53802166-73E5-37F1-821C-8BC3E4E8BA0B}"/>
                    </a:ext>
                  </a:extLst>
                </p:cNvPr>
                <p:cNvSpPr/>
                <p:nvPr/>
              </p:nvSpPr>
              <p:spPr>
                <a:xfrm>
                  <a:off x="6882148" y="197856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dirty="0"/>
                </a:p>
              </p:txBody>
            </p:sp>
            <p:sp>
              <p:nvSpPr>
                <p:cNvPr id="172" name="Freeform: Shape 171">
                  <a:extLst>
                    <a:ext uri="{FF2B5EF4-FFF2-40B4-BE49-F238E27FC236}">
                      <a16:creationId xmlns:a16="http://schemas.microsoft.com/office/drawing/2014/main" id="{9039E569-DE22-55C5-3EB5-097A0B06312D}"/>
                    </a:ext>
                  </a:extLst>
                </p:cNvPr>
                <p:cNvSpPr/>
                <p:nvPr/>
              </p:nvSpPr>
              <p:spPr>
                <a:xfrm>
                  <a:off x="7156956" y="1975383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dirty="0"/>
                </a:p>
              </p:txBody>
            </p:sp>
            <p:sp>
              <p:nvSpPr>
                <p:cNvPr id="173" name="Freeform: Shape 172">
                  <a:extLst>
                    <a:ext uri="{FF2B5EF4-FFF2-40B4-BE49-F238E27FC236}">
                      <a16:creationId xmlns:a16="http://schemas.microsoft.com/office/drawing/2014/main" id="{AA5311A7-2C79-4798-A7B3-56E3F09AF9AB}"/>
                    </a:ext>
                  </a:extLst>
                </p:cNvPr>
                <p:cNvSpPr/>
                <p:nvPr/>
              </p:nvSpPr>
              <p:spPr>
                <a:xfrm>
                  <a:off x="7447303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4" name="Freeform: Shape 173">
                  <a:extLst>
                    <a:ext uri="{FF2B5EF4-FFF2-40B4-BE49-F238E27FC236}">
                      <a16:creationId xmlns:a16="http://schemas.microsoft.com/office/drawing/2014/main" id="{37CF71DE-79E3-A56A-4251-0499A73318B8}"/>
                    </a:ext>
                  </a:extLst>
                </p:cNvPr>
                <p:cNvSpPr/>
                <p:nvPr/>
              </p:nvSpPr>
              <p:spPr>
                <a:xfrm>
                  <a:off x="2163910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5" name="Freeform: Shape 174">
                  <a:extLst>
                    <a:ext uri="{FF2B5EF4-FFF2-40B4-BE49-F238E27FC236}">
                      <a16:creationId xmlns:a16="http://schemas.microsoft.com/office/drawing/2014/main" id="{5785BA01-DCE5-1B3F-F95F-07D457FCFEF3}"/>
                    </a:ext>
                  </a:extLst>
                </p:cNvPr>
                <p:cNvSpPr/>
                <p:nvPr/>
              </p:nvSpPr>
              <p:spPr>
                <a:xfrm>
                  <a:off x="2160838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6" name="Freeform: Shape 175">
                  <a:extLst>
                    <a:ext uri="{FF2B5EF4-FFF2-40B4-BE49-F238E27FC236}">
                      <a16:creationId xmlns:a16="http://schemas.microsoft.com/office/drawing/2014/main" id="{454583F8-7896-CC28-0E3A-604956E2E19E}"/>
                    </a:ext>
                  </a:extLst>
                </p:cNvPr>
                <p:cNvSpPr/>
                <p:nvPr/>
              </p:nvSpPr>
              <p:spPr>
                <a:xfrm>
                  <a:off x="2160838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7" name="Freeform: Shape 176">
                  <a:extLst>
                    <a:ext uri="{FF2B5EF4-FFF2-40B4-BE49-F238E27FC236}">
                      <a16:creationId xmlns:a16="http://schemas.microsoft.com/office/drawing/2014/main" id="{6DD9BE17-6D96-0B0F-8459-836E8CE627AB}"/>
                    </a:ext>
                  </a:extLst>
                </p:cNvPr>
                <p:cNvSpPr/>
                <p:nvPr/>
              </p:nvSpPr>
              <p:spPr>
                <a:xfrm>
                  <a:off x="2160838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8" name="Freeform: Shape 177">
                  <a:extLst>
                    <a:ext uri="{FF2B5EF4-FFF2-40B4-BE49-F238E27FC236}">
                      <a16:creationId xmlns:a16="http://schemas.microsoft.com/office/drawing/2014/main" id="{F46DF0BB-439B-8802-5ECC-1D66146D7F77}"/>
                    </a:ext>
                  </a:extLst>
                </p:cNvPr>
                <p:cNvSpPr/>
                <p:nvPr/>
              </p:nvSpPr>
              <p:spPr>
                <a:xfrm>
                  <a:off x="2160838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79" name="Freeform: Shape 178">
                  <a:extLst>
                    <a:ext uri="{FF2B5EF4-FFF2-40B4-BE49-F238E27FC236}">
                      <a16:creationId xmlns:a16="http://schemas.microsoft.com/office/drawing/2014/main" id="{F35ACD8E-9D0B-7FD7-26A7-BF0A724C9720}"/>
                    </a:ext>
                  </a:extLst>
                </p:cNvPr>
                <p:cNvSpPr/>
                <p:nvPr/>
              </p:nvSpPr>
              <p:spPr>
                <a:xfrm>
                  <a:off x="2160838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0" name="Freeform: Shape 179">
                  <a:extLst>
                    <a:ext uri="{FF2B5EF4-FFF2-40B4-BE49-F238E27FC236}">
                      <a16:creationId xmlns:a16="http://schemas.microsoft.com/office/drawing/2014/main" id="{6434702D-E5CF-5D81-B544-F09FCDD48AA2}"/>
                    </a:ext>
                  </a:extLst>
                </p:cNvPr>
                <p:cNvSpPr/>
                <p:nvPr/>
              </p:nvSpPr>
              <p:spPr>
                <a:xfrm>
                  <a:off x="2335995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1" name="Freeform: Shape 180">
                  <a:extLst>
                    <a:ext uri="{FF2B5EF4-FFF2-40B4-BE49-F238E27FC236}">
                      <a16:creationId xmlns:a16="http://schemas.microsoft.com/office/drawing/2014/main" id="{0D4A2F34-62A8-4834-1C65-921353FEB8A8}"/>
                    </a:ext>
                  </a:extLst>
                </p:cNvPr>
                <p:cNvSpPr/>
                <p:nvPr/>
              </p:nvSpPr>
              <p:spPr>
                <a:xfrm>
                  <a:off x="2332922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2" name="Freeform: Shape 181">
                  <a:extLst>
                    <a:ext uri="{FF2B5EF4-FFF2-40B4-BE49-F238E27FC236}">
                      <a16:creationId xmlns:a16="http://schemas.microsoft.com/office/drawing/2014/main" id="{4F43A2B8-CE5C-B28A-7082-15A616462ADB}"/>
                    </a:ext>
                  </a:extLst>
                </p:cNvPr>
                <p:cNvSpPr/>
                <p:nvPr/>
              </p:nvSpPr>
              <p:spPr>
                <a:xfrm>
                  <a:off x="2332922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3" name="Freeform: Shape 182">
                  <a:extLst>
                    <a:ext uri="{FF2B5EF4-FFF2-40B4-BE49-F238E27FC236}">
                      <a16:creationId xmlns:a16="http://schemas.microsoft.com/office/drawing/2014/main" id="{9EFA74C0-697C-DF0F-ED5D-D3B288AA7C9A}"/>
                    </a:ext>
                  </a:extLst>
                </p:cNvPr>
                <p:cNvSpPr/>
                <p:nvPr/>
              </p:nvSpPr>
              <p:spPr>
                <a:xfrm>
                  <a:off x="2335995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4" name="Freeform: Shape 183">
                  <a:extLst>
                    <a:ext uri="{FF2B5EF4-FFF2-40B4-BE49-F238E27FC236}">
                      <a16:creationId xmlns:a16="http://schemas.microsoft.com/office/drawing/2014/main" id="{472A07AE-D9E7-382F-9C0C-22F17089FC7A}"/>
                    </a:ext>
                  </a:extLst>
                </p:cNvPr>
                <p:cNvSpPr/>
                <p:nvPr/>
              </p:nvSpPr>
              <p:spPr>
                <a:xfrm>
                  <a:off x="2332922" y="318834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5" name="Freeform: Shape 184">
                  <a:extLst>
                    <a:ext uri="{FF2B5EF4-FFF2-40B4-BE49-F238E27FC236}">
                      <a16:creationId xmlns:a16="http://schemas.microsoft.com/office/drawing/2014/main" id="{B6DCDC93-3D6A-7D97-E673-6F03689AC2A6}"/>
                    </a:ext>
                  </a:extLst>
                </p:cNvPr>
                <p:cNvSpPr/>
                <p:nvPr/>
              </p:nvSpPr>
              <p:spPr>
                <a:xfrm>
                  <a:off x="2323703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6" name="Freeform: Shape 185">
                  <a:extLst>
                    <a:ext uri="{FF2B5EF4-FFF2-40B4-BE49-F238E27FC236}">
                      <a16:creationId xmlns:a16="http://schemas.microsoft.com/office/drawing/2014/main" id="{9AC4304F-800B-1316-5087-8DBAC1849539}"/>
                    </a:ext>
                  </a:extLst>
                </p:cNvPr>
                <p:cNvSpPr/>
                <p:nvPr/>
              </p:nvSpPr>
              <p:spPr>
                <a:xfrm>
                  <a:off x="2508079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7" name="Freeform: Shape 186">
                  <a:extLst>
                    <a:ext uri="{FF2B5EF4-FFF2-40B4-BE49-F238E27FC236}">
                      <a16:creationId xmlns:a16="http://schemas.microsoft.com/office/drawing/2014/main" id="{A1BD1E7F-1354-DD8B-07F6-9BC356DD5565}"/>
                    </a:ext>
                  </a:extLst>
                </p:cNvPr>
                <p:cNvSpPr/>
                <p:nvPr/>
              </p:nvSpPr>
              <p:spPr>
                <a:xfrm>
                  <a:off x="2505006" y="136775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8" name="Freeform: Shape 187">
                  <a:extLst>
                    <a:ext uri="{FF2B5EF4-FFF2-40B4-BE49-F238E27FC236}">
                      <a16:creationId xmlns:a16="http://schemas.microsoft.com/office/drawing/2014/main" id="{18671871-E98E-5579-FC5C-2D46DADB9BF7}"/>
                    </a:ext>
                  </a:extLst>
                </p:cNvPr>
                <p:cNvSpPr/>
                <p:nvPr/>
              </p:nvSpPr>
              <p:spPr>
                <a:xfrm>
                  <a:off x="2505006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89" name="Freeform: Shape 188">
                  <a:extLst>
                    <a:ext uri="{FF2B5EF4-FFF2-40B4-BE49-F238E27FC236}">
                      <a16:creationId xmlns:a16="http://schemas.microsoft.com/office/drawing/2014/main" id="{96B4F639-7F6E-D93B-46D7-6C0A8D5C0523}"/>
                    </a:ext>
                  </a:extLst>
                </p:cNvPr>
                <p:cNvSpPr/>
                <p:nvPr/>
              </p:nvSpPr>
              <p:spPr>
                <a:xfrm>
                  <a:off x="2501933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0" name="Freeform: Shape 189">
                  <a:extLst>
                    <a:ext uri="{FF2B5EF4-FFF2-40B4-BE49-F238E27FC236}">
                      <a16:creationId xmlns:a16="http://schemas.microsoft.com/office/drawing/2014/main" id="{CE370B0A-1DFA-EE64-7BDB-9FC39A676A4C}"/>
                    </a:ext>
                  </a:extLst>
                </p:cNvPr>
                <p:cNvSpPr/>
                <p:nvPr/>
              </p:nvSpPr>
              <p:spPr>
                <a:xfrm>
                  <a:off x="2680163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1" name="Freeform: Shape 190">
                  <a:extLst>
                    <a:ext uri="{FF2B5EF4-FFF2-40B4-BE49-F238E27FC236}">
                      <a16:creationId xmlns:a16="http://schemas.microsoft.com/office/drawing/2014/main" id="{F726D4C5-BD69-7B7F-F7B9-6D05C087C796}"/>
                    </a:ext>
                  </a:extLst>
                </p:cNvPr>
                <p:cNvSpPr/>
                <p:nvPr/>
              </p:nvSpPr>
              <p:spPr>
                <a:xfrm>
                  <a:off x="5563681" y="1363522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2" name="Freeform: Shape 191">
                  <a:extLst>
                    <a:ext uri="{FF2B5EF4-FFF2-40B4-BE49-F238E27FC236}">
                      <a16:creationId xmlns:a16="http://schemas.microsoft.com/office/drawing/2014/main" id="{31689AA3-A72E-BBD5-3EEE-25D87B501740}"/>
                    </a:ext>
                  </a:extLst>
                </p:cNvPr>
                <p:cNvSpPr/>
                <p:nvPr/>
              </p:nvSpPr>
              <p:spPr>
                <a:xfrm>
                  <a:off x="2677090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3" name="Freeform: Shape 192">
                  <a:extLst>
                    <a:ext uri="{FF2B5EF4-FFF2-40B4-BE49-F238E27FC236}">
                      <a16:creationId xmlns:a16="http://schemas.microsoft.com/office/drawing/2014/main" id="{4F7885E7-F2EF-0509-D7ED-A79F23B27DC0}"/>
                    </a:ext>
                  </a:extLst>
                </p:cNvPr>
                <p:cNvSpPr/>
                <p:nvPr/>
              </p:nvSpPr>
              <p:spPr>
                <a:xfrm>
                  <a:off x="2664799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4" name="Freeform: Shape 193">
                  <a:extLst>
                    <a:ext uri="{FF2B5EF4-FFF2-40B4-BE49-F238E27FC236}">
                      <a16:creationId xmlns:a16="http://schemas.microsoft.com/office/drawing/2014/main" id="{C7B19CDC-61B9-4D84-7B6D-3A55CF21608C}"/>
                    </a:ext>
                  </a:extLst>
                </p:cNvPr>
                <p:cNvSpPr/>
                <p:nvPr/>
              </p:nvSpPr>
              <p:spPr>
                <a:xfrm>
                  <a:off x="2852247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6" name="Freeform: Shape 195">
                  <a:extLst>
                    <a:ext uri="{FF2B5EF4-FFF2-40B4-BE49-F238E27FC236}">
                      <a16:creationId xmlns:a16="http://schemas.microsoft.com/office/drawing/2014/main" id="{1485DC87-6BA0-EF4D-47BF-FF1A3DEE9196}"/>
                    </a:ext>
                  </a:extLst>
                </p:cNvPr>
                <p:cNvSpPr/>
                <p:nvPr/>
              </p:nvSpPr>
              <p:spPr>
                <a:xfrm>
                  <a:off x="2843029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7" name="Freeform: Shape 196">
                  <a:extLst>
                    <a:ext uri="{FF2B5EF4-FFF2-40B4-BE49-F238E27FC236}">
                      <a16:creationId xmlns:a16="http://schemas.microsoft.com/office/drawing/2014/main" id="{9F66F30B-CF22-2961-0F8B-ECB351FF5320}"/>
                    </a:ext>
                  </a:extLst>
                </p:cNvPr>
                <p:cNvSpPr/>
                <p:nvPr/>
              </p:nvSpPr>
              <p:spPr>
                <a:xfrm>
                  <a:off x="2843029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198" name="Freeform: Shape 197">
                  <a:extLst>
                    <a:ext uri="{FF2B5EF4-FFF2-40B4-BE49-F238E27FC236}">
                      <a16:creationId xmlns:a16="http://schemas.microsoft.com/office/drawing/2014/main" id="{501F7E39-8BCB-7DEA-4846-9DB551EED2B3}"/>
                    </a:ext>
                  </a:extLst>
                </p:cNvPr>
                <p:cNvSpPr/>
                <p:nvPr/>
              </p:nvSpPr>
              <p:spPr>
                <a:xfrm>
                  <a:off x="3027404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0" name="Freeform: Shape 199">
                  <a:extLst>
                    <a:ext uri="{FF2B5EF4-FFF2-40B4-BE49-F238E27FC236}">
                      <a16:creationId xmlns:a16="http://schemas.microsoft.com/office/drawing/2014/main" id="{C7B85777-950B-E41B-0C5B-F9A1389F9571}"/>
                    </a:ext>
                  </a:extLst>
                </p:cNvPr>
                <p:cNvSpPr/>
                <p:nvPr/>
              </p:nvSpPr>
              <p:spPr>
                <a:xfrm>
                  <a:off x="3021255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1" name="Freeform: Shape 200">
                  <a:extLst>
                    <a:ext uri="{FF2B5EF4-FFF2-40B4-BE49-F238E27FC236}">
                      <a16:creationId xmlns:a16="http://schemas.microsoft.com/office/drawing/2014/main" id="{4F527DBD-E553-874A-B664-327E1125342B}"/>
                    </a:ext>
                  </a:extLst>
                </p:cNvPr>
                <p:cNvSpPr/>
                <p:nvPr/>
              </p:nvSpPr>
              <p:spPr>
                <a:xfrm>
                  <a:off x="3027404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2" name="Freeform: Shape 201">
                  <a:extLst>
                    <a:ext uri="{FF2B5EF4-FFF2-40B4-BE49-F238E27FC236}">
                      <a16:creationId xmlns:a16="http://schemas.microsoft.com/office/drawing/2014/main" id="{940B5D5E-64BD-C98E-710D-56FD62A4D785}"/>
                    </a:ext>
                  </a:extLst>
                </p:cNvPr>
                <p:cNvSpPr/>
                <p:nvPr/>
              </p:nvSpPr>
              <p:spPr>
                <a:xfrm>
                  <a:off x="3282461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3" name="Freeform: Shape 202">
                  <a:extLst>
                    <a:ext uri="{FF2B5EF4-FFF2-40B4-BE49-F238E27FC236}">
                      <a16:creationId xmlns:a16="http://schemas.microsoft.com/office/drawing/2014/main" id="{839E90AD-65FD-B486-6825-1E38A7F870D6}"/>
                    </a:ext>
                  </a:extLst>
                </p:cNvPr>
                <p:cNvSpPr/>
                <p:nvPr/>
              </p:nvSpPr>
              <p:spPr>
                <a:xfrm>
                  <a:off x="4842785" y="136688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4" name="Freeform: Shape 203">
                  <a:extLst>
                    <a:ext uri="{FF2B5EF4-FFF2-40B4-BE49-F238E27FC236}">
                      <a16:creationId xmlns:a16="http://schemas.microsoft.com/office/drawing/2014/main" id="{76E5FC3A-443A-23FE-0F6F-77031AEDA80C}"/>
                    </a:ext>
                  </a:extLst>
                </p:cNvPr>
                <p:cNvSpPr/>
                <p:nvPr/>
              </p:nvSpPr>
              <p:spPr>
                <a:xfrm>
                  <a:off x="3279382" y="1064318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5" name="Freeform: Shape 204">
                  <a:extLst>
                    <a:ext uri="{FF2B5EF4-FFF2-40B4-BE49-F238E27FC236}">
                      <a16:creationId xmlns:a16="http://schemas.microsoft.com/office/drawing/2014/main" id="{9F47F9DB-CDD5-6D23-2AA1-2CC2A2E43DC2}"/>
                    </a:ext>
                  </a:extLst>
                </p:cNvPr>
                <p:cNvSpPr/>
                <p:nvPr/>
              </p:nvSpPr>
              <p:spPr>
                <a:xfrm>
                  <a:off x="3181054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6" name="Freeform: Shape 205">
                  <a:extLst>
                    <a:ext uri="{FF2B5EF4-FFF2-40B4-BE49-F238E27FC236}">
                      <a16:creationId xmlns:a16="http://schemas.microsoft.com/office/drawing/2014/main" id="{B78735FA-E5C6-58B0-E4D6-212FA39EB2B3}"/>
                    </a:ext>
                  </a:extLst>
                </p:cNvPr>
                <p:cNvSpPr/>
                <p:nvPr/>
              </p:nvSpPr>
              <p:spPr>
                <a:xfrm>
                  <a:off x="3540587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7" name="Freeform: Shape 206">
                  <a:extLst>
                    <a:ext uri="{FF2B5EF4-FFF2-40B4-BE49-F238E27FC236}">
                      <a16:creationId xmlns:a16="http://schemas.microsoft.com/office/drawing/2014/main" id="{40DD5CD4-08AC-530B-8097-C12D5907F5BD}"/>
                    </a:ext>
                  </a:extLst>
                </p:cNvPr>
                <p:cNvSpPr/>
                <p:nvPr/>
              </p:nvSpPr>
              <p:spPr>
                <a:xfrm>
                  <a:off x="5344236" y="136723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8" name="Freeform: Shape 207">
                  <a:extLst>
                    <a:ext uri="{FF2B5EF4-FFF2-40B4-BE49-F238E27FC236}">
                      <a16:creationId xmlns:a16="http://schemas.microsoft.com/office/drawing/2014/main" id="{488D8A40-8540-BCE2-469F-6208D5498449}"/>
                    </a:ext>
                  </a:extLst>
                </p:cNvPr>
                <p:cNvSpPr/>
                <p:nvPr/>
              </p:nvSpPr>
              <p:spPr>
                <a:xfrm>
                  <a:off x="3356211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09" name="Freeform: Shape 208">
                  <a:extLst>
                    <a:ext uri="{FF2B5EF4-FFF2-40B4-BE49-F238E27FC236}">
                      <a16:creationId xmlns:a16="http://schemas.microsoft.com/office/drawing/2014/main" id="{C76E0EA9-72FA-67A3-53D8-8657E510C96F}"/>
                    </a:ext>
                  </a:extLst>
                </p:cNvPr>
                <p:cNvSpPr/>
                <p:nvPr/>
              </p:nvSpPr>
              <p:spPr>
                <a:xfrm>
                  <a:off x="3795634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0" name="Freeform: Shape 209">
                  <a:extLst>
                    <a:ext uri="{FF2B5EF4-FFF2-40B4-BE49-F238E27FC236}">
                      <a16:creationId xmlns:a16="http://schemas.microsoft.com/office/drawing/2014/main" id="{2E3E5524-4CED-0274-F06A-1546A2A46E64}"/>
                    </a:ext>
                  </a:extLst>
                </p:cNvPr>
                <p:cNvSpPr/>
                <p:nvPr/>
              </p:nvSpPr>
              <p:spPr>
                <a:xfrm>
                  <a:off x="3703446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1" name="Freeform: Shape 210">
                  <a:extLst>
                    <a:ext uri="{FF2B5EF4-FFF2-40B4-BE49-F238E27FC236}">
                      <a16:creationId xmlns:a16="http://schemas.microsoft.com/office/drawing/2014/main" id="{0BCA470F-4644-5F04-CF12-5271659A1C34}"/>
                    </a:ext>
                  </a:extLst>
                </p:cNvPr>
                <p:cNvSpPr/>
                <p:nvPr/>
              </p:nvSpPr>
              <p:spPr>
                <a:xfrm>
                  <a:off x="4081417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2" name="Freeform: Shape 211">
                  <a:extLst>
                    <a:ext uri="{FF2B5EF4-FFF2-40B4-BE49-F238E27FC236}">
                      <a16:creationId xmlns:a16="http://schemas.microsoft.com/office/drawing/2014/main" id="{64E034B7-7EC5-FB0D-D694-FDC65C8EF463}"/>
                    </a:ext>
                  </a:extLst>
                </p:cNvPr>
                <p:cNvSpPr/>
                <p:nvPr/>
              </p:nvSpPr>
              <p:spPr>
                <a:xfrm>
                  <a:off x="3961573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3" name="Freeform: Shape 212">
                  <a:extLst>
                    <a:ext uri="{FF2B5EF4-FFF2-40B4-BE49-F238E27FC236}">
                      <a16:creationId xmlns:a16="http://schemas.microsoft.com/office/drawing/2014/main" id="{07D0F11C-79C5-1EA2-3F9E-096B4C1CC17A}"/>
                    </a:ext>
                  </a:extLst>
                </p:cNvPr>
                <p:cNvSpPr/>
                <p:nvPr/>
              </p:nvSpPr>
              <p:spPr>
                <a:xfrm>
                  <a:off x="4213559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4" name="Freeform: Shape 213">
                  <a:extLst>
                    <a:ext uri="{FF2B5EF4-FFF2-40B4-BE49-F238E27FC236}">
                      <a16:creationId xmlns:a16="http://schemas.microsoft.com/office/drawing/2014/main" id="{9871245B-D9EF-4EC5-CF1B-7429EAC59ED5}"/>
                    </a:ext>
                  </a:extLst>
                </p:cNvPr>
                <p:cNvSpPr/>
                <p:nvPr/>
              </p:nvSpPr>
              <p:spPr>
                <a:xfrm>
                  <a:off x="4434811" y="2278050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8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5" name="Freeform: Shape 214">
                  <a:extLst>
                    <a:ext uri="{FF2B5EF4-FFF2-40B4-BE49-F238E27FC236}">
                      <a16:creationId xmlns:a16="http://schemas.microsoft.com/office/drawing/2014/main" id="{01B1AF1E-0566-669B-F9CD-C93DE737F2A8}"/>
                    </a:ext>
                  </a:extLst>
                </p:cNvPr>
                <p:cNvSpPr/>
                <p:nvPr/>
              </p:nvSpPr>
              <p:spPr>
                <a:xfrm>
                  <a:off x="2166987" y="4402079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6" name="Freeform: Shape 215">
                  <a:extLst>
                    <a:ext uri="{FF2B5EF4-FFF2-40B4-BE49-F238E27FC236}">
                      <a16:creationId xmlns:a16="http://schemas.microsoft.com/office/drawing/2014/main" id="{A99C61C5-6F1A-BA7D-D8EE-F3107EB9C020}"/>
                    </a:ext>
                  </a:extLst>
                </p:cNvPr>
                <p:cNvSpPr/>
                <p:nvPr/>
              </p:nvSpPr>
              <p:spPr>
                <a:xfrm>
                  <a:off x="2846098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7" name="Freeform: Shape 216">
                  <a:extLst>
                    <a:ext uri="{FF2B5EF4-FFF2-40B4-BE49-F238E27FC236}">
                      <a16:creationId xmlns:a16="http://schemas.microsoft.com/office/drawing/2014/main" id="{86C60EB2-ADD4-AC6A-0E51-A62EA15E1388}"/>
                    </a:ext>
                  </a:extLst>
                </p:cNvPr>
                <p:cNvSpPr/>
                <p:nvPr/>
              </p:nvSpPr>
              <p:spPr>
                <a:xfrm>
                  <a:off x="4566944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8" name="Freeform: Shape 217">
                  <a:extLst>
                    <a:ext uri="{FF2B5EF4-FFF2-40B4-BE49-F238E27FC236}">
                      <a16:creationId xmlns:a16="http://schemas.microsoft.com/office/drawing/2014/main" id="{897AC9D2-C9EA-0D70-7033-343D8F8F1B6F}"/>
                    </a:ext>
                  </a:extLst>
                </p:cNvPr>
                <p:cNvSpPr/>
                <p:nvPr/>
              </p:nvSpPr>
              <p:spPr>
                <a:xfrm>
                  <a:off x="3002818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19" name="Freeform: Shape 218">
                  <a:extLst>
                    <a:ext uri="{FF2B5EF4-FFF2-40B4-BE49-F238E27FC236}">
                      <a16:creationId xmlns:a16="http://schemas.microsoft.com/office/drawing/2014/main" id="{763053B7-CD86-3BA5-9DB4-9BBB94146A02}"/>
                    </a:ext>
                  </a:extLst>
                </p:cNvPr>
                <p:cNvSpPr/>
                <p:nvPr/>
              </p:nvSpPr>
              <p:spPr>
                <a:xfrm>
                  <a:off x="3792565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1" name="Freeform: Shape 220">
                  <a:extLst>
                    <a:ext uri="{FF2B5EF4-FFF2-40B4-BE49-F238E27FC236}">
                      <a16:creationId xmlns:a16="http://schemas.microsoft.com/office/drawing/2014/main" id="{F3DB756A-EE2C-7AAB-63EB-10B15E823C8A}"/>
                    </a:ext>
                  </a:extLst>
                </p:cNvPr>
                <p:cNvSpPr/>
                <p:nvPr/>
              </p:nvSpPr>
              <p:spPr>
                <a:xfrm>
                  <a:off x="3018186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dirty="0">
                    <a:highlight>
                      <a:srgbClr val="FFFF00"/>
                    </a:highlight>
                  </a:endParaRPr>
                </a:p>
              </p:txBody>
            </p:sp>
            <p:sp>
              <p:nvSpPr>
                <p:cNvPr id="222" name="Freeform: Shape 221">
                  <a:extLst>
                    <a:ext uri="{FF2B5EF4-FFF2-40B4-BE49-F238E27FC236}">
                      <a16:creationId xmlns:a16="http://schemas.microsoft.com/office/drawing/2014/main" id="{553AD1F9-9394-EC0C-4F24-D66133D06403}"/>
                    </a:ext>
                  </a:extLst>
                </p:cNvPr>
                <p:cNvSpPr/>
                <p:nvPr/>
              </p:nvSpPr>
              <p:spPr>
                <a:xfrm>
                  <a:off x="4566944" y="409864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5 w 60993"/>
                    <a:gd name="connsiteY1" fmla="*/ 11 h 60993"/>
                    <a:gd name="connsiteX2" fmla="*/ 61005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5" y="11"/>
                      </a:lnTo>
                      <a:lnTo>
                        <a:pt x="61005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3" name="Freeform: Shape 222">
                  <a:extLst>
                    <a:ext uri="{FF2B5EF4-FFF2-40B4-BE49-F238E27FC236}">
                      <a16:creationId xmlns:a16="http://schemas.microsoft.com/office/drawing/2014/main" id="{313E2EEF-6E0B-64DA-7B98-C7E22209EBCB}"/>
                    </a:ext>
                  </a:extLst>
                </p:cNvPr>
                <p:cNvSpPr/>
                <p:nvPr/>
              </p:nvSpPr>
              <p:spPr>
                <a:xfrm>
                  <a:off x="3279382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4" name="Freeform: Shape 223">
                  <a:extLst>
                    <a:ext uri="{FF2B5EF4-FFF2-40B4-BE49-F238E27FC236}">
                      <a16:creationId xmlns:a16="http://schemas.microsoft.com/office/drawing/2014/main" id="{5BF46C76-B263-6A5F-B6B3-F6A82E24AC40}"/>
                    </a:ext>
                  </a:extLst>
                </p:cNvPr>
                <p:cNvSpPr/>
                <p:nvPr/>
              </p:nvSpPr>
              <p:spPr>
                <a:xfrm>
                  <a:off x="3792565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5" name="Freeform: Shape 224">
                  <a:extLst>
                    <a:ext uri="{FF2B5EF4-FFF2-40B4-BE49-F238E27FC236}">
                      <a16:creationId xmlns:a16="http://schemas.microsoft.com/office/drawing/2014/main" id="{0AA39653-E532-B2FF-91D7-CC4E7ADEB814}"/>
                    </a:ext>
                  </a:extLst>
                </p:cNvPr>
                <p:cNvSpPr/>
                <p:nvPr/>
              </p:nvSpPr>
              <p:spPr>
                <a:xfrm>
                  <a:off x="4388717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6" name="Freeform: Shape 225">
                  <a:extLst>
                    <a:ext uri="{FF2B5EF4-FFF2-40B4-BE49-F238E27FC236}">
                      <a16:creationId xmlns:a16="http://schemas.microsoft.com/office/drawing/2014/main" id="{DF4ADB06-C1A3-5F54-4632-E7FD44E9114B}"/>
                    </a:ext>
                  </a:extLst>
                </p:cNvPr>
                <p:cNvSpPr/>
                <p:nvPr/>
              </p:nvSpPr>
              <p:spPr>
                <a:xfrm>
                  <a:off x="3786416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7" name="Freeform: Shape 226">
                  <a:extLst>
                    <a:ext uri="{FF2B5EF4-FFF2-40B4-BE49-F238E27FC236}">
                      <a16:creationId xmlns:a16="http://schemas.microsoft.com/office/drawing/2014/main" id="{7F811BB4-73F0-786E-F06A-9DF5D764586D}"/>
                    </a:ext>
                  </a:extLst>
                </p:cNvPr>
                <p:cNvSpPr/>
                <p:nvPr/>
              </p:nvSpPr>
              <p:spPr>
                <a:xfrm>
                  <a:off x="3792565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8" name="Freeform: Shape 227">
                  <a:extLst>
                    <a:ext uri="{FF2B5EF4-FFF2-40B4-BE49-F238E27FC236}">
                      <a16:creationId xmlns:a16="http://schemas.microsoft.com/office/drawing/2014/main" id="{31B999F5-6E2B-EF9A-BC1A-7B3BC17E97F2}"/>
                    </a:ext>
                  </a:extLst>
                </p:cNvPr>
                <p:cNvSpPr/>
                <p:nvPr/>
              </p:nvSpPr>
              <p:spPr>
                <a:xfrm>
                  <a:off x="4720593" y="1671184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29" name="Freeform: Shape 228">
                  <a:extLst>
                    <a:ext uri="{FF2B5EF4-FFF2-40B4-BE49-F238E27FC236}">
                      <a16:creationId xmlns:a16="http://schemas.microsoft.com/office/drawing/2014/main" id="{0CF6D540-F006-EAC9-92F5-889041E2A51A}"/>
                    </a:ext>
                  </a:extLst>
                </p:cNvPr>
                <p:cNvSpPr/>
                <p:nvPr/>
              </p:nvSpPr>
              <p:spPr>
                <a:xfrm>
                  <a:off x="4379498" y="3491781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0" name="Freeform: Shape 229">
                  <a:extLst>
                    <a:ext uri="{FF2B5EF4-FFF2-40B4-BE49-F238E27FC236}">
                      <a16:creationId xmlns:a16="http://schemas.microsoft.com/office/drawing/2014/main" id="{1F45B7CF-944F-8DDD-66CA-CD93E2B36AA9}"/>
                    </a:ext>
                  </a:extLst>
                </p:cNvPr>
                <p:cNvSpPr/>
                <p:nvPr/>
              </p:nvSpPr>
              <p:spPr>
                <a:xfrm>
                  <a:off x="3792565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1" name="Freeform: Shape 230">
                  <a:extLst>
                    <a:ext uri="{FF2B5EF4-FFF2-40B4-BE49-F238E27FC236}">
                      <a16:creationId xmlns:a16="http://schemas.microsoft.com/office/drawing/2014/main" id="{B7E473AF-186A-1C0B-A240-54416CC98B48}"/>
                    </a:ext>
                  </a:extLst>
                </p:cNvPr>
                <p:cNvSpPr/>
                <p:nvPr/>
              </p:nvSpPr>
              <p:spPr>
                <a:xfrm>
                  <a:off x="4050691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2" name="Freeform: Shape 231">
                  <a:extLst>
                    <a:ext uri="{FF2B5EF4-FFF2-40B4-BE49-F238E27FC236}">
                      <a16:creationId xmlns:a16="http://schemas.microsoft.com/office/drawing/2014/main" id="{493BD05B-4205-4195-5ACC-B2AB54F91581}"/>
                    </a:ext>
                  </a:extLst>
                </p:cNvPr>
                <p:cNvSpPr/>
                <p:nvPr/>
              </p:nvSpPr>
              <p:spPr>
                <a:xfrm>
                  <a:off x="4050691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3" name="Freeform: Shape 232">
                  <a:extLst>
                    <a:ext uri="{FF2B5EF4-FFF2-40B4-BE49-F238E27FC236}">
                      <a16:creationId xmlns:a16="http://schemas.microsoft.com/office/drawing/2014/main" id="{1AB15842-485B-95EF-96D0-07421FA263CF}"/>
                    </a:ext>
                  </a:extLst>
                </p:cNvPr>
                <p:cNvSpPr/>
                <p:nvPr/>
              </p:nvSpPr>
              <p:spPr>
                <a:xfrm>
                  <a:off x="4050691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4" name="Freeform: Shape 233">
                  <a:extLst>
                    <a:ext uri="{FF2B5EF4-FFF2-40B4-BE49-F238E27FC236}">
                      <a16:creationId xmlns:a16="http://schemas.microsoft.com/office/drawing/2014/main" id="{9375D2A5-BFAF-ED87-887F-DFC9582B645B}"/>
                    </a:ext>
                  </a:extLst>
                </p:cNvPr>
                <p:cNvSpPr/>
                <p:nvPr/>
              </p:nvSpPr>
              <p:spPr>
                <a:xfrm>
                  <a:off x="4050691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5" name="Freeform: Shape 234">
                  <a:extLst>
                    <a:ext uri="{FF2B5EF4-FFF2-40B4-BE49-F238E27FC236}">
                      <a16:creationId xmlns:a16="http://schemas.microsoft.com/office/drawing/2014/main" id="{9B239324-511E-5244-1D56-6FEE265CAE08}"/>
                    </a:ext>
                  </a:extLst>
                </p:cNvPr>
                <p:cNvSpPr/>
                <p:nvPr/>
              </p:nvSpPr>
              <p:spPr>
                <a:xfrm>
                  <a:off x="422891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6" name="Freeform: Shape 235">
                  <a:extLst>
                    <a:ext uri="{FF2B5EF4-FFF2-40B4-BE49-F238E27FC236}">
                      <a16:creationId xmlns:a16="http://schemas.microsoft.com/office/drawing/2014/main" id="{552BC387-0CEC-D44F-558C-0AF7EACA2EFF}"/>
                    </a:ext>
                  </a:extLst>
                </p:cNvPr>
                <p:cNvSpPr/>
                <p:nvPr/>
              </p:nvSpPr>
              <p:spPr>
                <a:xfrm>
                  <a:off x="422891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7" name="Freeform: Shape 236">
                  <a:extLst>
                    <a:ext uri="{FF2B5EF4-FFF2-40B4-BE49-F238E27FC236}">
                      <a16:creationId xmlns:a16="http://schemas.microsoft.com/office/drawing/2014/main" id="{6F008963-D44B-198D-AF8C-D28FCCA9A572}"/>
                    </a:ext>
                  </a:extLst>
                </p:cNvPr>
                <p:cNvSpPr/>
                <p:nvPr/>
              </p:nvSpPr>
              <p:spPr>
                <a:xfrm>
                  <a:off x="422891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8" name="Freeform: Shape 237">
                  <a:extLst>
                    <a:ext uri="{FF2B5EF4-FFF2-40B4-BE49-F238E27FC236}">
                      <a16:creationId xmlns:a16="http://schemas.microsoft.com/office/drawing/2014/main" id="{8B64C541-80DD-30EC-F1D1-15B13BE92E0F}"/>
                    </a:ext>
                  </a:extLst>
                </p:cNvPr>
                <p:cNvSpPr/>
                <p:nvPr/>
              </p:nvSpPr>
              <p:spPr>
                <a:xfrm>
                  <a:off x="4228918" y="760885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0000FF"/>
                </a:solidFill>
                <a:ln w="12185" cap="flat">
                  <a:solidFill>
                    <a:srgbClr val="0000FF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39" name="Freeform: Shape 238">
                  <a:extLst>
                    <a:ext uri="{FF2B5EF4-FFF2-40B4-BE49-F238E27FC236}">
                      <a16:creationId xmlns:a16="http://schemas.microsoft.com/office/drawing/2014/main" id="{87CCA0EB-AAD6-BAE0-D381-0EC9DBD99B06}"/>
                    </a:ext>
                  </a:extLst>
                </p:cNvPr>
                <p:cNvSpPr/>
                <p:nvPr/>
              </p:nvSpPr>
              <p:spPr>
                <a:xfrm>
                  <a:off x="7977898" y="1974617"/>
                  <a:ext cx="60993" cy="60993"/>
                </a:xfrm>
                <a:custGeom>
                  <a:avLst/>
                  <a:gdLst>
                    <a:gd name="connsiteX0" fmla="*/ 11 w 60993"/>
                    <a:gd name="connsiteY0" fmla="*/ 11 h 60993"/>
                    <a:gd name="connsiteX1" fmla="*/ 61004 w 60993"/>
                    <a:gd name="connsiteY1" fmla="*/ 11 h 60993"/>
                    <a:gd name="connsiteX2" fmla="*/ 61004 w 60993"/>
                    <a:gd name="connsiteY2" fmla="*/ 61004 h 60993"/>
                    <a:gd name="connsiteX3" fmla="*/ 11 w 60993"/>
                    <a:gd name="connsiteY3" fmla="*/ 61004 h 6099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60993" h="60993">
                      <a:moveTo>
                        <a:pt x="11" y="11"/>
                      </a:moveTo>
                      <a:lnTo>
                        <a:pt x="61004" y="11"/>
                      </a:lnTo>
                      <a:lnTo>
                        <a:pt x="61004" y="61004"/>
                      </a:lnTo>
                      <a:lnTo>
                        <a:pt x="11" y="61004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4" name="Freeform: Shape 243">
                  <a:extLst>
                    <a:ext uri="{FF2B5EF4-FFF2-40B4-BE49-F238E27FC236}">
                      <a16:creationId xmlns:a16="http://schemas.microsoft.com/office/drawing/2014/main" id="{76D99FA2-B8CA-6810-7115-9523ED1E326A}"/>
                    </a:ext>
                  </a:extLst>
                </p:cNvPr>
                <p:cNvSpPr/>
                <p:nvPr/>
              </p:nvSpPr>
              <p:spPr>
                <a:xfrm>
                  <a:off x="5793134" y="1965771"/>
                  <a:ext cx="73192" cy="73192"/>
                </a:xfrm>
                <a:custGeom>
                  <a:avLst/>
                  <a:gdLst>
                    <a:gd name="connsiteX0" fmla="*/ 73203 w 73192"/>
                    <a:gd name="connsiteY0" fmla="*/ 36607 h 73192"/>
                    <a:gd name="connsiteX1" fmla="*/ 36607 w 73192"/>
                    <a:gd name="connsiteY1" fmla="*/ 73203 h 73192"/>
                    <a:gd name="connsiteX2" fmla="*/ 11 w 73192"/>
                    <a:gd name="connsiteY2" fmla="*/ 36607 h 73192"/>
                    <a:gd name="connsiteX3" fmla="*/ 36607 w 73192"/>
                    <a:gd name="connsiteY3" fmla="*/ 11 h 73192"/>
                    <a:gd name="connsiteX4" fmla="*/ 73203 w 73192"/>
                    <a:gd name="connsiteY4" fmla="*/ 36607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3192" h="73192">
                      <a:moveTo>
                        <a:pt x="73203" y="36607"/>
                      </a:moveTo>
                      <a:cubicBezTo>
                        <a:pt x="73203" y="56818"/>
                        <a:pt x="56819" y="73203"/>
                        <a:pt x="36607" y="73203"/>
                      </a:cubicBezTo>
                      <a:cubicBezTo>
                        <a:pt x="16396" y="73203"/>
                        <a:pt x="11" y="56818"/>
                        <a:pt x="11" y="36607"/>
                      </a:cubicBezTo>
                      <a:cubicBezTo>
                        <a:pt x="11" y="16396"/>
                        <a:pt x="16396" y="11"/>
                        <a:pt x="36607" y="11"/>
                      </a:cubicBezTo>
                      <a:cubicBezTo>
                        <a:pt x="56819" y="11"/>
                        <a:pt x="73203" y="16396"/>
                        <a:pt x="73203" y="3660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5" name="Freeform: Shape 244">
                  <a:extLst>
                    <a:ext uri="{FF2B5EF4-FFF2-40B4-BE49-F238E27FC236}">
                      <a16:creationId xmlns:a16="http://schemas.microsoft.com/office/drawing/2014/main" id="{291B0217-65CC-72C7-0D75-6213B4A53C10}"/>
                    </a:ext>
                  </a:extLst>
                </p:cNvPr>
                <p:cNvSpPr/>
                <p:nvPr/>
              </p:nvSpPr>
              <p:spPr>
                <a:xfrm>
                  <a:off x="5736380" y="1671183"/>
                  <a:ext cx="73192" cy="73192"/>
                </a:xfrm>
                <a:custGeom>
                  <a:avLst/>
                  <a:gdLst>
                    <a:gd name="connsiteX0" fmla="*/ 73203 w 73192"/>
                    <a:gd name="connsiteY0" fmla="*/ 36607 h 73192"/>
                    <a:gd name="connsiteX1" fmla="*/ 36607 w 73192"/>
                    <a:gd name="connsiteY1" fmla="*/ 73203 h 73192"/>
                    <a:gd name="connsiteX2" fmla="*/ 11 w 73192"/>
                    <a:gd name="connsiteY2" fmla="*/ 36607 h 73192"/>
                    <a:gd name="connsiteX3" fmla="*/ 36607 w 73192"/>
                    <a:gd name="connsiteY3" fmla="*/ 11 h 73192"/>
                    <a:gd name="connsiteX4" fmla="*/ 73203 w 73192"/>
                    <a:gd name="connsiteY4" fmla="*/ 36607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3192" h="73192">
                      <a:moveTo>
                        <a:pt x="73203" y="36607"/>
                      </a:moveTo>
                      <a:cubicBezTo>
                        <a:pt x="73203" y="56818"/>
                        <a:pt x="56819" y="73203"/>
                        <a:pt x="36607" y="73203"/>
                      </a:cubicBezTo>
                      <a:cubicBezTo>
                        <a:pt x="16396" y="73203"/>
                        <a:pt x="11" y="56818"/>
                        <a:pt x="11" y="36607"/>
                      </a:cubicBezTo>
                      <a:cubicBezTo>
                        <a:pt x="11" y="16396"/>
                        <a:pt x="16396" y="11"/>
                        <a:pt x="36607" y="11"/>
                      </a:cubicBezTo>
                      <a:cubicBezTo>
                        <a:pt x="56819" y="11"/>
                        <a:pt x="73203" y="16396"/>
                        <a:pt x="73203" y="3660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6" name="Freeform: Shape 245">
                  <a:extLst>
                    <a:ext uri="{FF2B5EF4-FFF2-40B4-BE49-F238E27FC236}">
                      <a16:creationId xmlns:a16="http://schemas.microsoft.com/office/drawing/2014/main" id="{E93CAD3A-04CD-C948-A9B1-6D8291AFFAFF}"/>
                    </a:ext>
                  </a:extLst>
                </p:cNvPr>
                <p:cNvSpPr/>
                <p:nvPr/>
              </p:nvSpPr>
              <p:spPr>
                <a:xfrm>
                  <a:off x="4618769" y="1367538"/>
                  <a:ext cx="73192" cy="73192"/>
                </a:xfrm>
                <a:custGeom>
                  <a:avLst/>
                  <a:gdLst>
                    <a:gd name="connsiteX0" fmla="*/ 73203 w 73192"/>
                    <a:gd name="connsiteY0" fmla="*/ 36607 h 73192"/>
                    <a:gd name="connsiteX1" fmla="*/ 36607 w 73192"/>
                    <a:gd name="connsiteY1" fmla="*/ 73203 h 73192"/>
                    <a:gd name="connsiteX2" fmla="*/ 11 w 73192"/>
                    <a:gd name="connsiteY2" fmla="*/ 36607 h 73192"/>
                    <a:gd name="connsiteX3" fmla="*/ 36607 w 73192"/>
                    <a:gd name="connsiteY3" fmla="*/ 11 h 73192"/>
                    <a:gd name="connsiteX4" fmla="*/ 73203 w 73192"/>
                    <a:gd name="connsiteY4" fmla="*/ 36607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3192" h="73192">
                      <a:moveTo>
                        <a:pt x="73203" y="36607"/>
                      </a:moveTo>
                      <a:cubicBezTo>
                        <a:pt x="73203" y="56818"/>
                        <a:pt x="56819" y="73203"/>
                        <a:pt x="36607" y="73203"/>
                      </a:cubicBezTo>
                      <a:cubicBezTo>
                        <a:pt x="16396" y="73203"/>
                        <a:pt x="11" y="56818"/>
                        <a:pt x="11" y="36607"/>
                      </a:cubicBezTo>
                      <a:cubicBezTo>
                        <a:pt x="11" y="16396"/>
                        <a:pt x="16396" y="11"/>
                        <a:pt x="36607" y="11"/>
                      </a:cubicBezTo>
                      <a:cubicBezTo>
                        <a:pt x="56819" y="11"/>
                        <a:pt x="73203" y="16396"/>
                        <a:pt x="73203" y="3660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7" name="Freeform: Shape 246">
                  <a:extLst>
                    <a:ext uri="{FF2B5EF4-FFF2-40B4-BE49-F238E27FC236}">
                      <a16:creationId xmlns:a16="http://schemas.microsoft.com/office/drawing/2014/main" id="{F8803DBE-532F-50DD-D7AA-A1B4AE753FA3}"/>
                    </a:ext>
                  </a:extLst>
                </p:cNvPr>
                <p:cNvSpPr/>
                <p:nvPr/>
              </p:nvSpPr>
              <p:spPr>
                <a:xfrm>
                  <a:off x="5599977" y="1046538"/>
                  <a:ext cx="73192" cy="73192"/>
                </a:xfrm>
                <a:custGeom>
                  <a:avLst/>
                  <a:gdLst>
                    <a:gd name="connsiteX0" fmla="*/ 73203 w 73192"/>
                    <a:gd name="connsiteY0" fmla="*/ 36607 h 73192"/>
                    <a:gd name="connsiteX1" fmla="*/ 36607 w 73192"/>
                    <a:gd name="connsiteY1" fmla="*/ 73203 h 73192"/>
                    <a:gd name="connsiteX2" fmla="*/ 11 w 73192"/>
                    <a:gd name="connsiteY2" fmla="*/ 36607 h 73192"/>
                    <a:gd name="connsiteX3" fmla="*/ 36607 w 73192"/>
                    <a:gd name="connsiteY3" fmla="*/ 11 h 73192"/>
                    <a:gd name="connsiteX4" fmla="*/ 73203 w 73192"/>
                    <a:gd name="connsiteY4" fmla="*/ 36607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3192" h="73192">
                      <a:moveTo>
                        <a:pt x="73203" y="36607"/>
                      </a:moveTo>
                      <a:cubicBezTo>
                        <a:pt x="73203" y="56818"/>
                        <a:pt x="56818" y="73203"/>
                        <a:pt x="36607" y="73203"/>
                      </a:cubicBezTo>
                      <a:cubicBezTo>
                        <a:pt x="16395" y="73203"/>
                        <a:pt x="11" y="56818"/>
                        <a:pt x="11" y="36607"/>
                      </a:cubicBezTo>
                      <a:cubicBezTo>
                        <a:pt x="11" y="16396"/>
                        <a:pt x="16395" y="11"/>
                        <a:pt x="36607" y="11"/>
                      </a:cubicBezTo>
                      <a:cubicBezTo>
                        <a:pt x="56818" y="11"/>
                        <a:pt x="73203" y="16396"/>
                        <a:pt x="73203" y="3660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8" name="Freeform: Shape 247">
                  <a:extLst>
                    <a:ext uri="{FF2B5EF4-FFF2-40B4-BE49-F238E27FC236}">
                      <a16:creationId xmlns:a16="http://schemas.microsoft.com/office/drawing/2014/main" id="{320D1394-514B-8650-0DB6-20E2807432DC}"/>
                    </a:ext>
                  </a:extLst>
                </p:cNvPr>
                <p:cNvSpPr/>
                <p:nvPr/>
              </p:nvSpPr>
              <p:spPr>
                <a:xfrm>
                  <a:off x="5190012" y="760885"/>
                  <a:ext cx="73192" cy="73192"/>
                </a:xfrm>
                <a:custGeom>
                  <a:avLst/>
                  <a:gdLst>
                    <a:gd name="connsiteX0" fmla="*/ 73203 w 73192"/>
                    <a:gd name="connsiteY0" fmla="*/ 36607 h 73192"/>
                    <a:gd name="connsiteX1" fmla="*/ 36607 w 73192"/>
                    <a:gd name="connsiteY1" fmla="*/ 73203 h 73192"/>
                    <a:gd name="connsiteX2" fmla="*/ 11 w 73192"/>
                    <a:gd name="connsiteY2" fmla="*/ 36607 h 73192"/>
                    <a:gd name="connsiteX3" fmla="*/ 36607 w 73192"/>
                    <a:gd name="connsiteY3" fmla="*/ 11 h 73192"/>
                    <a:gd name="connsiteX4" fmla="*/ 73203 w 73192"/>
                    <a:gd name="connsiteY4" fmla="*/ 36607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73192" h="73192">
                      <a:moveTo>
                        <a:pt x="73203" y="36607"/>
                      </a:moveTo>
                      <a:cubicBezTo>
                        <a:pt x="73203" y="56818"/>
                        <a:pt x="56819" y="73203"/>
                        <a:pt x="36607" y="73203"/>
                      </a:cubicBezTo>
                      <a:cubicBezTo>
                        <a:pt x="16396" y="73203"/>
                        <a:pt x="11" y="56818"/>
                        <a:pt x="11" y="36607"/>
                      </a:cubicBezTo>
                      <a:cubicBezTo>
                        <a:pt x="11" y="16396"/>
                        <a:pt x="16396" y="11"/>
                        <a:pt x="36607" y="11"/>
                      </a:cubicBezTo>
                      <a:cubicBezTo>
                        <a:pt x="56819" y="11"/>
                        <a:pt x="73203" y="16396"/>
                        <a:pt x="73203" y="36607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49" name="Freeform: Shape 248">
                  <a:extLst>
                    <a:ext uri="{FF2B5EF4-FFF2-40B4-BE49-F238E27FC236}">
                      <a16:creationId xmlns:a16="http://schemas.microsoft.com/office/drawing/2014/main" id="{74D94254-8E6E-6A02-7A18-CCE39955DC2C}"/>
                    </a:ext>
                  </a:extLst>
                </p:cNvPr>
                <p:cNvSpPr/>
                <p:nvPr/>
              </p:nvSpPr>
              <p:spPr>
                <a:xfrm>
                  <a:off x="4594690" y="1950220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0" name="Freeform: Shape 249">
                  <a:extLst>
                    <a:ext uri="{FF2B5EF4-FFF2-40B4-BE49-F238E27FC236}">
                      <a16:creationId xmlns:a16="http://schemas.microsoft.com/office/drawing/2014/main" id="{FE9DDF90-CE62-D2DD-815A-BAC6DA4B764F}"/>
                    </a:ext>
                  </a:extLst>
                </p:cNvPr>
                <p:cNvSpPr/>
                <p:nvPr/>
              </p:nvSpPr>
              <p:spPr>
                <a:xfrm>
                  <a:off x="4594690" y="1950220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2" name="Freeform: Shape 251">
                  <a:extLst>
                    <a:ext uri="{FF2B5EF4-FFF2-40B4-BE49-F238E27FC236}">
                      <a16:creationId xmlns:a16="http://schemas.microsoft.com/office/drawing/2014/main" id="{811AA6CB-9F87-0E51-DC7E-34AB5168B985}"/>
                    </a:ext>
                  </a:extLst>
                </p:cNvPr>
                <p:cNvSpPr/>
                <p:nvPr/>
              </p:nvSpPr>
              <p:spPr>
                <a:xfrm>
                  <a:off x="4723753" y="1646787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4" name="Freeform: Shape 253">
                  <a:extLst>
                    <a:ext uri="{FF2B5EF4-FFF2-40B4-BE49-F238E27FC236}">
                      <a16:creationId xmlns:a16="http://schemas.microsoft.com/office/drawing/2014/main" id="{4CD35D9C-3526-5454-DB8E-A2AB81F0F0C5}"/>
                    </a:ext>
                  </a:extLst>
                </p:cNvPr>
                <p:cNvSpPr/>
                <p:nvPr/>
              </p:nvSpPr>
              <p:spPr>
                <a:xfrm>
                  <a:off x="4469198" y="4074249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5" name="Freeform: Shape 254">
                  <a:extLst>
                    <a:ext uri="{FF2B5EF4-FFF2-40B4-BE49-F238E27FC236}">
                      <a16:creationId xmlns:a16="http://schemas.microsoft.com/office/drawing/2014/main" id="{54BB3BDD-8CB0-C0E4-176B-D7452767F72D}"/>
                    </a:ext>
                  </a:extLst>
                </p:cNvPr>
                <p:cNvSpPr/>
                <p:nvPr/>
              </p:nvSpPr>
              <p:spPr>
                <a:xfrm>
                  <a:off x="4576252" y="134335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6" name="Freeform: Shape 255">
                  <a:extLst>
                    <a:ext uri="{FF2B5EF4-FFF2-40B4-BE49-F238E27FC236}">
                      <a16:creationId xmlns:a16="http://schemas.microsoft.com/office/drawing/2014/main" id="{EFA09B63-0527-C6E3-CEDE-5AD725B8DBDB}"/>
                    </a:ext>
                  </a:extLst>
                </p:cNvPr>
                <p:cNvSpPr/>
                <p:nvPr/>
              </p:nvSpPr>
              <p:spPr>
                <a:xfrm>
                  <a:off x="4576252" y="134335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7" name="Freeform: Shape 256">
                  <a:extLst>
                    <a:ext uri="{FF2B5EF4-FFF2-40B4-BE49-F238E27FC236}">
                      <a16:creationId xmlns:a16="http://schemas.microsoft.com/office/drawing/2014/main" id="{75002A48-C68A-56DC-8A0E-D39F5F6EEAF0}"/>
                    </a:ext>
                  </a:extLst>
                </p:cNvPr>
                <p:cNvSpPr/>
                <p:nvPr/>
              </p:nvSpPr>
              <p:spPr>
                <a:xfrm>
                  <a:off x="4388807" y="1039921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8" name="Freeform: Shape 257">
                  <a:extLst>
                    <a:ext uri="{FF2B5EF4-FFF2-40B4-BE49-F238E27FC236}">
                      <a16:creationId xmlns:a16="http://schemas.microsoft.com/office/drawing/2014/main" id="{7CFD9AD7-EC5C-0B6D-2326-F69D99EB4D36}"/>
                    </a:ext>
                  </a:extLst>
                </p:cNvPr>
                <p:cNvSpPr/>
                <p:nvPr/>
              </p:nvSpPr>
              <p:spPr>
                <a:xfrm>
                  <a:off x="4388807" y="1039921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59" name="Freeform: Shape 258">
                  <a:extLst>
                    <a:ext uri="{FF2B5EF4-FFF2-40B4-BE49-F238E27FC236}">
                      <a16:creationId xmlns:a16="http://schemas.microsoft.com/office/drawing/2014/main" id="{A9599499-BC32-EAFA-F215-23F3A0666F9C}"/>
                    </a:ext>
                  </a:extLst>
                </p:cNvPr>
                <p:cNvSpPr/>
                <p:nvPr/>
              </p:nvSpPr>
              <p:spPr>
                <a:xfrm>
                  <a:off x="4256674" y="346738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0" name="Freeform: Shape 259">
                  <a:extLst>
                    <a:ext uri="{FF2B5EF4-FFF2-40B4-BE49-F238E27FC236}">
                      <a16:creationId xmlns:a16="http://schemas.microsoft.com/office/drawing/2014/main" id="{5867480B-9A96-C618-DB8E-F9C7E024E037}"/>
                    </a:ext>
                  </a:extLst>
                </p:cNvPr>
                <p:cNvSpPr/>
                <p:nvPr/>
              </p:nvSpPr>
              <p:spPr>
                <a:xfrm>
                  <a:off x="4256674" y="346738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1" name="Freeform: Shape 260">
                  <a:extLst>
                    <a:ext uri="{FF2B5EF4-FFF2-40B4-BE49-F238E27FC236}">
                      <a16:creationId xmlns:a16="http://schemas.microsoft.com/office/drawing/2014/main" id="{19EDCF04-CCC5-071F-703D-DA07705BA8CD}"/>
                    </a:ext>
                  </a:extLst>
                </p:cNvPr>
                <p:cNvSpPr/>
                <p:nvPr/>
              </p:nvSpPr>
              <p:spPr>
                <a:xfrm>
                  <a:off x="4250525" y="3163951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2" name="Freeform: Shape 261">
                  <a:extLst>
                    <a:ext uri="{FF2B5EF4-FFF2-40B4-BE49-F238E27FC236}">
                      <a16:creationId xmlns:a16="http://schemas.microsoft.com/office/drawing/2014/main" id="{EDA66E7F-4FA1-C663-5F46-C43279014425}"/>
                    </a:ext>
                  </a:extLst>
                </p:cNvPr>
                <p:cNvSpPr/>
                <p:nvPr/>
              </p:nvSpPr>
              <p:spPr>
                <a:xfrm>
                  <a:off x="4250525" y="3163951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3" name="Freeform: Shape 262">
                  <a:extLst>
                    <a:ext uri="{FF2B5EF4-FFF2-40B4-BE49-F238E27FC236}">
                      <a16:creationId xmlns:a16="http://schemas.microsoft.com/office/drawing/2014/main" id="{993CB11F-DF21-74E3-5DD3-8B477FAE132E}"/>
                    </a:ext>
                  </a:extLst>
                </p:cNvPr>
                <p:cNvSpPr/>
                <p:nvPr/>
              </p:nvSpPr>
              <p:spPr>
                <a:xfrm>
                  <a:off x="4032343" y="736488"/>
                  <a:ext cx="97589" cy="109787"/>
                </a:xfrm>
                <a:custGeom>
                  <a:avLst/>
                  <a:gdLst>
                    <a:gd name="connsiteX0" fmla="*/ 48806 w 97589"/>
                    <a:gd name="connsiteY0" fmla="*/ 11 h 109787"/>
                    <a:gd name="connsiteX1" fmla="*/ 61004 w 97589"/>
                    <a:gd name="connsiteY1" fmla="*/ 36607 h 109787"/>
                    <a:gd name="connsiteX2" fmla="*/ 97600 w 97589"/>
                    <a:gd name="connsiteY2" fmla="*/ 36607 h 109787"/>
                    <a:gd name="connsiteX3" fmla="*/ 73203 w 97589"/>
                    <a:gd name="connsiteY3" fmla="*/ 61004 h 109787"/>
                    <a:gd name="connsiteX4" fmla="*/ 85402 w 97589"/>
                    <a:gd name="connsiteY4" fmla="*/ 109799 h 109787"/>
                    <a:gd name="connsiteX5" fmla="*/ 48806 w 97589"/>
                    <a:gd name="connsiteY5" fmla="*/ 73203 h 109787"/>
                    <a:gd name="connsiteX6" fmla="*/ 12210 w 97589"/>
                    <a:gd name="connsiteY6" fmla="*/ 109799 h 109787"/>
                    <a:gd name="connsiteX7" fmla="*/ 24408 w 97589"/>
                    <a:gd name="connsiteY7" fmla="*/ 61004 h 109787"/>
                    <a:gd name="connsiteX8" fmla="*/ 11 w 97589"/>
                    <a:gd name="connsiteY8" fmla="*/ 36607 h 109787"/>
                    <a:gd name="connsiteX9" fmla="*/ 36607 w 97589"/>
                    <a:gd name="connsiteY9" fmla="*/ 36607 h 1097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7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4" name="Freeform: Shape 263">
                  <a:extLst>
                    <a:ext uri="{FF2B5EF4-FFF2-40B4-BE49-F238E27FC236}">
                      <a16:creationId xmlns:a16="http://schemas.microsoft.com/office/drawing/2014/main" id="{A90B2CF0-D378-7020-1CBF-4A6DF19681B6}"/>
                    </a:ext>
                  </a:extLst>
                </p:cNvPr>
                <p:cNvSpPr/>
                <p:nvPr/>
              </p:nvSpPr>
              <p:spPr>
                <a:xfrm>
                  <a:off x="4032343" y="736488"/>
                  <a:ext cx="97589" cy="109787"/>
                </a:xfrm>
                <a:custGeom>
                  <a:avLst/>
                  <a:gdLst>
                    <a:gd name="connsiteX0" fmla="*/ 48806 w 97589"/>
                    <a:gd name="connsiteY0" fmla="*/ 11 h 109787"/>
                    <a:gd name="connsiteX1" fmla="*/ 61004 w 97589"/>
                    <a:gd name="connsiteY1" fmla="*/ 36607 h 109787"/>
                    <a:gd name="connsiteX2" fmla="*/ 97600 w 97589"/>
                    <a:gd name="connsiteY2" fmla="*/ 36607 h 109787"/>
                    <a:gd name="connsiteX3" fmla="*/ 73203 w 97589"/>
                    <a:gd name="connsiteY3" fmla="*/ 61004 h 109787"/>
                    <a:gd name="connsiteX4" fmla="*/ 85402 w 97589"/>
                    <a:gd name="connsiteY4" fmla="*/ 109799 h 109787"/>
                    <a:gd name="connsiteX5" fmla="*/ 48806 w 97589"/>
                    <a:gd name="connsiteY5" fmla="*/ 73203 h 109787"/>
                    <a:gd name="connsiteX6" fmla="*/ 12210 w 97589"/>
                    <a:gd name="connsiteY6" fmla="*/ 109799 h 109787"/>
                    <a:gd name="connsiteX7" fmla="*/ 24408 w 97589"/>
                    <a:gd name="connsiteY7" fmla="*/ 61004 h 109787"/>
                    <a:gd name="connsiteX8" fmla="*/ 11 w 97589"/>
                    <a:gd name="connsiteY8" fmla="*/ 36607 h 109787"/>
                    <a:gd name="connsiteX9" fmla="*/ 36607 w 97589"/>
                    <a:gd name="connsiteY9" fmla="*/ 36607 h 1097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7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5" name="Freeform: Shape 264">
                  <a:extLst>
                    <a:ext uri="{FF2B5EF4-FFF2-40B4-BE49-F238E27FC236}">
                      <a16:creationId xmlns:a16="http://schemas.microsoft.com/office/drawing/2014/main" id="{F7CB367F-EA12-4973-7163-70FEB968F726}"/>
                    </a:ext>
                  </a:extLst>
                </p:cNvPr>
                <p:cNvSpPr/>
                <p:nvPr/>
              </p:nvSpPr>
              <p:spPr>
                <a:xfrm>
                  <a:off x="1524741" y="4098647"/>
                  <a:ext cx="73192" cy="73192"/>
                </a:xfrm>
                <a:custGeom>
                  <a:avLst/>
                  <a:gdLst>
                    <a:gd name="connsiteX0" fmla="*/ 36607 w 73192"/>
                    <a:gd name="connsiteY0" fmla="*/ 11 h 73192"/>
                    <a:gd name="connsiteX1" fmla="*/ 11 w 73192"/>
                    <a:gd name="connsiteY1" fmla="*/ 73203 h 73192"/>
                    <a:gd name="connsiteX2" fmla="*/ 73203 w 73192"/>
                    <a:gd name="connsiteY2" fmla="*/ 73203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73192" h="73192">
                      <a:moveTo>
                        <a:pt x="36607" y="11"/>
                      </a:moveTo>
                      <a:lnTo>
                        <a:pt x="11" y="73203"/>
                      </a:lnTo>
                      <a:lnTo>
                        <a:pt x="73203" y="7320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6" name="Freeform: Shape 265">
                  <a:extLst>
                    <a:ext uri="{FF2B5EF4-FFF2-40B4-BE49-F238E27FC236}">
                      <a16:creationId xmlns:a16="http://schemas.microsoft.com/office/drawing/2014/main" id="{EBE1F89F-40CE-8EBD-ADDD-53C55BBA90B5}"/>
                    </a:ext>
                  </a:extLst>
                </p:cNvPr>
                <p:cNvSpPr/>
                <p:nvPr/>
              </p:nvSpPr>
              <p:spPr>
                <a:xfrm>
                  <a:off x="1524741" y="1367751"/>
                  <a:ext cx="73192" cy="73192"/>
                </a:xfrm>
                <a:custGeom>
                  <a:avLst/>
                  <a:gdLst>
                    <a:gd name="connsiteX0" fmla="*/ 36607 w 73192"/>
                    <a:gd name="connsiteY0" fmla="*/ 11 h 73192"/>
                    <a:gd name="connsiteX1" fmla="*/ 11 w 73192"/>
                    <a:gd name="connsiteY1" fmla="*/ 73203 h 73192"/>
                    <a:gd name="connsiteX2" fmla="*/ 73203 w 73192"/>
                    <a:gd name="connsiteY2" fmla="*/ 73203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73192" h="73192">
                      <a:moveTo>
                        <a:pt x="36607" y="11"/>
                      </a:moveTo>
                      <a:lnTo>
                        <a:pt x="11" y="73203"/>
                      </a:lnTo>
                      <a:lnTo>
                        <a:pt x="73203" y="7320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7" name="Freeform: Shape 266">
                  <a:extLst>
                    <a:ext uri="{FF2B5EF4-FFF2-40B4-BE49-F238E27FC236}">
                      <a16:creationId xmlns:a16="http://schemas.microsoft.com/office/drawing/2014/main" id="{C4D3F7EA-3E88-EE8A-5534-5A7DEFA8D0A3}"/>
                    </a:ext>
                  </a:extLst>
                </p:cNvPr>
                <p:cNvSpPr/>
                <p:nvPr/>
              </p:nvSpPr>
              <p:spPr>
                <a:xfrm>
                  <a:off x="1524741" y="2278050"/>
                  <a:ext cx="73192" cy="73192"/>
                </a:xfrm>
                <a:custGeom>
                  <a:avLst/>
                  <a:gdLst>
                    <a:gd name="connsiteX0" fmla="*/ 36607 w 73192"/>
                    <a:gd name="connsiteY0" fmla="*/ 11 h 73192"/>
                    <a:gd name="connsiteX1" fmla="*/ 11 w 73192"/>
                    <a:gd name="connsiteY1" fmla="*/ 73203 h 73192"/>
                    <a:gd name="connsiteX2" fmla="*/ 73203 w 73192"/>
                    <a:gd name="connsiteY2" fmla="*/ 73203 h 731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73192" h="73192">
                      <a:moveTo>
                        <a:pt x="36607" y="11"/>
                      </a:moveTo>
                      <a:lnTo>
                        <a:pt x="11" y="73203"/>
                      </a:lnTo>
                      <a:lnTo>
                        <a:pt x="73203" y="73203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8" name="Freeform: Shape 267">
                  <a:extLst>
                    <a:ext uri="{FF2B5EF4-FFF2-40B4-BE49-F238E27FC236}">
                      <a16:creationId xmlns:a16="http://schemas.microsoft.com/office/drawing/2014/main" id="{D121BB92-2930-423B-E950-152109FB557F}"/>
                    </a:ext>
                  </a:extLst>
                </p:cNvPr>
                <p:cNvSpPr/>
                <p:nvPr/>
              </p:nvSpPr>
              <p:spPr>
                <a:xfrm>
                  <a:off x="7965700" y="1950220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69" name="Freeform: Shape 268">
                  <a:extLst>
                    <a:ext uri="{FF2B5EF4-FFF2-40B4-BE49-F238E27FC236}">
                      <a16:creationId xmlns:a16="http://schemas.microsoft.com/office/drawing/2014/main" id="{C6EEE267-12F7-8E43-9243-D2B2BAA4C8F8}"/>
                    </a:ext>
                  </a:extLst>
                </p:cNvPr>
                <p:cNvSpPr/>
                <p:nvPr/>
              </p:nvSpPr>
              <p:spPr>
                <a:xfrm>
                  <a:off x="7965700" y="1950220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0" name="Freeform: Shape 269">
                  <a:extLst>
                    <a:ext uri="{FF2B5EF4-FFF2-40B4-BE49-F238E27FC236}">
                      <a16:creationId xmlns:a16="http://schemas.microsoft.com/office/drawing/2014/main" id="{94A81D4A-D118-41C5-DE7C-D79BB0A4764A}"/>
                    </a:ext>
                  </a:extLst>
                </p:cNvPr>
                <p:cNvSpPr/>
                <p:nvPr/>
              </p:nvSpPr>
              <p:spPr>
                <a:xfrm>
                  <a:off x="7965700" y="1646787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1" name="Freeform: Shape 270">
                  <a:extLst>
                    <a:ext uri="{FF2B5EF4-FFF2-40B4-BE49-F238E27FC236}">
                      <a16:creationId xmlns:a16="http://schemas.microsoft.com/office/drawing/2014/main" id="{6531C980-CB68-D72E-5EB2-86E49C6C5D05}"/>
                    </a:ext>
                  </a:extLst>
                </p:cNvPr>
                <p:cNvSpPr/>
                <p:nvPr/>
              </p:nvSpPr>
              <p:spPr>
                <a:xfrm>
                  <a:off x="7965700" y="1646787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2" name="Freeform: Shape 271">
                  <a:extLst>
                    <a:ext uri="{FF2B5EF4-FFF2-40B4-BE49-F238E27FC236}">
                      <a16:creationId xmlns:a16="http://schemas.microsoft.com/office/drawing/2014/main" id="{C84E2DE2-E47E-5195-DC04-87A25CE7A12D}"/>
                    </a:ext>
                  </a:extLst>
                </p:cNvPr>
                <p:cNvSpPr/>
                <p:nvPr/>
              </p:nvSpPr>
              <p:spPr>
                <a:xfrm>
                  <a:off x="5579401" y="134264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3" name="Freeform: Shape 272">
                  <a:extLst>
                    <a:ext uri="{FF2B5EF4-FFF2-40B4-BE49-F238E27FC236}">
                      <a16:creationId xmlns:a16="http://schemas.microsoft.com/office/drawing/2014/main" id="{36E593D8-E7B6-41F5-2A48-C877A57E0392}"/>
                    </a:ext>
                  </a:extLst>
                </p:cNvPr>
                <p:cNvSpPr/>
                <p:nvPr/>
              </p:nvSpPr>
              <p:spPr>
                <a:xfrm>
                  <a:off x="5580771" y="1339124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4" name="Freeform: Shape 273">
                  <a:extLst>
                    <a:ext uri="{FF2B5EF4-FFF2-40B4-BE49-F238E27FC236}">
                      <a16:creationId xmlns:a16="http://schemas.microsoft.com/office/drawing/2014/main" id="{6D97CCC7-CC69-2D21-83BB-5A2078E3C722}"/>
                    </a:ext>
                  </a:extLst>
                </p:cNvPr>
                <p:cNvSpPr/>
                <p:nvPr/>
              </p:nvSpPr>
              <p:spPr>
                <a:xfrm>
                  <a:off x="7689136" y="1025635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5" name="Freeform: Shape 274">
                  <a:extLst>
                    <a:ext uri="{FF2B5EF4-FFF2-40B4-BE49-F238E27FC236}">
                      <a16:creationId xmlns:a16="http://schemas.microsoft.com/office/drawing/2014/main" id="{5A312CAC-D8F5-3A3C-3CF9-4F9631EBA26B}"/>
                    </a:ext>
                  </a:extLst>
                </p:cNvPr>
                <p:cNvSpPr/>
                <p:nvPr/>
              </p:nvSpPr>
              <p:spPr>
                <a:xfrm>
                  <a:off x="7689136" y="1020873"/>
                  <a:ext cx="97589" cy="109788"/>
                </a:xfrm>
                <a:custGeom>
                  <a:avLst/>
                  <a:gdLst>
                    <a:gd name="connsiteX0" fmla="*/ 48806 w 97589"/>
                    <a:gd name="connsiteY0" fmla="*/ 11 h 109788"/>
                    <a:gd name="connsiteX1" fmla="*/ 61004 w 97589"/>
                    <a:gd name="connsiteY1" fmla="*/ 36607 h 109788"/>
                    <a:gd name="connsiteX2" fmla="*/ 97600 w 97589"/>
                    <a:gd name="connsiteY2" fmla="*/ 36607 h 109788"/>
                    <a:gd name="connsiteX3" fmla="*/ 73203 w 97589"/>
                    <a:gd name="connsiteY3" fmla="*/ 61004 h 109788"/>
                    <a:gd name="connsiteX4" fmla="*/ 85402 w 97589"/>
                    <a:gd name="connsiteY4" fmla="*/ 109799 h 109788"/>
                    <a:gd name="connsiteX5" fmla="*/ 48806 w 97589"/>
                    <a:gd name="connsiteY5" fmla="*/ 73203 h 109788"/>
                    <a:gd name="connsiteX6" fmla="*/ 12210 w 97589"/>
                    <a:gd name="connsiteY6" fmla="*/ 109799 h 109788"/>
                    <a:gd name="connsiteX7" fmla="*/ 24408 w 97589"/>
                    <a:gd name="connsiteY7" fmla="*/ 61004 h 109788"/>
                    <a:gd name="connsiteX8" fmla="*/ 11 w 97589"/>
                    <a:gd name="connsiteY8" fmla="*/ 36607 h 109788"/>
                    <a:gd name="connsiteX9" fmla="*/ 36607 w 97589"/>
                    <a:gd name="connsiteY9" fmla="*/ 36607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6" name="Freeform: Shape 275">
                  <a:extLst>
                    <a:ext uri="{FF2B5EF4-FFF2-40B4-BE49-F238E27FC236}">
                      <a16:creationId xmlns:a16="http://schemas.microsoft.com/office/drawing/2014/main" id="{A08B6404-014C-466C-7E14-319DD79CD894}"/>
                    </a:ext>
                  </a:extLst>
                </p:cNvPr>
                <p:cNvSpPr/>
                <p:nvPr/>
              </p:nvSpPr>
              <p:spPr>
                <a:xfrm>
                  <a:off x="7320384" y="712678"/>
                  <a:ext cx="97589" cy="109787"/>
                </a:xfrm>
                <a:custGeom>
                  <a:avLst/>
                  <a:gdLst>
                    <a:gd name="connsiteX0" fmla="*/ 48806 w 97589"/>
                    <a:gd name="connsiteY0" fmla="*/ 11 h 109787"/>
                    <a:gd name="connsiteX1" fmla="*/ 61004 w 97589"/>
                    <a:gd name="connsiteY1" fmla="*/ 36607 h 109787"/>
                    <a:gd name="connsiteX2" fmla="*/ 97600 w 97589"/>
                    <a:gd name="connsiteY2" fmla="*/ 36607 h 109787"/>
                    <a:gd name="connsiteX3" fmla="*/ 73203 w 97589"/>
                    <a:gd name="connsiteY3" fmla="*/ 61004 h 109787"/>
                    <a:gd name="connsiteX4" fmla="*/ 85402 w 97589"/>
                    <a:gd name="connsiteY4" fmla="*/ 109799 h 109787"/>
                    <a:gd name="connsiteX5" fmla="*/ 48806 w 97589"/>
                    <a:gd name="connsiteY5" fmla="*/ 73203 h 109787"/>
                    <a:gd name="connsiteX6" fmla="*/ 12210 w 97589"/>
                    <a:gd name="connsiteY6" fmla="*/ 109799 h 109787"/>
                    <a:gd name="connsiteX7" fmla="*/ 24408 w 97589"/>
                    <a:gd name="connsiteY7" fmla="*/ 61004 h 109787"/>
                    <a:gd name="connsiteX8" fmla="*/ 11 w 97589"/>
                    <a:gd name="connsiteY8" fmla="*/ 36607 h 109787"/>
                    <a:gd name="connsiteX9" fmla="*/ 36607 w 97589"/>
                    <a:gd name="connsiteY9" fmla="*/ 36607 h 1097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7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77" name="Freeform: Shape 276">
                  <a:extLst>
                    <a:ext uri="{FF2B5EF4-FFF2-40B4-BE49-F238E27FC236}">
                      <a16:creationId xmlns:a16="http://schemas.microsoft.com/office/drawing/2014/main" id="{BBD19F4C-4CC6-93BD-3659-F04DA21487AE}"/>
                    </a:ext>
                  </a:extLst>
                </p:cNvPr>
                <p:cNvSpPr/>
                <p:nvPr/>
              </p:nvSpPr>
              <p:spPr>
                <a:xfrm>
                  <a:off x="7320384" y="712677"/>
                  <a:ext cx="97589" cy="109787"/>
                </a:xfrm>
                <a:custGeom>
                  <a:avLst/>
                  <a:gdLst>
                    <a:gd name="connsiteX0" fmla="*/ 48806 w 97589"/>
                    <a:gd name="connsiteY0" fmla="*/ 11 h 109787"/>
                    <a:gd name="connsiteX1" fmla="*/ 61004 w 97589"/>
                    <a:gd name="connsiteY1" fmla="*/ 36607 h 109787"/>
                    <a:gd name="connsiteX2" fmla="*/ 97600 w 97589"/>
                    <a:gd name="connsiteY2" fmla="*/ 36607 h 109787"/>
                    <a:gd name="connsiteX3" fmla="*/ 73203 w 97589"/>
                    <a:gd name="connsiteY3" fmla="*/ 61004 h 109787"/>
                    <a:gd name="connsiteX4" fmla="*/ 85402 w 97589"/>
                    <a:gd name="connsiteY4" fmla="*/ 109799 h 109787"/>
                    <a:gd name="connsiteX5" fmla="*/ 48806 w 97589"/>
                    <a:gd name="connsiteY5" fmla="*/ 73203 h 109787"/>
                    <a:gd name="connsiteX6" fmla="*/ 12210 w 97589"/>
                    <a:gd name="connsiteY6" fmla="*/ 109799 h 109787"/>
                    <a:gd name="connsiteX7" fmla="*/ 24408 w 97589"/>
                    <a:gd name="connsiteY7" fmla="*/ 61004 h 109787"/>
                    <a:gd name="connsiteX8" fmla="*/ 11 w 97589"/>
                    <a:gd name="connsiteY8" fmla="*/ 36607 h 109787"/>
                    <a:gd name="connsiteX9" fmla="*/ 36607 w 97589"/>
                    <a:gd name="connsiteY9" fmla="*/ 36607 h 10978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7">
                      <a:moveTo>
                        <a:pt x="48806" y="11"/>
                      </a:moveTo>
                      <a:lnTo>
                        <a:pt x="61004" y="36607"/>
                      </a:lnTo>
                      <a:lnTo>
                        <a:pt x="97600" y="36607"/>
                      </a:lnTo>
                      <a:lnTo>
                        <a:pt x="73203" y="61004"/>
                      </a:lnTo>
                      <a:lnTo>
                        <a:pt x="85402" y="109799"/>
                      </a:lnTo>
                      <a:lnTo>
                        <a:pt x="48806" y="73203"/>
                      </a:lnTo>
                      <a:lnTo>
                        <a:pt x="12210" y="109799"/>
                      </a:lnTo>
                      <a:lnTo>
                        <a:pt x="24408" y="61004"/>
                      </a:lnTo>
                      <a:lnTo>
                        <a:pt x="11" y="36607"/>
                      </a:lnTo>
                      <a:lnTo>
                        <a:pt x="36607" y="36607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grpSp>
            <p:nvGrpSpPr>
              <p:cNvPr id="278" name="Graphic 4">
                <a:extLst>
                  <a:ext uri="{FF2B5EF4-FFF2-40B4-BE49-F238E27FC236}">
                    <a16:creationId xmlns:a16="http://schemas.microsoft.com/office/drawing/2014/main" id="{10663DBD-F98F-C861-CB56-10B5D70329A6}"/>
                  </a:ext>
                </a:extLst>
              </p:cNvPr>
              <p:cNvGrpSpPr/>
              <p:nvPr/>
            </p:nvGrpSpPr>
            <p:grpSpPr>
              <a:xfrm>
                <a:off x="1314363" y="566212"/>
                <a:ext cx="7515951" cy="5216233"/>
                <a:chOff x="1314363" y="566212"/>
                <a:chExt cx="7515951" cy="5216233"/>
              </a:xfrm>
            </p:grpSpPr>
            <p:sp>
              <p:nvSpPr>
                <p:cNvPr id="279" name="Freeform: Shape 278">
                  <a:extLst>
                    <a:ext uri="{FF2B5EF4-FFF2-40B4-BE49-F238E27FC236}">
                      <a16:creationId xmlns:a16="http://schemas.microsoft.com/office/drawing/2014/main" id="{A1A5A28D-9697-B840-8CA2-1CCB88BC5A67}"/>
                    </a:ext>
                  </a:extLst>
                </p:cNvPr>
                <p:cNvSpPr/>
                <p:nvPr/>
              </p:nvSpPr>
              <p:spPr>
                <a:xfrm>
                  <a:off x="1498581" y="5276811"/>
                  <a:ext cx="7331733" cy="12198"/>
                </a:xfrm>
                <a:custGeom>
                  <a:avLst/>
                  <a:gdLst>
                    <a:gd name="connsiteX0" fmla="*/ 11 w 7331733"/>
                    <a:gd name="connsiteY0" fmla="*/ 11 h 12198"/>
                    <a:gd name="connsiteX1" fmla="*/ 7331745 w 7331733"/>
                    <a:gd name="connsiteY1" fmla="*/ 11 h 121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331733" h="12198">
                      <a:moveTo>
                        <a:pt x="11" y="11"/>
                      </a:moveTo>
                      <a:lnTo>
                        <a:pt x="7331745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0" name="Freeform: Shape 279">
                  <a:extLst>
                    <a:ext uri="{FF2B5EF4-FFF2-40B4-BE49-F238E27FC236}">
                      <a16:creationId xmlns:a16="http://schemas.microsoft.com/office/drawing/2014/main" id="{7514ED12-A41C-B449-D5CC-E6934E6C0A40}"/>
                    </a:ext>
                  </a:extLst>
                </p:cNvPr>
                <p:cNvSpPr/>
                <p:nvPr/>
              </p:nvSpPr>
              <p:spPr>
                <a:xfrm>
                  <a:off x="8830315" y="566212"/>
                  <a:ext cx="12198" cy="4710599"/>
                </a:xfrm>
                <a:custGeom>
                  <a:avLst/>
                  <a:gdLst>
                    <a:gd name="connsiteX0" fmla="*/ 11 w 12198"/>
                    <a:gd name="connsiteY0" fmla="*/ 4710610 h 4710599"/>
                    <a:gd name="connsiteX1" fmla="*/ 11 w 12198"/>
                    <a:gd name="connsiteY1" fmla="*/ 11 h 471059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4710599">
                      <a:moveTo>
                        <a:pt x="11" y="4710610"/>
                      </a:moveTo>
                      <a:lnTo>
                        <a:pt x="11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1" name="Freeform: Shape 280">
                  <a:extLst>
                    <a:ext uri="{FF2B5EF4-FFF2-40B4-BE49-F238E27FC236}">
                      <a16:creationId xmlns:a16="http://schemas.microsoft.com/office/drawing/2014/main" id="{401CB12F-737B-97EF-1869-3CA17A2BE51E}"/>
                    </a:ext>
                  </a:extLst>
                </p:cNvPr>
                <p:cNvSpPr/>
                <p:nvPr/>
              </p:nvSpPr>
              <p:spPr>
                <a:xfrm>
                  <a:off x="1498581" y="566212"/>
                  <a:ext cx="7331733" cy="12198"/>
                </a:xfrm>
                <a:custGeom>
                  <a:avLst/>
                  <a:gdLst>
                    <a:gd name="connsiteX0" fmla="*/ 11 w 7331733"/>
                    <a:gd name="connsiteY0" fmla="*/ 11 h 12198"/>
                    <a:gd name="connsiteX1" fmla="*/ 7331745 w 7331733"/>
                    <a:gd name="connsiteY1" fmla="*/ 11 h 121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331733" h="12198">
                      <a:moveTo>
                        <a:pt x="11" y="11"/>
                      </a:moveTo>
                      <a:lnTo>
                        <a:pt x="7331745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2" name="Freeform: Shape 281">
                  <a:extLst>
                    <a:ext uri="{FF2B5EF4-FFF2-40B4-BE49-F238E27FC236}">
                      <a16:creationId xmlns:a16="http://schemas.microsoft.com/office/drawing/2014/main" id="{F32FEE11-EEF8-C284-2D15-C5507ADC5A46}"/>
                    </a:ext>
                  </a:extLst>
                </p:cNvPr>
                <p:cNvSpPr/>
                <p:nvPr/>
              </p:nvSpPr>
              <p:spPr>
                <a:xfrm>
                  <a:off x="1498581" y="566212"/>
                  <a:ext cx="12198" cy="4710599"/>
                </a:xfrm>
                <a:custGeom>
                  <a:avLst/>
                  <a:gdLst>
                    <a:gd name="connsiteX0" fmla="*/ 11 w 12198"/>
                    <a:gd name="connsiteY0" fmla="*/ 4710610 h 4710599"/>
                    <a:gd name="connsiteX1" fmla="*/ 11 w 12198"/>
                    <a:gd name="connsiteY1" fmla="*/ 11 h 471059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4710599">
                      <a:moveTo>
                        <a:pt x="11" y="4710610"/>
                      </a:moveTo>
                      <a:lnTo>
                        <a:pt x="11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3" name="Freeform: Shape 282">
                  <a:extLst>
                    <a:ext uri="{FF2B5EF4-FFF2-40B4-BE49-F238E27FC236}">
                      <a16:creationId xmlns:a16="http://schemas.microsoft.com/office/drawing/2014/main" id="{C714220D-2B47-FE7B-EA1B-805C27AE2A48}"/>
                    </a:ext>
                  </a:extLst>
                </p:cNvPr>
                <p:cNvSpPr/>
                <p:nvPr/>
              </p:nvSpPr>
              <p:spPr>
                <a:xfrm>
                  <a:off x="1498581" y="5276811"/>
                  <a:ext cx="7331733" cy="12198"/>
                </a:xfrm>
                <a:custGeom>
                  <a:avLst/>
                  <a:gdLst>
                    <a:gd name="connsiteX0" fmla="*/ 11 w 7331733"/>
                    <a:gd name="connsiteY0" fmla="*/ 11 h 12198"/>
                    <a:gd name="connsiteX1" fmla="*/ 7331745 w 7331733"/>
                    <a:gd name="connsiteY1" fmla="*/ 11 h 1219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7331733" h="12198">
                      <a:moveTo>
                        <a:pt x="11" y="11"/>
                      </a:moveTo>
                      <a:lnTo>
                        <a:pt x="7331745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4" name="Freeform: Shape 283">
                  <a:extLst>
                    <a:ext uri="{FF2B5EF4-FFF2-40B4-BE49-F238E27FC236}">
                      <a16:creationId xmlns:a16="http://schemas.microsoft.com/office/drawing/2014/main" id="{3B35358C-2707-D489-42D7-E3D4FE88D34D}"/>
                    </a:ext>
                  </a:extLst>
                </p:cNvPr>
                <p:cNvSpPr/>
                <p:nvPr/>
              </p:nvSpPr>
              <p:spPr>
                <a:xfrm>
                  <a:off x="2022276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5" name="TextBox 284">
                  <a:extLst>
                    <a:ext uri="{FF2B5EF4-FFF2-40B4-BE49-F238E27FC236}">
                      <a16:creationId xmlns:a16="http://schemas.microsoft.com/office/drawing/2014/main" id="{26AA3670-3048-2231-909E-58D6DD51410E}"/>
                    </a:ext>
                  </a:extLst>
                </p:cNvPr>
                <p:cNvSpPr txBox="1"/>
                <p:nvPr/>
              </p:nvSpPr>
              <p:spPr>
                <a:xfrm>
                  <a:off x="1888141" y="5352468"/>
                  <a:ext cx="268270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0</a:t>
                  </a:r>
                </a:p>
              </p:txBody>
            </p:sp>
            <p:sp>
              <p:nvSpPr>
                <p:cNvPr id="286" name="Freeform: Shape 285">
                  <a:extLst>
                    <a:ext uri="{FF2B5EF4-FFF2-40B4-BE49-F238E27FC236}">
                      <a16:creationId xmlns:a16="http://schemas.microsoft.com/office/drawing/2014/main" id="{F7F3848C-DECF-9601-846B-18DD1BFDECE4}"/>
                    </a:ext>
                  </a:extLst>
                </p:cNvPr>
                <p:cNvSpPr/>
                <p:nvPr/>
              </p:nvSpPr>
              <p:spPr>
                <a:xfrm>
                  <a:off x="2391028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A2AD27E1-F3A0-36AF-A619-54E44F9D82DA}"/>
                    </a:ext>
                  </a:extLst>
                </p:cNvPr>
                <p:cNvSpPr txBox="1"/>
                <p:nvPr/>
              </p:nvSpPr>
              <p:spPr>
                <a:xfrm>
                  <a:off x="2256893" y="5352468"/>
                  <a:ext cx="268270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4</a:t>
                  </a:r>
                </a:p>
              </p:txBody>
            </p:sp>
            <p:sp>
              <p:nvSpPr>
                <p:cNvPr id="288" name="Freeform: Shape 287">
                  <a:extLst>
                    <a:ext uri="{FF2B5EF4-FFF2-40B4-BE49-F238E27FC236}">
                      <a16:creationId xmlns:a16="http://schemas.microsoft.com/office/drawing/2014/main" id="{A37AAA12-863D-DDAE-C49A-3FCDE776FCDD}"/>
                    </a:ext>
                  </a:extLst>
                </p:cNvPr>
                <p:cNvSpPr/>
                <p:nvPr/>
              </p:nvSpPr>
              <p:spPr>
                <a:xfrm>
                  <a:off x="2759780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4BC929D8-B259-C861-F9EE-17A7E61F527C}"/>
                    </a:ext>
                  </a:extLst>
                </p:cNvPr>
                <p:cNvSpPr txBox="1"/>
                <p:nvPr/>
              </p:nvSpPr>
              <p:spPr>
                <a:xfrm>
                  <a:off x="2625645" y="5352468"/>
                  <a:ext cx="268270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8</a:t>
                  </a:r>
                </a:p>
              </p:txBody>
            </p:sp>
            <p:sp>
              <p:nvSpPr>
                <p:cNvPr id="290" name="Freeform: Shape 289">
                  <a:extLst>
                    <a:ext uri="{FF2B5EF4-FFF2-40B4-BE49-F238E27FC236}">
                      <a16:creationId xmlns:a16="http://schemas.microsoft.com/office/drawing/2014/main" id="{FB35D447-DEAB-1285-F585-700DB337CCA3}"/>
                    </a:ext>
                  </a:extLst>
                </p:cNvPr>
                <p:cNvSpPr/>
                <p:nvPr/>
              </p:nvSpPr>
              <p:spPr>
                <a:xfrm>
                  <a:off x="3128532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1" name="TextBox 290">
                  <a:extLst>
                    <a:ext uri="{FF2B5EF4-FFF2-40B4-BE49-F238E27FC236}">
                      <a16:creationId xmlns:a16="http://schemas.microsoft.com/office/drawing/2014/main" id="{CCC831DA-924B-D7C5-AC83-86267120A52C}"/>
                    </a:ext>
                  </a:extLst>
                </p:cNvPr>
                <p:cNvSpPr txBox="1"/>
                <p:nvPr/>
              </p:nvSpPr>
              <p:spPr>
                <a:xfrm>
                  <a:off x="2951701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12</a:t>
                  </a:r>
                </a:p>
              </p:txBody>
            </p:sp>
            <p:sp>
              <p:nvSpPr>
                <p:cNvPr id="292" name="Freeform: Shape 291">
                  <a:extLst>
                    <a:ext uri="{FF2B5EF4-FFF2-40B4-BE49-F238E27FC236}">
                      <a16:creationId xmlns:a16="http://schemas.microsoft.com/office/drawing/2014/main" id="{54F785AE-CD21-DEF6-EDF7-748C43C5FD99}"/>
                    </a:ext>
                  </a:extLst>
                </p:cNvPr>
                <p:cNvSpPr/>
                <p:nvPr/>
              </p:nvSpPr>
              <p:spPr>
                <a:xfrm>
                  <a:off x="3497284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2EBB11E3-2104-DD32-BFD4-6FE90A8521E9}"/>
                    </a:ext>
                  </a:extLst>
                </p:cNvPr>
                <p:cNvSpPr txBox="1"/>
                <p:nvPr/>
              </p:nvSpPr>
              <p:spPr>
                <a:xfrm>
                  <a:off x="3320453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16</a:t>
                  </a:r>
                </a:p>
              </p:txBody>
            </p:sp>
            <p:sp>
              <p:nvSpPr>
                <p:cNvPr id="294" name="Freeform: Shape 293">
                  <a:extLst>
                    <a:ext uri="{FF2B5EF4-FFF2-40B4-BE49-F238E27FC236}">
                      <a16:creationId xmlns:a16="http://schemas.microsoft.com/office/drawing/2014/main" id="{1311C3E2-6020-9848-1F41-ABAA0CCD8464}"/>
                    </a:ext>
                  </a:extLst>
                </p:cNvPr>
                <p:cNvSpPr/>
                <p:nvPr/>
              </p:nvSpPr>
              <p:spPr>
                <a:xfrm>
                  <a:off x="3866036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5" name="TextBox 294">
                  <a:extLst>
                    <a:ext uri="{FF2B5EF4-FFF2-40B4-BE49-F238E27FC236}">
                      <a16:creationId xmlns:a16="http://schemas.microsoft.com/office/drawing/2014/main" id="{883B767C-E553-F191-CF79-B3874A2CEDF6}"/>
                    </a:ext>
                  </a:extLst>
                </p:cNvPr>
                <p:cNvSpPr txBox="1"/>
                <p:nvPr/>
              </p:nvSpPr>
              <p:spPr>
                <a:xfrm>
                  <a:off x="3689205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20</a:t>
                  </a:r>
                </a:p>
              </p:txBody>
            </p:sp>
            <p:sp>
              <p:nvSpPr>
                <p:cNvPr id="296" name="Freeform: Shape 295">
                  <a:extLst>
                    <a:ext uri="{FF2B5EF4-FFF2-40B4-BE49-F238E27FC236}">
                      <a16:creationId xmlns:a16="http://schemas.microsoft.com/office/drawing/2014/main" id="{76CF6323-576F-7661-89FA-C5D64D642F63}"/>
                    </a:ext>
                  </a:extLst>
                </p:cNvPr>
                <p:cNvSpPr/>
                <p:nvPr/>
              </p:nvSpPr>
              <p:spPr>
                <a:xfrm>
                  <a:off x="4234788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6B75D68F-54AC-646B-4F39-972EC995B085}"/>
                    </a:ext>
                  </a:extLst>
                </p:cNvPr>
                <p:cNvSpPr txBox="1"/>
                <p:nvPr/>
              </p:nvSpPr>
              <p:spPr>
                <a:xfrm>
                  <a:off x="4057957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24</a:t>
                  </a:r>
                </a:p>
              </p:txBody>
            </p:sp>
            <p:sp>
              <p:nvSpPr>
                <p:cNvPr id="298" name="Freeform: Shape 297">
                  <a:extLst>
                    <a:ext uri="{FF2B5EF4-FFF2-40B4-BE49-F238E27FC236}">
                      <a16:creationId xmlns:a16="http://schemas.microsoft.com/office/drawing/2014/main" id="{82ACE2E5-EFB4-421D-B9E9-B936E6794B0B}"/>
                    </a:ext>
                  </a:extLst>
                </p:cNvPr>
                <p:cNvSpPr/>
                <p:nvPr/>
              </p:nvSpPr>
              <p:spPr>
                <a:xfrm>
                  <a:off x="4603540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6E8B4764-2526-A12F-954B-986483787B91}"/>
                    </a:ext>
                  </a:extLst>
                </p:cNvPr>
                <p:cNvSpPr txBox="1"/>
                <p:nvPr/>
              </p:nvSpPr>
              <p:spPr>
                <a:xfrm>
                  <a:off x="4426709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28</a:t>
                  </a:r>
                </a:p>
              </p:txBody>
            </p:sp>
            <p:sp>
              <p:nvSpPr>
                <p:cNvPr id="300" name="Freeform: Shape 299">
                  <a:extLst>
                    <a:ext uri="{FF2B5EF4-FFF2-40B4-BE49-F238E27FC236}">
                      <a16:creationId xmlns:a16="http://schemas.microsoft.com/office/drawing/2014/main" id="{E5F44DC0-D8B4-4555-488F-379DC2C2090B}"/>
                    </a:ext>
                  </a:extLst>
                </p:cNvPr>
                <p:cNvSpPr/>
                <p:nvPr/>
              </p:nvSpPr>
              <p:spPr>
                <a:xfrm>
                  <a:off x="4972291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1" name="TextBox 300">
                  <a:extLst>
                    <a:ext uri="{FF2B5EF4-FFF2-40B4-BE49-F238E27FC236}">
                      <a16:creationId xmlns:a16="http://schemas.microsoft.com/office/drawing/2014/main" id="{25D7F8E5-43B4-C759-C431-17E30D7609B9}"/>
                    </a:ext>
                  </a:extLst>
                </p:cNvPr>
                <p:cNvSpPr txBox="1"/>
                <p:nvPr/>
              </p:nvSpPr>
              <p:spPr>
                <a:xfrm>
                  <a:off x="4795461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32</a:t>
                  </a:r>
                </a:p>
              </p:txBody>
            </p:sp>
            <p:sp>
              <p:nvSpPr>
                <p:cNvPr id="302" name="Freeform: Shape 301">
                  <a:extLst>
                    <a:ext uri="{FF2B5EF4-FFF2-40B4-BE49-F238E27FC236}">
                      <a16:creationId xmlns:a16="http://schemas.microsoft.com/office/drawing/2014/main" id="{4882578D-46D9-6B02-4684-0A2FC7520427}"/>
                    </a:ext>
                  </a:extLst>
                </p:cNvPr>
                <p:cNvSpPr/>
                <p:nvPr/>
              </p:nvSpPr>
              <p:spPr>
                <a:xfrm>
                  <a:off x="5341043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3" name="TextBox 302">
                  <a:extLst>
                    <a:ext uri="{FF2B5EF4-FFF2-40B4-BE49-F238E27FC236}">
                      <a16:creationId xmlns:a16="http://schemas.microsoft.com/office/drawing/2014/main" id="{73E03747-E45B-DD34-2764-DBF426C92225}"/>
                    </a:ext>
                  </a:extLst>
                </p:cNvPr>
                <p:cNvSpPr txBox="1"/>
                <p:nvPr/>
              </p:nvSpPr>
              <p:spPr>
                <a:xfrm>
                  <a:off x="5164213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36</a:t>
                  </a:r>
                </a:p>
              </p:txBody>
            </p:sp>
            <p:sp>
              <p:nvSpPr>
                <p:cNvPr id="304" name="Freeform: Shape 303">
                  <a:extLst>
                    <a:ext uri="{FF2B5EF4-FFF2-40B4-BE49-F238E27FC236}">
                      <a16:creationId xmlns:a16="http://schemas.microsoft.com/office/drawing/2014/main" id="{49B44484-4E4F-5143-0689-BD904685B459}"/>
                    </a:ext>
                  </a:extLst>
                </p:cNvPr>
                <p:cNvSpPr/>
                <p:nvPr/>
              </p:nvSpPr>
              <p:spPr>
                <a:xfrm>
                  <a:off x="5709795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5" name="TextBox 304">
                  <a:extLst>
                    <a:ext uri="{FF2B5EF4-FFF2-40B4-BE49-F238E27FC236}">
                      <a16:creationId xmlns:a16="http://schemas.microsoft.com/office/drawing/2014/main" id="{571F53E9-2550-B76A-FCEA-8E0959F158B7}"/>
                    </a:ext>
                  </a:extLst>
                </p:cNvPr>
                <p:cNvSpPr txBox="1"/>
                <p:nvPr/>
              </p:nvSpPr>
              <p:spPr>
                <a:xfrm>
                  <a:off x="5532964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40</a:t>
                  </a:r>
                </a:p>
              </p:txBody>
            </p:sp>
            <p:sp>
              <p:nvSpPr>
                <p:cNvPr id="306" name="Freeform: Shape 305">
                  <a:extLst>
                    <a:ext uri="{FF2B5EF4-FFF2-40B4-BE49-F238E27FC236}">
                      <a16:creationId xmlns:a16="http://schemas.microsoft.com/office/drawing/2014/main" id="{AB563609-3DF0-FEE4-CFBF-80471A8BFDEC}"/>
                    </a:ext>
                  </a:extLst>
                </p:cNvPr>
                <p:cNvSpPr/>
                <p:nvPr/>
              </p:nvSpPr>
              <p:spPr>
                <a:xfrm>
                  <a:off x="6078547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7" name="TextBox 306">
                  <a:extLst>
                    <a:ext uri="{FF2B5EF4-FFF2-40B4-BE49-F238E27FC236}">
                      <a16:creationId xmlns:a16="http://schemas.microsoft.com/office/drawing/2014/main" id="{1F2AD1DE-18C1-1B47-232B-B29EC72B94FF}"/>
                    </a:ext>
                  </a:extLst>
                </p:cNvPr>
                <p:cNvSpPr txBox="1"/>
                <p:nvPr/>
              </p:nvSpPr>
              <p:spPr>
                <a:xfrm>
                  <a:off x="5901716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44</a:t>
                  </a:r>
                </a:p>
              </p:txBody>
            </p:sp>
            <p:sp>
              <p:nvSpPr>
                <p:cNvPr id="308" name="Freeform: Shape 307">
                  <a:extLst>
                    <a:ext uri="{FF2B5EF4-FFF2-40B4-BE49-F238E27FC236}">
                      <a16:creationId xmlns:a16="http://schemas.microsoft.com/office/drawing/2014/main" id="{3C72770A-D597-2408-E65B-AD9045210731}"/>
                    </a:ext>
                  </a:extLst>
                </p:cNvPr>
                <p:cNvSpPr/>
                <p:nvPr/>
              </p:nvSpPr>
              <p:spPr>
                <a:xfrm>
                  <a:off x="6447299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09" name="TextBox 308">
                  <a:extLst>
                    <a:ext uri="{FF2B5EF4-FFF2-40B4-BE49-F238E27FC236}">
                      <a16:creationId xmlns:a16="http://schemas.microsoft.com/office/drawing/2014/main" id="{C8C2C70F-91D4-10E9-C17D-97EFB2F2346F}"/>
                    </a:ext>
                  </a:extLst>
                </p:cNvPr>
                <p:cNvSpPr txBox="1"/>
                <p:nvPr/>
              </p:nvSpPr>
              <p:spPr>
                <a:xfrm>
                  <a:off x="6270468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48</a:t>
                  </a:r>
                </a:p>
              </p:txBody>
            </p:sp>
            <p:sp>
              <p:nvSpPr>
                <p:cNvPr id="310" name="Freeform: Shape 309">
                  <a:extLst>
                    <a:ext uri="{FF2B5EF4-FFF2-40B4-BE49-F238E27FC236}">
                      <a16:creationId xmlns:a16="http://schemas.microsoft.com/office/drawing/2014/main" id="{E07AA8CE-B8C8-4FE1-C266-5AB6FA56C6D3}"/>
                    </a:ext>
                  </a:extLst>
                </p:cNvPr>
                <p:cNvSpPr/>
                <p:nvPr/>
              </p:nvSpPr>
              <p:spPr>
                <a:xfrm>
                  <a:off x="6816051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1" name="TextBox 310">
                  <a:extLst>
                    <a:ext uri="{FF2B5EF4-FFF2-40B4-BE49-F238E27FC236}">
                      <a16:creationId xmlns:a16="http://schemas.microsoft.com/office/drawing/2014/main" id="{A0A2C318-E8EB-0DED-ABF6-5005969DDF87}"/>
                    </a:ext>
                  </a:extLst>
                </p:cNvPr>
                <p:cNvSpPr txBox="1"/>
                <p:nvPr/>
              </p:nvSpPr>
              <p:spPr>
                <a:xfrm>
                  <a:off x="6639220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52</a:t>
                  </a:r>
                </a:p>
              </p:txBody>
            </p:sp>
            <p:sp>
              <p:nvSpPr>
                <p:cNvPr id="312" name="Freeform: Shape 311">
                  <a:extLst>
                    <a:ext uri="{FF2B5EF4-FFF2-40B4-BE49-F238E27FC236}">
                      <a16:creationId xmlns:a16="http://schemas.microsoft.com/office/drawing/2014/main" id="{B6933D45-00DB-4F05-C12A-F8F3769A0BD3}"/>
                    </a:ext>
                  </a:extLst>
                </p:cNvPr>
                <p:cNvSpPr/>
                <p:nvPr/>
              </p:nvSpPr>
              <p:spPr>
                <a:xfrm>
                  <a:off x="7184802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491A9651-F7C9-A40F-AFBC-0467F2054CA0}"/>
                    </a:ext>
                  </a:extLst>
                </p:cNvPr>
                <p:cNvSpPr txBox="1"/>
                <p:nvPr/>
              </p:nvSpPr>
              <p:spPr>
                <a:xfrm>
                  <a:off x="7007972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56</a:t>
                  </a:r>
                </a:p>
              </p:txBody>
            </p:sp>
            <p:sp>
              <p:nvSpPr>
                <p:cNvPr id="314" name="Freeform: Shape 313">
                  <a:extLst>
                    <a:ext uri="{FF2B5EF4-FFF2-40B4-BE49-F238E27FC236}">
                      <a16:creationId xmlns:a16="http://schemas.microsoft.com/office/drawing/2014/main" id="{62BAC9C8-B0E9-E9BC-56FE-B97A1954BC7C}"/>
                    </a:ext>
                  </a:extLst>
                </p:cNvPr>
                <p:cNvSpPr/>
                <p:nvPr/>
              </p:nvSpPr>
              <p:spPr>
                <a:xfrm>
                  <a:off x="7553555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5" name="TextBox 314">
                  <a:extLst>
                    <a:ext uri="{FF2B5EF4-FFF2-40B4-BE49-F238E27FC236}">
                      <a16:creationId xmlns:a16="http://schemas.microsoft.com/office/drawing/2014/main" id="{1858E169-FEAD-34B8-92D9-D53ACC85FEE1}"/>
                    </a:ext>
                  </a:extLst>
                </p:cNvPr>
                <p:cNvSpPr txBox="1"/>
                <p:nvPr/>
              </p:nvSpPr>
              <p:spPr>
                <a:xfrm>
                  <a:off x="7376724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60</a:t>
                  </a:r>
                </a:p>
              </p:txBody>
            </p:sp>
            <p:sp>
              <p:nvSpPr>
                <p:cNvPr id="316" name="Freeform: Shape 315">
                  <a:extLst>
                    <a:ext uri="{FF2B5EF4-FFF2-40B4-BE49-F238E27FC236}">
                      <a16:creationId xmlns:a16="http://schemas.microsoft.com/office/drawing/2014/main" id="{3CE2515C-2B0A-10D0-47F5-1C293C3C01F1}"/>
                    </a:ext>
                  </a:extLst>
                </p:cNvPr>
                <p:cNvSpPr/>
                <p:nvPr/>
              </p:nvSpPr>
              <p:spPr>
                <a:xfrm>
                  <a:off x="7922307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7" name="TextBox 316">
                  <a:extLst>
                    <a:ext uri="{FF2B5EF4-FFF2-40B4-BE49-F238E27FC236}">
                      <a16:creationId xmlns:a16="http://schemas.microsoft.com/office/drawing/2014/main" id="{F5414F31-6AE1-A106-C49C-7A875FAD3A61}"/>
                    </a:ext>
                  </a:extLst>
                </p:cNvPr>
                <p:cNvSpPr txBox="1"/>
                <p:nvPr/>
              </p:nvSpPr>
              <p:spPr>
                <a:xfrm>
                  <a:off x="7745476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64</a:t>
                  </a:r>
                </a:p>
              </p:txBody>
            </p:sp>
            <p:sp>
              <p:nvSpPr>
                <p:cNvPr id="318" name="Freeform: Shape 317">
                  <a:extLst>
                    <a:ext uri="{FF2B5EF4-FFF2-40B4-BE49-F238E27FC236}">
                      <a16:creationId xmlns:a16="http://schemas.microsoft.com/office/drawing/2014/main" id="{FE9B1596-9AF8-E148-8ED4-5901F58C85FB}"/>
                    </a:ext>
                  </a:extLst>
                </p:cNvPr>
                <p:cNvSpPr/>
                <p:nvPr/>
              </p:nvSpPr>
              <p:spPr>
                <a:xfrm>
                  <a:off x="8291058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19" name="TextBox 318">
                  <a:extLst>
                    <a:ext uri="{FF2B5EF4-FFF2-40B4-BE49-F238E27FC236}">
                      <a16:creationId xmlns:a16="http://schemas.microsoft.com/office/drawing/2014/main" id="{3847A22D-6CD0-0766-0DF3-4246090C0347}"/>
                    </a:ext>
                  </a:extLst>
                </p:cNvPr>
                <p:cNvSpPr txBox="1"/>
                <p:nvPr/>
              </p:nvSpPr>
              <p:spPr>
                <a:xfrm>
                  <a:off x="8114227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68</a:t>
                  </a:r>
                </a:p>
              </p:txBody>
            </p:sp>
            <p:sp>
              <p:nvSpPr>
                <p:cNvPr id="320" name="Freeform: Shape 319">
                  <a:extLst>
                    <a:ext uri="{FF2B5EF4-FFF2-40B4-BE49-F238E27FC236}">
                      <a16:creationId xmlns:a16="http://schemas.microsoft.com/office/drawing/2014/main" id="{28C92D63-469E-D82A-109A-7ABBE4328494}"/>
                    </a:ext>
                  </a:extLst>
                </p:cNvPr>
                <p:cNvSpPr/>
                <p:nvPr/>
              </p:nvSpPr>
              <p:spPr>
                <a:xfrm>
                  <a:off x="8659810" y="5276811"/>
                  <a:ext cx="12198" cy="63433"/>
                </a:xfrm>
                <a:custGeom>
                  <a:avLst/>
                  <a:gdLst>
                    <a:gd name="connsiteX0" fmla="*/ 11 w 12198"/>
                    <a:gd name="connsiteY0" fmla="*/ 11 h 63433"/>
                    <a:gd name="connsiteX1" fmla="*/ 11 w 12198"/>
                    <a:gd name="connsiteY1" fmla="*/ 63444 h 6343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63433">
                      <a:moveTo>
                        <a:pt x="11" y="11"/>
                      </a:moveTo>
                      <a:lnTo>
                        <a:pt x="11" y="63444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21" name="TextBox 320">
                  <a:extLst>
                    <a:ext uri="{FF2B5EF4-FFF2-40B4-BE49-F238E27FC236}">
                      <a16:creationId xmlns:a16="http://schemas.microsoft.com/office/drawing/2014/main" id="{CBF0B022-711D-046B-292D-89C627087534}"/>
                    </a:ext>
                  </a:extLst>
                </p:cNvPr>
                <p:cNvSpPr txBox="1"/>
                <p:nvPr/>
              </p:nvSpPr>
              <p:spPr>
                <a:xfrm>
                  <a:off x="8482979" y="5352468"/>
                  <a:ext cx="353661" cy="23782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00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72</a:t>
                  </a:r>
                </a:p>
              </p:txBody>
            </p:sp>
            <p:sp>
              <p:nvSpPr>
                <p:cNvPr id="322" name="TextBox 321">
                  <a:extLst>
                    <a:ext uri="{FF2B5EF4-FFF2-40B4-BE49-F238E27FC236}">
                      <a16:creationId xmlns:a16="http://schemas.microsoft.com/office/drawing/2014/main" id="{3353B894-FD73-78EF-6D40-D1287980AC07}"/>
                    </a:ext>
                  </a:extLst>
                </p:cNvPr>
                <p:cNvSpPr txBox="1"/>
                <p:nvPr/>
              </p:nvSpPr>
              <p:spPr>
                <a:xfrm>
                  <a:off x="4816826" y="5578143"/>
                  <a:ext cx="707422" cy="2500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75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Months</a:t>
                  </a:r>
                </a:p>
              </p:txBody>
            </p:sp>
            <p:sp>
              <p:nvSpPr>
                <p:cNvPr id="323" name="Freeform: Shape 322">
                  <a:extLst>
                    <a:ext uri="{FF2B5EF4-FFF2-40B4-BE49-F238E27FC236}">
                      <a16:creationId xmlns:a16="http://schemas.microsoft.com/office/drawing/2014/main" id="{DDEDCAC7-BF7C-7D01-6B1A-E2B45618B15D}"/>
                    </a:ext>
                  </a:extLst>
                </p:cNvPr>
                <p:cNvSpPr/>
                <p:nvPr/>
              </p:nvSpPr>
              <p:spPr>
                <a:xfrm>
                  <a:off x="1498581" y="566212"/>
                  <a:ext cx="12198" cy="4710599"/>
                </a:xfrm>
                <a:custGeom>
                  <a:avLst/>
                  <a:gdLst>
                    <a:gd name="connsiteX0" fmla="*/ 11 w 12198"/>
                    <a:gd name="connsiteY0" fmla="*/ 4710610 h 4710599"/>
                    <a:gd name="connsiteX1" fmla="*/ 11 w 12198"/>
                    <a:gd name="connsiteY1" fmla="*/ 11 h 471059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198" h="4710599">
                      <a:moveTo>
                        <a:pt x="11" y="4710610"/>
                      </a:moveTo>
                      <a:lnTo>
                        <a:pt x="11" y="11"/>
                      </a:lnTo>
                    </a:path>
                  </a:pathLst>
                </a:custGeom>
                <a:noFill/>
                <a:ln w="12185" cap="flat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24" name="TextBox 323">
                  <a:extLst>
                    <a:ext uri="{FF2B5EF4-FFF2-40B4-BE49-F238E27FC236}">
                      <a16:creationId xmlns:a16="http://schemas.microsoft.com/office/drawing/2014/main" id="{2D54FAD5-71A6-B963-33AE-B7CDB348B45A}"/>
                    </a:ext>
                  </a:extLst>
                </p:cNvPr>
                <p:cNvSpPr txBox="1"/>
                <p:nvPr/>
              </p:nvSpPr>
              <p:spPr>
                <a:xfrm rot="-5400000">
                  <a:off x="1009447" y="2796500"/>
                  <a:ext cx="768416" cy="25002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l"/>
                  <a:r>
                    <a:rPr lang="en-US" sz="975" spc="0" baseline="0">
                      <a:ln/>
                      <a:solidFill>
                        <a:srgbClr val="000000"/>
                      </a:solidFill>
                      <a:latin typeface="MYingHei_18030_C-Medium"/>
                      <a:ea typeface="MYingHei_18030_C-Medium"/>
                      <a:cs typeface="MYingHei_18030_C-Medium"/>
                      <a:sym typeface="MYingHei_18030_C-Medium"/>
                      <a:rtl val="0"/>
                    </a:rPr>
                    <a:t>Patients</a:t>
                  </a:r>
                </a:p>
              </p:txBody>
            </p:sp>
          </p:grpSp>
        </p:grpSp>
        <p:grpSp>
          <p:nvGrpSpPr>
            <p:cNvPr id="325" name="Graphic 4">
              <a:extLst>
                <a:ext uri="{FF2B5EF4-FFF2-40B4-BE49-F238E27FC236}">
                  <a16:creationId xmlns:a16="http://schemas.microsoft.com/office/drawing/2014/main" id="{A78CBA30-81A3-586B-350D-8ACA8D73A442}"/>
                </a:ext>
              </a:extLst>
            </p:cNvPr>
            <p:cNvGrpSpPr/>
            <p:nvPr/>
          </p:nvGrpSpPr>
          <p:grpSpPr>
            <a:xfrm>
              <a:off x="1498897" y="5909228"/>
              <a:ext cx="2549521" cy="231774"/>
              <a:chOff x="1498897" y="5909228"/>
              <a:chExt cx="2549521" cy="231774"/>
            </a:xfrm>
          </p:grpSpPr>
          <p:sp>
            <p:nvSpPr>
              <p:cNvPr id="326" name="Freeform: Shape 325">
                <a:extLst>
                  <a:ext uri="{FF2B5EF4-FFF2-40B4-BE49-F238E27FC236}">
                    <a16:creationId xmlns:a16="http://schemas.microsoft.com/office/drawing/2014/main" id="{6FD1EF86-D7C6-E32C-C012-AC5EAE1B2C6E}"/>
                  </a:ext>
                </a:extLst>
              </p:cNvPr>
              <p:cNvSpPr/>
              <p:nvPr/>
            </p:nvSpPr>
            <p:spPr>
              <a:xfrm>
                <a:off x="1498897" y="5909228"/>
                <a:ext cx="2549521" cy="231774"/>
              </a:xfrm>
              <a:custGeom>
                <a:avLst/>
                <a:gdLst>
                  <a:gd name="connsiteX0" fmla="*/ 27 w 2549521"/>
                  <a:gd name="connsiteY0" fmla="*/ 439 h 231774"/>
                  <a:gd name="connsiteX1" fmla="*/ 2549549 w 2549521"/>
                  <a:gd name="connsiteY1" fmla="*/ 439 h 231774"/>
                  <a:gd name="connsiteX2" fmla="*/ 2549549 w 2549521"/>
                  <a:gd name="connsiteY2" fmla="*/ 232214 h 231774"/>
                  <a:gd name="connsiteX3" fmla="*/ 27 w 2549521"/>
                  <a:gd name="connsiteY3" fmla="*/ 232214 h 2317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549521" h="231774">
                    <a:moveTo>
                      <a:pt x="27" y="439"/>
                    </a:moveTo>
                    <a:lnTo>
                      <a:pt x="2549549" y="439"/>
                    </a:lnTo>
                    <a:lnTo>
                      <a:pt x="2549549" y="232214"/>
                    </a:lnTo>
                    <a:lnTo>
                      <a:pt x="27" y="232214"/>
                    </a:lnTo>
                    <a:close/>
                  </a:path>
                </a:pathLst>
              </a:custGeom>
              <a:solidFill>
                <a:srgbClr val="FFFFFF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27" name="Freeform: Shape 326">
                <a:extLst>
                  <a:ext uri="{FF2B5EF4-FFF2-40B4-BE49-F238E27FC236}">
                    <a16:creationId xmlns:a16="http://schemas.microsoft.com/office/drawing/2014/main" id="{8F1CB833-1496-0542-D0A9-24866B2644D4}"/>
                  </a:ext>
                </a:extLst>
              </p:cNvPr>
              <p:cNvSpPr/>
              <p:nvPr/>
            </p:nvSpPr>
            <p:spPr>
              <a:xfrm>
                <a:off x="1498897" y="5909228"/>
                <a:ext cx="2549521" cy="231774"/>
              </a:xfrm>
              <a:custGeom>
                <a:avLst/>
                <a:gdLst>
                  <a:gd name="connsiteX0" fmla="*/ 27 w 2549521"/>
                  <a:gd name="connsiteY0" fmla="*/ 439 h 231774"/>
                  <a:gd name="connsiteX1" fmla="*/ 2549549 w 2549521"/>
                  <a:gd name="connsiteY1" fmla="*/ 439 h 231774"/>
                  <a:gd name="connsiteX2" fmla="*/ 2549549 w 2549521"/>
                  <a:gd name="connsiteY2" fmla="*/ 232214 h 231774"/>
                  <a:gd name="connsiteX3" fmla="*/ 27 w 2549521"/>
                  <a:gd name="connsiteY3" fmla="*/ 232214 h 2317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549521" h="231774">
                    <a:moveTo>
                      <a:pt x="27" y="439"/>
                    </a:moveTo>
                    <a:lnTo>
                      <a:pt x="2549549" y="439"/>
                    </a:lnTo>
                    <a:lnTo>
                      <a:pt x="2549549" y="232214"/>
                    </a:lnTo>
                    <a:lnTo>
                      <a:pt x="27" y="232214"/>
                    </a:lnTo>
                    <a:close/>
                  </a:path>
                </a:pathLst>
              </a:custGeom>
              <a:noFill/>
              <a:ln w="12185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28" name="TextBox 327">
                <a:extLst>
                  <a:ext uri="{FF2B5EF4-FFF2-40B4-BE49-F238E27FC236}">
                    <a16:creationId xmlns:a16="http://schemas.microsoft.com/office/drawing/2014/main" id="{436D21E4-D126-671F-71FC-97C6841F1E2B}"/>
                  </a:ext>
                </a:extLst>
              </p:cNvPr>
              <p:cNvSpPr txBox="1"/>
              <p:nvPr/>
            </p:nvSpPr>
            <p:spPr>
              <a:xfrm>
                <a:off x="3786197" y="5912303"/>
                <a:ext cx="292668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N</a:t>
                </a:r>
              </a:p>
            </p:txBody>
          </p:sp>
          <p:grpSp>
            <p:nvGrpSpPr>
              <p:cNvPr id="329" name="Graphic 4">
                <a:extLst>
                  <a:ext uri="{FF2B5EF4-FFF2-40B4-BE49-F238E27FC236}">
                    <a16:creationId xmlns:a16="http://schemas.microsoft.com/office/drawing/2014/main" id="{866CF663-1EB4-4F73-AB0E-C0C4E75A1A0A}"/>
                  </a:ext>
                </a:extLst>
              </p:cNvPr>
              <p:cNvGrpSpPr/>
              <p:nvPr/>
            </p:nvGrpSpPr>
            <p:grpSpPr>
              <a:xfrm>
                <a:off x="3682458" y="5945824"/>
                <a:ext cx="109788" cy="109788"/>
                <a:chOff x="3682458" y="5945824"/>
                <a:chExt cx="109788" cy="109788"/>
              </a:xfrm>
            </p:grpSpPr>
            <p:sp>
              <p:nvSpPr>
                <p:cNvPr id="330" name="Freeform: Shape 329">
                  <a:extLst>
                    <a:ext uri="{FF2B5EF4-FFF2-40B4-BE49-F238E27FC236}">
                      <a16:creationId xmlns:a16="http://schemas.microsoft.com/office/drawing/2014/main" id="{73AEC1F7-48F0-A1DB-F5D9-B9056AE6E508}"/>
                    </a:ext>
                  </a:extLst>
                </p:cNvPr>
                <p:cNvSpPr/>
                <p:nvPr/>
              </p:nvSpPr>
              <p:spPr>
                <a:xfrm>
                  <a:off x="3682458" y="5945824"/>
                  <a:ext cx="109788" cy="109788"/>
                </a:xfrm>
                <a:custGeom>
                  <a:avLst/>
                  <a:gdLst>
                    <a:gd name="connsiteX0" fmla="*/ 203 w 109788"/>
                    <a:gd name="connsiteY0" fmla="*/ 450 h 109788"/>
                    <a:gd name="connsiteX1" fmla="*/ 109991 w 109788"/>
                    <a:gd name="connsiteY1" fmla="*/ 450 h 109788"/>
                    <a:gd name="connsiteX2" fmla="*/ 109991 w 109788"/>
                    <a:gd name="connsiteY2" fmla="*/ 110238 h 109788"/>
                    <a:gd name="connsiteX3" fmla="*/ 203 w 109788"/>
                    <a:gd name="connsiteY3" fmla="*/ 110238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9788" h="109788">
                      <a:moveTo>
                        <a:pt x="203" y="450"/>
                      </a:moveTo>
                      <a:lnTo>
                        <a:pt x="109991" y="450"/>
                      </a:lnTo>
                      <a:lnTo>
                        <a:pt x="109991" y="110238"/>
                      </a:lnTo>
                      <a:lnTo>
                        <a:pt x="203" y="110238"/>
                      </a:lnTo>
                      <a:close/>
                    </a:path>
                  </a:pathLst>
                </a:custGeom>
                <a:solidFill>
                  <a:srgbClr val="FF9933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31" name="Freeform: Shape 330">
                  <a:extLst>
                    <a:ext uri="{FF2B5EF4-FFF2-40B4-BE49-F238E27FC236}">
                      <a16:creationId xmlns:a16="http://schemas.microsoft.com/office/drawing/2014/main" id="{CEFD6012-71FF-CE09-F7BD-2DCFE7DA6D07}"/>
                    </a:ext>
                  </a:extLst>
                </p:cNvPr>
                <p:cNvSpPr/>
                <p:nvPr/>
              </p:nvSpPr>
              <p:spPr>
                <a:xfrm>
                  <a:off x="3682458" y="5945824"/>
                  <a:ext cx="109788" cy="109788"/>
                </a:xfrm>
                <a:custGeom>
                  <a:avLst/>
                  <a:gdLst>
                    <a:gd name="connsiteX0" fmla="*/ 203 w 109788"/>
                    <a:gd name="connsiteY0" fmla="*/ 450 h 109788"/>
                    <a:gd name="connsiteX1" fmla="*/ 109991 w 109788"/>
                    <a:gd name="connsiteY1" fmla="*/ 450 h 109788"/>
                    <a:gd name="connsiteX2" fmla="*/ 109991 w 109788"/>
                    <a:gd name="connsiteY2" fmla="*/ 110238 h 109788"/>
                    <a:gd name="connsiteX3" fmla="*/ 203 w 109788"/>
                    <a:gd name="connsiteY3" fmla="*/ 110238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9788" h="109788">
                      <a:moveTo>
                        <a:pt x="203" y="450"/>
                      </a:moveTo>
                      <a:lnTo>
                        <a:pt x="109991" y="450"/>
                      </a:lnTo>
                      <a:lnTo>
                        <a:pt x="109991" y="110238"/>
                      </a:lnTo>
                      <a:lnTo>
                        <a:pt x="203" y="110238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65FE139E-7B07-6FF9-C434-25394924249D}"/>
                  </a:ext>
                </a:extLst>
              </p:cNvPr>
              <p:cNvSpPr txBox="1"/>
              <p:nvPr/>
            </p:nvSpPr>
            <p:spPr>
              <a:xfrm>
                <a:off x="3371442" y="5912303"/>
                <a:ext cx="280469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Y</a:t>
                </a:r>
              </a:p>
            </p:txBody>
          </p:sp>
          <p:grpSp>
            <p:nvGrpSpPr>
              <p:cNvPr id="333" name="Graphic 4">
                <a:extLst>
                  <a:ext uri="{FF2B5EF4-FFF2-40B4-BE49-F238E27FC236}">
                    <a16:creationId xmlns:a16="http://schemas.microsoft.com/office/drawing/2014/main" id="{B9CF6F67-F474-FE86-23FE-F312F770D223}"/>
                  </a:ext>
                </a:extLst>
              </p:cNvPr>
              <p:cNvGrpSpPr/>
              <p:nvPr/>
            </p:nvGrpSpPr>
            <p:grpSpPr>
              <a:xfrm>
                <a:off x="3267703" y="5945824"/>
                <a:ext cx="109788" cy="109788"/>
                <a:chOff x="3267703" y="5945824"/>
                <a:chExt cx="109788" cy="109788"/>
              </a:xfrm>
            </p:grpSpPr>
            <p:sp>
              <p:nvSpPr>
                <p:cNvPr id="334" name="Freeform: Shape 333">
                  <a:extLst>
                    <a:ext uri="{FF2B5EF4-FFF2-40B4-BE49-F238E27FC236}">
                      <a16:creationId xmlns:a16="http://schemas.microsoft.com/office/drawing/2014/main" id="{524AFA25-CD16-42BC-CB5D-6DAEFA4A6F3F}"/>
                    </a:ext>
                  </a:extLst>
                </p:cNvPr>
                <p:cNvSpPr/>
                <p:nvPr/>
              </p:nvSpPr>
              <p:spPr>
                <a:xfrm>
                  <a:off x="3267703" y="5945824"/>
                  <a:ext cx="109788" cy="109788"/>
                </a:xfrm>
                <a:custGeom>
                  <a:avLst/>
                  <a:gdLst>
                    <a:gd name="connsiteX0" fmla="*/ 169 w 109788"/>
                    <a:gd name="connsiteY0" fmla="*/ 450 h 109788"/>
                    <a:gd name="connsiteX1" fmla="*/ 109957 w 109788"/>
                    <a:gd name="connsiteY1" fmla="*/ 450 h 109788"/>
                    <a:gd name="connsiteX2" fmla="*/ 109957 w 109788"/>
                    <a:gd name="connsiteY2" fmla="*/ 110238 h 109788"/>
                    <a:gd name="connsiteX3" fmla="*/ 169 w 109788"/>
                    <a:gd name="connsiteY3" fmla="*/ 110238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9788" h="109788">
                      <a:moveTo>
                        <a:pt x="169" y="450"/>
                      </a:moveTo>
                      <a:lnTo>
                        <a:pt x="109957" y="450"/>
                      </a:lnTo>
                      <a:lnTo>
                        <a:pt x="109957" y="110238"/>
                      </a:lnTo>
                      <a:lnTo>
                        <a:pt x="169" y="110238"/>
                      </a:lnTo>
                      <a:close/>
                    </a:path>
                  </a:pathLst>
                </a:custGeom>
                <a:solidFill>
                  <a:srgbClr val="FFCC99">
                    <a:alpha val="90000"/>
                  </a:srgbClr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35" name="Freeform: Shape 334">
                  <a:extLst>
                    <a:ext uri="{FF2B5EF4-FFF2-40B4-BE49-F238E27FC236}">
                      <a16:creationId xmlns:a16="http://schemas.microsoft.com/office/drawing/2014/main" id="{7F7DF5B2-9947-DB6E-E3E4-811872E88229}"/>
                    </a:ext>
                  </a:extLst>
                </p:cNvPr>
                <p:cNvSpPr/>
                <p:nvPr/>
              </p:nvSpPr>
              <p:spPr>
                <a:xfrm>
                  <a:off x="3267703" y="5945824"/>
                  <a:ext cx="109788" cy="109788"/>
                </a:xfrm>
                <a:custGeom>
                  <a:avLst/>
                  <a:gdLst>
                    <a:gd name="connsiteX0" fmla="*/ 169 w 109788"/>
                    <a:gd name="connsiteY0" fmla="*/ 450 h 109788"/>
                    <a:gd name="connsiteX1" fmla="*/ 109957 w 109788"/>
                    <a:gd name="connsiteY1" fmla="*/ 450 h 109788"/>
                    <a:gd name="connsiteX2" fmla="*/ 109957 w 109788"/>
                    <a:gd name="connsiteY2" fmla="*/ 110238 h 109788"/>
                    <a:gd name="connsiteX3" fmla="*/ 169 w 109788"/>
                    <a:gd name="connsiteY3" fmla="*/ 110238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09788" h="109788">
                      <a:moveTo>
                        <a:pt x="169" y="450"/>
                      </a:moveTo>
                      <a:lnTo>
                        <a:pt x="109957" y="450"/>
                      </a:lnTo>
                      <a:lnTo>
                        <a:pt x="109957" y="110238"/>
                      </a:lnTo>
                      <a:lnTo>
                        <a:pt x="169" y="110238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00000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336" name="TextBox 335">
                <a:extLst>
                  <a:ext uri="{FF2B5EF4-FFF2-40B4-BE49-F238E27FC236}">
                    <a16:creationId xmlns:a16="http://schemas.microsoft.com/office/drawing/2014/main" id="{25E5DA53-D246-641A-343F-6EF47B194767}"/>
                  </a:ext>
                </a:extLst>
              </p:cNvPr>
              <p:cNvSpPr txBox="1"/>
              <p:nvPr/>
            </p:nvSpPr>
            <p:spPr>
              <a:xfrm>
                <a:off x="1468450" y="5900104"/>
                <a:ext cx="1658918" cy="2500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75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Rechallenge patients</a:t>
                </a:r>
              </a:p>
            </p:txBody>
          </p:sp>
        </p:grpSp>
        <p:grpSp>
          <p:nvGrpSpPr>
            <p:cNvPr id="337" name="Graphic 4">
              <a:extLst>
                <a:ext uri="{FF2B5EF4-FFF2-40B4-BE49-F238E27FC236}">
                  <a16:creationId xmlns:a16="http://schemas.microsoft.com/office/drawing/2014/main" id="{3FE0FB45-6FC2-5D7A-C605-3F0290C7ABCA}"/>
                </a:ext>
              </a:extLst>
            </p:cNvPr>
            <p:cNvGrpSpPr/>
            <p:nvPr/>
          </p:nvGrpSpPr>
          <p:grpSpPr>
            <a:xfrm>
              <a:off x="1633082" y="4765628"/>
              <a:ext cx="5422257" cy="469599"/>
              <a:chOff x="1633082" y="4765628"/>
              <a:chExt cx="5422257" cy="469599"/>
            </a:xfrm>
          </p:grpSpPr>
          <p:sp>
            <p:nvSpPr>
              <p:cNvPr id="338" name="TextBox 337">
                <a:extLst>
                  <a:ext uri="{FF2B5EF4-FFF2-40B4-BE49-F238E27FC236}">
                    <a16:creationId xmlns:a16="http://schemas.microsoft.com/office/drawing/2014/main" id="{DDA0EBF1-F286-19D3-4975-C7EC83364C30}"/>
                  </a:ext>
                </a:extLst>
              </p:cNvPr>
              <p:cNvSpPr txBox="1"/>
              <p:nvPr/>
            </p:nvSpPr>
            <p:spPr>
              <a:xfrm>
                <a:off x="4054567" y="4997403"/>
                <a:ext cx="1500336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End of Rechallenge</a:t>
                </a:r>
              </a:p>
            </p:txBody>
          </p:sp>
          <p:grpSp>
            <p:nvGrpSpPr>
              <p:cNvPr id="339" name="Graphic 4">
                <a:extLst>
                  <a:ext uri="{FF2B5EF4-FFF2-40B4-BE49-F238E27FC236}">
                    <a16:creationId xmlns:a16="http://schemas.microsoft.com/office/drawing/2014/main" id="{2CA089DF-EAAE-21E1-D37A-4A6CF3776C66}"/>
                  </a:ext>
                </a:extLst>
              </p:cNvPr>
              <p:cNvGrpSpPr/>
              <p:nvPr/>
            </p:nvGrpSpPr>
            <p:grpSpPr>
              <a:xfrm>
                <a:off x="3963027" y="5018725"/>
                <a:ext cx="97589" cy="109788"/>
                <a:chOff x="3963027" y="5018725"/>
                <a:chExt cx="97589" cy="109788"/>
              </a:xfrm>
            </p:grpSpPr>
            <p:sp>
              <p:nvSpPr>
                <p:cNvPr id="340" name="Freeform: Shape 339">
                  <a:extLst>
                    <a:ext uri="{FF2B5EF4-FFF2-40B4-BE49-F238E27FC236}">
                      <a16:creationId xmlns:a16="http://schemas.microsoft.com/office/drawing/2014/main" id="{1ED7C89A-E175-BB99-EAD5-FF3515732653}"/>
                    </a:ext>
                  </a:extLst>
                </p:cNvPr>
                <p:cNvSpPr/>
                <p:nvPr/>
              </p:nvSpPr>
              <p:spPr>
                <a:xfrm>
                  <a:off x="3963027" y="5018725"/>
                  <a:ext cx="97589" cy="109788"/>
                </a:xfrm>
                <a:custGeom>
                  <a:avLst/>
                  <a:gdLst>
                    <a:gd name="connsiteX0" fmla="*/ 49021 w 97589"/>
                    <a:gd name="connsiteY0" fmla="*/ 374 h 109788"/>
                    <a:gd name="connsiteX1" fmla="*/ 61219 w 97589"/>
                    <a:gd name="connsiteY1" fmla="*/ 36970 h 109788"/>
                    <a:gd name="connsiteX2" fmla="*/ 97815 w 97589"/>
                    <a:gd name="connsiteY2" fmla="*/ 36970 h 109788"/>
                    <a:gd name="connsiteX3" fmla="*/ 73418 w 97589"/>
                    <a:gd name="connsiteY3" fmla="*/ 61367 h 109788"/>
                    <a:gd name="connsiteX4" fmla="*/ 85617 w 97589"/>
                    <a:gd name="connsiteY4" fmla="*/ 110162 h 109788"/>
                    <a:gd name="connsiteX5" fmla="*/ 49021 w 97589"/>
                    <a:gd name="connsiteY5" fmla="*/ 73566 h 109788"/>
                    <a:gd name="connsiteX6" fmla="*/ 12425 w 97589"/>
                    <a:gd name="connsiteY6" fmla="*/ 110162 h 109788"/>
                    <a:gd name="connsiteX7" fmla="*/ 24623 w 97589"/>
                    <a:gd name="connsiteY7" fmla="*/ 61367 h 109788"/>
                    <a:gd name="connsiteX8" fmla="*/ 226 w 97589"/>
                    <a:gd name="connsiteY8" fmla="*/ 36970 h 109788"/>
                    <a:gd name="connsiteX9" fmla="*/ 36822 w 97589"/>
                    <a:gd name="connsiteY9" fmla="*/ 36970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9021" y="374"/>
                      </a:moveTo>
                      <a:lnTo>
                        <a:pt x="61219" y="36970"/>
                      </a:lnTo>
                      <a:lnTo>
                        <a:pt x="97815" y="36970"/>
                      </a:lnTo>
                      <a:lnTo>
                        <a:pt x="73418" y="61367"/>
                      </a:lnTo>
                      <a:lnTo>
                        <a:pt x="85617" y="110162"/>
                      </a:lnTo>
                      <a:lnTo>
                        <a:pt x="49021" y="73566"/>
                      </a:lnTo>
                      <a:lnTo>
                        <a:pt x="12425" y="110162"/>
                      </a:lnTo>
                      <a:lnTo>
                        <a:pt x="24623" y="61367"/>
                      </a:lnTo>
                      <a:lnTo>
                        <a:pt x="226" y="36970"/>
                      </a:lnTo>
                      <a:lnTo>
                        <a:pt x="36822" y="36970"/>
                      </a:lnTo>
                      <a:close/>
                    </a:path>
                  </a:pathLst>
                </a:custGeom>
                <a:solidFill>
                  <a:srgbClr val="800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41" name="Freeform: Shape 340">
                  <a:extLst>
                    <a:ext uri="{FF2B5EF4-FFF2-40B4-BE49-F238E27FC236}">
                      <a16:creationId xmlns:a16="http://schemas.microsoft.com/office/drawing/2014/main" id="{5B970650-C751-7AA6-02DC-48444344649D}"/>
                    </a:ext>
                  </a:extLst>
                </p:cNvPr>
                <p:cNvSpPr/>
                <p:nvPr/>
              </p:nvSpPr>
              <p:spPr>
                <a:xfrm>
                  <a:off x="3963027" y="5018725"/>
                  <a:ext cx="97589" cy="109788"/>
                </a:xfrm>
                <a:custGeom>
                  <a:avLst/>
                  <a:gdLst>
                    <a:gd name="connsiteX0" fmla="*/ 49021 w 97589"/>
                    <a:gd name="connsiteY0" fmla="*/ 374 h 109788"/>
                    <a:gd name="connsiteX1" fmla="*/ 61219 w 97589"/>
                    <a:gd name="connsiteY1" fmla="*/ 36970 h 109788"/>
                    <a:gd name="connsiteX2" fmla="*/ 97815 w 97589"/>
                    <a:gd name="connsiteY2" fmla="*/ 36970 h 109788"/>
                    <a:gd name="connsiteX3" fmla="*/ 73418 w 97589"/>
                    <a:gd name="connsiteY3" fmla="*/ 61367 h 109788"/>
                    <a:gd name="connsiteX4" fmla="*/ 85617 w 97589"/>
                    <a:gd name="connsiteY4" fmla="*/ 110162 h 109788"/>
                    <a:gd name="connsiteX5" fmla="*/ 49021 w 97589"/>
                    <a:gd name="connsiteY5" fmla="*/ 73566 h 109788"/>
                    <a:gd name="connsiteX6" fmla="*/ 12425 w 97589"/>
                    <a:gd name="connsiteY6" fmla="*/ 110162 h 109788"/>
                    <a:gd name="connsiteX7" fmla="*/ 24623 w 97589"/>
                    <a:gd name="connsiteY7" fmla="*/ 61367 h 109788"/>
                    <a:gd name="connsiteX8" fmla="*/ 226 w 97589"/>
                    <a:gd name="connsiteY8" fmla="*/ 36970 h 109788"/>
                    <a:gd name="connsiteX9" fmla="*/ 36822 w 97589"/>
                    <a:gd name="connsiteY9" fmla="*/ 36970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9021" y="374"/>
                      </a:moveTo>
                      <a:lnTo>
                        <a:pt x="61219" y="36970"/>
                      </a:lnTo>
                      <a:lnTo>
                        <a:pt x="97815" y="36970"/>
                      </a:lnTo>
                      <a:lnTo>
                        <a:pt x="73418" y="61367"/>
                      </a:lnTo>
                      <a:lnTo>
                        <a:pt x="85617" y="110162"/>
                      </a:lnTo>
                      <a:lnTo>
                        <a:pt x="49021" y="73566"/>
                      </a:lnTo>
                      <a:lnTo>
                        <a:pt x="12425" y="110162"/>
                      </a:lnTo>
                      <a:lnTo>
                        <a:pt x="24623" y="61367"/>
                      </a:lnTo>
                      <a:lnTo>
                        <a:pt x="226" y="36970"/>
                      </a:lnTo>
                      <a:lnTo>
                        <a:pt x="36822" y="36970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0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342" name="TextBox 341">
                <a:extLst>
                  <a:ext uri="{FF2B5EF4-FFF2-40B4-BE49-F238E27FC236}">
                    <a16:creationId xmlns:a16="http://schemas.microsoft.com/office/drawing/2014/main" id="{AE86C139-B60D-B2E0-031A-27D4D19A0984}"/>
                  </a:ext>
                </a:extLst>
              </p:cNvPr>
              <p:cNvSpPr txBox="1"/>
              <p:nvPr/>
            </p:nvSpPr>
            <p:spPr>
              <a:xfrm>
                <a:off x="3017681" y="4997403"/>
                <a:ext cx="58060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 dirty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M</a:t>
                </a:r>
                <a:r>
                  <a:rPr lang="en-US" altLang="zh-CN" sz="900" spc="0" baseline="0" dirty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ucosal</a:t>
                </a:r>
                <a:endParaRPr lang="en-US" sz="900" spc="0" baseline="0" dirty="0">
                  <a:ln/>
                  <a:solidFill>
                    <a:srgbClr val="000000"/>
                  </a:solidFill>
                  <a:latin typeface="MYingHei_18030_C-Medium"/>
                  <a:ea typeface="MYingHei_18030_C-Medium"/>
                  <a:cs typeface="MYingHei_18030_C-Medium"/>
                  <a:sym typeface="MYingHei_18030_C-Medium"/>
                  <a:rtl val="0"/>
                </a:endParaRPr>
              </a:p>
            </p:txBody>
          </p:sp>
          <p:sp>
            <p:nvSpPr>
              <p:cNvPr id="343" name="Freeform: Shape 342">
                <a:extLst>
                  <a:ext uri="{FF2B5EF4-FFF2-40B4-BE49-F238E27FC236}">
                    <a16:creationId xmlns:a16="http://schemas.microsoft.com/office/drawing/2014/main" id="{C630D9A8-E44D-F156-7169-C1A95F1FF5A0}"/>
                  </a:ext>
                </a:extLst>
              </p:cNvPr>
              <p:cNvSpPr/>
              <p:nvPr/>
            </p:nvSpPr>
            <p:spPr>
              <a:xfrm>
                <a:off x="2938339" y="5043123"/>
                <a:ext cx="73192" cy="73192"/>
              </a:xfrm>
              <a:custGeom>
                <a:avLst/>
                <a:gdLst>
                  <a:gd name="connsiteX0" fmla="*/ 36737 w 73192"/>
                  <a:gd name="connsiteY0" fmla="*/ 374 h 73192"/>
                  <a:gd name="connsiteX1" fmla="*/ 141 w 73192"/>
                  <a:gd name="connsiteY1" fmla="*/ 73566 h 73192"/>
                  <a:gd name="connsiteX2" fmla="*/ 73333 w 73192"/>
                  <a:gd name="connsiteY2" fmla="*/ 73566 h 731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3192" h="73192">
                    <a:moveTo>
                      <a:pt x="36737" y="374"/>
                    </a:moveTo>
                    <a:lnTo>
                      <a:pt x="141" y="73566"/>
                    </a:lnTo>
                    <a:lnTo>
                      <a:pt x="73333" y="73566"/>
                    </a:lnTo>
                    <a:close/>
                  </a:path>
                </a:pathLst>
              </a:custGeom>
              <a:solidFill>
                <a:srgbClr val="000000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44" name="TextBox 343">
                <a:extLst>
                  <a:ext uri="{FF2B5EF4-FFF2-40B4-BE49-F238E27FC236}">
                    <a16:creationId xmlns:a16="http://schemas.microsoft.com/office/drawing/2014/main" id="{634BBC70-43EC-5C6D-EB4B-F4258E8A3ECD}"/>
                  </a:ext>
                </a:extLst>
              </p:cNvPr>
              <p:cNvSpPr txBox="1"/>
              <p:nvPr/>
            </p:nvSpPr>
            <p:spPr>
              <a:xfrm>
                <a:off x="2419946" y="4997403"/>
                <a:ext cx="475648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EOT</a:t>
                </a:r>
              </a:p>
            </p:txBody>
          </p:sp>
          <p:grpSp>
            <p:nvGrpSpPr>
              <p:cNvPr id="345" name="Graphic 4">
                <a:extLst>
                  <a:ext uri="{FF2B5EF4-FFF2-40B4-BE49-F238E27FC236}">
                    <a16:creationId xmlns:a16="http://schemas.microsoft.com/office/drawing/2014/main" id="{D137432B-3FA3-39AE-2C75-2F5DC8D04776}"/>
                  </a:ext>
                </a:extLst>
              </p:cNvPr>
              <p:cNvGrpSpPr/>
              <p:nvPr/>
            </p:nvGrpSpPr>
            <p:grpSpPr>
              <a:xfrm>
                <a:off x="2328406" y="5018725"/>
                <a:ext cx="97589" cy="109788"/>
                <a:chOff x="2328406" y="5018725"/>
                <a:chExt cx="97589" cy="109788"/>
              </a:xfrm>
            </p:grpSpPr>
            <p:sp>
              <p:nvSpPr>
                <p:cNvPr id="346" name="Freeform: Shape 345">
                  <a:extLst>
                    <a:ext uri="{FF2B5EF4-FFF2-40B4-BE49-F238E27FC236}">
                      <a16:creationId xmlns:a16="http://schemas.microsoft.com/office/drawing/2014/main" id="{1D4FAC25-AF7D-7591-A67E-5C2CA7207742}"/>
                    </a:ext>
                  </a:extLst>
                </p:cNvPr>
                <p:cNvSpPr/>
                <p:nvPr/>
              </p:nvSpPr>
              <p:spPr>
                <a:xfrm>
                  <a:off x="2328406" y="5018725"/>
                  <a:ext cx="97589" cy="109788"/>
                </a:xfrm>
                <a:custGeom>
                  <a:avLst/>
                  <a:gdLst>
                    <a:gd name="connsiteX0" fmla="*/ 48887 w 97589"/>
                    <a:gd name="connsiteY0" fmla="*/ 374 h 109788"/>
                    <a:gd name="connsiteX1" fmla="*/ 61085 w 97589"/>
                    <a:gd name="connsiteY1" fmla="*/ 36970 h 109788"/>
                    <a:gd name="connsiteX2" fmla="*/ 97681 w 97589"/>
                    <a:gd name="connsiteY2" fmla="*/ 36970 h 109788"/>
                    <a:gd name="connsiteX3" fmla="*/ 73284 w 97589"/>
                    <a:gd name="connsiteY3" fmla="*/ 61367 h 109788"/>
                    <a:gd name="connsiteX4" fmla="*/ 85483 w 97589"/>
                    <a:gd name="connsiteY4" fmla="*/ 110162 h 109788"/>
                    <a:gd name="connsiteX5" fmla="*/ 48887 w 97589"/>
                    <a:gd name="connsiteY5" fmla="*/ 73566 h 109788"/>
                    <a:gd name="connsiteX6" fmla="*/ 12291 w 97589"/>
                    <a:gd name="connsiteY6" fmla="*/ 110162 h 109788"/>
                    <a:gd name="connsiteX7" fmla="*/ 24489 w 97589"/>
                    <a:gd name="connsiteY7" fmla="*/ 61367 h 109788"/>
                    <a:gd name="connsiteX8" fmla="*/ 92 w 97589"/>
                    <a:gd name="connsiteY8" fmla="*/ 36970 h 109788"/>
                    <a:gd name="connsiteX9" fmla="*/ 36688 w 97589"/>
                    <a:gd name="connsiteY9" fmla="*/ 36970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87" y="374"/>
                      </a:moveTo>
                      <a:lnTo>
                        <a:pt x="61085" y="36970"/>
                      </a:lnTo>
                      <a:lnTo>
                        <a:pt x="97681" y="36970"/>
                      </a:lnTo>
                      <a:lnTo>
                        <a:pt x="73284" y="61367"/>
                      </a:lnTo>
                      <a:lnTo>
                        <a:pt x="85483" y="110162"/>
                      </a:lnTo>
                      <a:lnTo>
                        <a:pt x="48887" y="73566"/>
                      </a:lnTo>
                      <a:lnTo>
                        <a:pt x="12291" y="110162"/>
                      </a:lnTo>
                      <a:lnTo>
                        <a:pt x="24489" y="61367"/>
                      </a:lnTo>
                      <a:lnTo>
                        <a:pt x="92" y="36970"/>
                      </a:lnTo>
                      <a:lnTo>
                        <a:pt x="36688" y="36970"/>
                      </a:lnTo>
                      <a:close/>
                    </a:path>
                  </a:pathLst>
                </a:custGeom>
                <a:solidFill>
                  <a:srgbClr val="808080"/>
                </a:solidFill>
                <a:ln w="12185" cap="flat">
                  <a:noFill/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  <p:sp>
              <p:nvSpPr>
                <p:cNvPr id="347" name="Freeform: Shape 346">
                  <a:extLst>
                    <a:ext uri="{FF2B5EF4-FFF2-40B4-BE49-F238E27FC236}">
                      <a16:creationId xmlns:a16="http://schemas.microsoft.com/office/drawing/2014/main" id="{A6F7AE5F-5CC7-203F-F97C-10CBCF55F89E}"/>
                    </a:ext>
                  </a:extLst>
                </p:cNvPr>
                <p:cNvSpPr/>
                <p:nvPr/>
              </p:nvSpPr>
              <p:spPr>
                <a:xfrm>
                  <a:off x="2328406" y="5018725"/>
                  <a:ext cx="97589" cy="109788"/>
                </a:xfrm>
                <a:custGeom>
                  <a:avLst/>
                  <a:gdLst>
                    <a:gd name="connsiteX0" fmla="*/ 48887 w 97589"/>
                    <a:gd name="connsiteY0" fmla="*/ 374 h 109788"/>
                    <a:gd name="connsiteX1" fmla="*/ 61085 w 97589"/>
                    <a:gd name="connsiteY1" fmla="*/ 36970 h 109788"/>
                    <a:gd name="connsiteX2" fmla="*/ 97681 w 97589"/>
                    <a:gd name="connsiteY2" fmla="*/ 36970 h 109788"/>
                    <a:gd name="connsiteX3" fmla="*/ 73284 w 97589"/>
                    <a:gd name="connsiteY3" fmla="*/ 61367 h 109788"/>
                    <a:gd name="connsiteX4" fmla="*/ 85483 w 97589"/>
                    <a:gd name="connsiteY4" fmla="*/ 110162 h 109788"/>
                    <a:gd name="connsiteX5" fmla="*/ 48887 w 97589"/>
                    <a:gd name="connsiteY5" fmla="*/ 73566 h 109788"/>
                    <a:gd name="connsiteX6" fmla="*/ 12291 w 97589"/>
                    <a:gd name="connsiteY6" fmla="*/ 110162 h 109788"/>
                    <a:gd name="connsiteX7" fmla="*/ 24489 w 97589"/>
                    <a:gd name="connsiteY7" fmla="*/ 61367 h 109788"/>
                    <a:gd name="connsiteX8" fmla="*/ 92 w 97589"/>
                    <a:gd name="connsiteY8" fmla="*/ 36970 h 109788"/>
                    <a:gd name="connsiteX9" fmla="*/ 36688 w 97589"/>
                    <a:gd name="connsiteY9" fmla="*/ 36970 h 10978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97589" h="109788">
                      <a:moveTo>
                        <a:pt x="48887" y="374"/>
                      </a:moveTo>
                      <a:lnTo>
                        <a:pt x="61085" y="36970"/>
                      </a:lnTo>
                      <a:lnTo>
                        <a:pt x="97681" y="36970"/>
                      </a:lnTo>
                      <a:lnTo>
                        <a:pt x="73284" y="61367"/>
                      </a:lnTo>
                      <a:lnTo>
                        <a:pt x="85483" y="110162"/>
                      </a:lnTo>
                      <a:lnTo>
                        <a:pt x="48887" y="73566"/>
                      </a:lnTo>
                      <a:lnTo>
                        <a:pt x="12291" y="110162"/>
                      </a:lnTo>
                      <a:lnTo>
                        <a:pt x="24489" y="61367"/>
                      </a:lnTo>
                      <a:lnTo>
                        <a:pt x="92" y="36970"/>
                      </a:lnTo>
                      <a:lnTo>
                        <a:pt x="36688" y="36970"/>
                      </a:lnTo>
                      <a:close/>
                    </a:path>
                  </a:pathLst>
                </a:custGeom>
                <a:noFill/>
                <a:ln w="12185" cap="sq">
                  <a:solidFill>
                    <a:srgbClr val="808080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/>
                </a:p>
              </p:txBody>
            </p:sp>
          </p:grp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889EF00D-8418-CB1D-7CF4-63A6920F51CD}"/>
                  </a:ext>
                </a:extLst>
              </p:cNvPr>
              <p:cNvSpPr txBox="1"/>
              <p:nvPr/>
            </p:nvSpPr>
            <p:spPr>
              <a:xfrm>
                <a:off x="1785615" y="4997403"/>
                <a:ext cx="512244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Alive</a:t>
                </a:r>
              </a:p>
            </p:txBody>
          </p:sp>
          <p:sp>
            <p:nvSpPr>
              <p:cNvPr id="349" name="Freeform: Shape 348">
                <a:extLst>
                  <a:ext uri="{FF2B5EF4-FFF2-40B4-BE49-F238E27FC236}">
                    <a16:creationId xmlns:a16="http://schemas.microsoft.com/office/drawing/2014/main" id="{0DB17483-5471-DA28-3F9A-B92AEE0EF265}"/>
                  </a:ext>
                </a:extLst>
              </p:cNvPr>
              <p:cNvSpPr/>
              <p:nvPr/>
            </p:nvSpPr>
            <p:spPr>
              <a:xfrm>
                <a:off x="1633082" y="5030924"/>
                <a:ext cx="146384" cy="146384"/>
              </a:xfrm>
              <a:custGeom>
                <a:avLst/>
                <a:gdLst>
                  <a:gd name="connsiteX0" fmla="*/ 146418 w 146384"/>
                  <a:gd name="connsiteY0" fmla="*/ 73566 h 146384"/>
                  <a:gd name="connsiteX1" fmla="*/ 34 w 146384"/>
                  <a:gd name="connsiteY1" fmla="*/ 374 h 146384"/>
                  <a:gd name="connsiteX2" fmla="*/ 34 w 146384"/>
                  <a:gd name="connsiteY2" fmla="*/ 146758 h 1463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6384" h="146384">
                    <a:moveTo>
                      <a:pt x="146418" y="73566"/>
                    </a:moveTo>
                    <a:lnTo>
                      <a:pt x="34" y="374"/>
                    </a:lnTo>
                    <a:lnTo>
                      <a:pt x="34" y="146758"/>
                    </a:lnTo>
                    <a:close/>
                  </a:path>
                </a:pathLst>
              </a:custGeom>
              <a:solidFill>
                <a:srgbClr val="A9A9A9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50" name="TextBox 349">
                <a:extLst>
                  <a:ext uri="{FF2B5EF4-FFF2-40B4-BE49-F238E27FC236}">
                    <a16:creationId xmlns:a16="http://schemas.microsoft.com/office/drawing/2014/main" id="{B8AB2894-FDAD-F7F0-0EB0-FD0E6EEF338B}"/>
                  </a:ext>
                </a:extLst>
              </p:cNvPr>
              <p:cNvSpPr txBox="1"/>
              <p:nvPr/>
            </p:nvSpPr>
            <p:spPr>
              <a:xfrm>
                <a:off x="5676990" y="4765628"/>
                <a:ext cx="1378349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Rechallenge Start</a:t>
                </a:r>
              </a:p>
            </p:txBody>
          </p:sp>
          <p:sp>
            <p:nvSpPr>
              <p:cNvPr id="351" name="Freeform: Shape 350">
                <a:extLst>
                  <a:ext uri="{FF2B5EF4-FFF2-40B4-BE49-F238E27FC236}">
                    <a16:creationId xmlns:a16="http://schemas.microsoft.com/office/drawing/2014/main" id="{AEA5ED50-DE3C-4036-C400-6D6FBC0E8D40}"/>
                  </a:ext>
                </a:extLst>
              </p:cNvPr>
              <p:cNvSpPr/>
              <p:nvPr/>
            </p:nvSpPr>
            <p:spPr>
              <a:xfrm>
                <a:off x="5597649" y="4823547"/>
                <a:ext cx="73192" cy="73192"/>
              </a:xfrm>
              <a:custGeom>
                <a:avLst/>
                <a:gdLst>
                  <a:gd name="connsiteX0" fmla="*/ 73551 w 73192"/>
                  <a:gd name="connsiteY0" fmla="*/ 36952 h 73192"/>
                  <a:gd name="connsiteX1" fmla="*/ 36955 w 73192"/>
                  <a:gd name="connsiteY1" fmla="*/ 73548 h 73192"/>
                  <a:gd name="connsiteX2" fmla="*/ 359 w 73192"/>
                  <a:gd name="connsiteY2" fmla="*/ 36952 h 73192"/>
                  <a:gd name="connsiteX3" fmla="*/ 36955 w 73192"/>
                  <a:gd name="connsiteY3" fmla="*/ 356 h 73192"/>
                  <a:gd name="connsiteX4" fmla="*/ 73551 w 73192"/>
                  <a:gd name="connsiteY4" fmla="*/ 36952 h 731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3192" h="73192">
                    <a:moveTo>
                      <a:pt x="73551" y="36952"/>
                    </a:moveTo>
                    <a:cubicBezTo>
                      <a:pt x="73551" y="57163"/>
                      <a:pt x="57166" y="73548"/>
                      <a:pt x="36955" y="73548"/>
                    </a:cubicBezTo>
                    <a:cubicBezTo>
                      <a:pt x="16744" y="73548"/>
                      <a:pt x="359" y="57163"/>
                      <a:pt x="359" y="36952"/>
                    </a:cubicBezTo>
                    <a:cubicBezTo>
                      <a:pt x="359" y="16741"/>
                      <a:pt x="16744" y="356"/>
                      <a:pt x="36955" y="356"/>
                    </a:cubicBezTo>
                    <a:cubicBezTo>
                      <a:pt x="57166" y="356"/>
                      <a:pt x="73551" y="16741"/>
                      <a:pt x="73551" y="3695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52" name="TextBox 351">
                <a:extLst>
                  <a:ext uri="{FF2B5EF4-FFF2-40B4-BE49-F238E27FC236}">
                    <a16:creationId xmlns:a16="http://schemas.microsoft.com/office/drawing/2014/main" id="{1E3D6205-796A-21EB-0F81-FC2C2EDB3FD9}"/>
                  </a:ext>
                </a:extLst>
              </p:cNvPr>
              <p:cNvSpPr txBox="1"/>
              <p:nvPr/>
            </p:nvSpPr>
            <p:spPr>
              <a:xfrm>
                <a:off x="4054567" y="4765628"/>
                <a:ext cx="390257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PD</a:t>
                </a:r>
              </a:p>
            </p:txBody>
          </p:sp>
          <p:sp>
            <p:nvSpPr>
              <p:cNvPr id="353" name="Freeform: Shape 352">
                <a:extLst>
                  <a:ext uri="{FF2B5EF4-FFF2-40B4-BE49-F238E27FC236}">
                    <a16:creationId xmlns:a16="http://schemas.microsoft.com/office/drawing/2014/main" id="{9044DEE2-DBD8-0B22-4A21-B9C6D61A0067}"/>
                  </a:ext>
                </a:extLst>
              </p:cNvPr>
              <p:cNvSpPr/>
              <p:nvPr/>
            </p:nvSpPr>
            <p:spPr>
              <a:xfrm>
                <a:off x="3975226" y="4823547"/>
                <a:ext cx="60993" cy="60993"/>
              </a:xfrm>
              <a:custGeom>
                <a:avLst/>
                <a:gdLst>
                  <a:gd name="connsiteX0" fmla="*/ 226 w 60993"/>
                  <a:gd name="connsiteY0" fmla="*/ 356 h 60993"/>
                  <a:gd name="connsiteX1" fmla="*/ 61219 w 60993"/>
                  <a:gd name="connsiteY1" fmla="*/ 356 h 60993"/>
                  <a:gd name="connsiteX2" fmla="*/ 61219 w 60993"/>
                  <a:gd name="connsiteY2" fmla="*/ 61349 h 60993"/>
                  <a:gd name="connsiteX3" fmla="*/ 226 w 60993"/>
                  <a:gd name="connsiteY3" fmla="*/ 61349 h 609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993" h="60993">
                    <a:moveTo>
                      <a:pt x="226" y="356"/>
                    </a:moveTo>
                    <a:lnTo>
                      <a:pt x="61219" y="356"/>
                    </a:lnTo>
                    <a:lnTo>
                      <a:pt x="61219" y="61349"/>
                    </a:lnTo>
                    <a:lnTo>
                      <a:pt x="226" y="61349"/>
                    </a:lnTo>
                    <a:close/>
                  </a:path>
                </a:pathLst>
              </a:custGeom>
              <a:solidFill>
                <a:srgbClr val="FFFF00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54" name="TextBox 353">
                <a:extLst>
                  <a:ext uri="{FF2B5EF4-FFF2-40B4-BE49-F238E27FC236}">
                    <a16:creationId xmlns:a16="http://schemas.microsoft.com/office/drawing/2014/main" id="{28B0BE5B-2720-722B-B773-39E0A917C9D7}"/>
                  </a:ext>
                </a:extLst>
              </p:cNvPr>
              <p:cNvSpPr txBox="1"/>
              <p:nvPr/>
            </p:nvSpPr>
            <p:spPr>
              <a:xfrm>
                <a:off x="3017681" y="4765628"/>
                <a:ext cx="390257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SD</a:t>
                </a:r>
              </a:p>
            </p:txBody>
          </p:sp>
          <p:sp>
            <p:nvSpPr>
              <p:cNvPr id="355" name="Freeform: Shape 354">
                <a:extLst>
                  <a:ext uri="{FF2B5EF4-FFF2-40B4-BE49-F238E27FC236}">
                    <a16:creationId xmlns:a16="http://schemas.microsoft.com/office/drawing/2014/main" id="{E16F391E-631B-6B35-3BF7-EE0EE5100E2D}"/>
                  </a:ext>
                </a:extLst>
              </p:cNvPr>
              <p:cNvSpPr/>
              <p:nvPr/>
            </p:nvSpPr>
            <p:spPr>
              <a:xfrm>
                <a:off x="2938339" y="4823547"/>
                <a:ext cx="60993" cy="60993"/>
              </a:xfrm>
              <a:custGeom>
                <a:avLst/>
                <a:gdLst>
                  <a:gd name="connsiteX0" fmla="*/ 141 w 60993"/>
                  <a:gd name="connsiteY0" fmla="*/ 356 h 60993"/>
                  <a:gd name="connsiteX1" fmla="*/ 61134 w 60993"/>
                  <a:gd name="connsiteY1" fmla="*/ 356 h 60993"/>
                  <a:gd name="connsiteX2" fmla="*/ 61134 w 60993"/>
                  <a:gd name="connsiteY2" fmla="*/ 61349 h 60993"/>
                  <a:gd name="connsiteX3" fmla="*/ 141 w 60993"/>
                  <a:gd name="connsiteY3" fmla="*/ 61349 h 609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993" h="60993">
                    <a:moveTo>
                      <a:pt x="141" y="356"/>
                    </a:moveTo>
                    <a:lnTo>
                      <a:pt x="61134" y="356"/>
                    </a:lnTo>
                    <a:lnTo>
                      <a:pt x="61134" y="61349"/>
                    </a:lnTo>
                    <a:lnTo>
                      <a:pt x="141" y="61349"/>
                    </a:lnTo>
                    <a:close/>
                  </a:path>
                </a:pathLst>
              </a:custGeom>
              <a:solidFill>
                <a:srgbClr val="008000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56" name="TextBox 355">
                <a:extLst>
                  <a:ext uri="{FF2B5EF4-FFF2-40B4-BE49-F238E27FC236}">
                    <a16:creationId xmlns:a16="http://schemas.microsoft.com/office/drawing/2014/main" id="{DA46A21A-1E24-01E7-D8D9-3FAAE342722E}"/>
                  </a:ext>
                </a:extLst>
              </p:cNvPr>
              <p:cNvSpPr txBox="1"/>
              <p:nvPr/>
            </p:nvSpPr>
            <p:spPr>
              <a:xfrm>
                <a:off x="2419946" y="4765628"/>
                <a:ext cx="390257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PR</a:t>
                </a:r>
              </a:p>
            </p:txBody>
          </p:sp>
          <p:sp>
            <p:nvSpPr>
              <p:cNvPr id="357" name="Freeform: Shape 356">
                <a:extLst>
                  <a:ext uri="{FF2B5EF4-FFF2-40B4-BE49-F238E27FC236}">
                    <a16:creationId xmlns:a16="http://schemas.microsoft.com/office/drawing/2014/main" id="{D779C68B-2273-E3FC-7EE7-35DED795B7DB}"/>
                  </a:ext>
                </a:extLst>
              </p:cNvPr>
              <p:cNvSpPr/>
              <p:nvPr/>
            </p:nvSpPr>
            <p:spPr>
              <a:xfrm>
                <a:off x="2340605" y="4823547"/>
                <a:ext cx="60993" cy="60993"/>
              </a:xfrm>
              <a:custGeom>
                <a:avLst/>
                <a:gdLst>
                  <a:gd name="connsiteX0" fmla="*/ 92 w 60993"/>
                  <a:gd name="connsiteY0" fmla="*/ 356 h 60993"/>
                  <a:gd name="connsiteX1" fmla="*/ 61085 w 60993"/>
                  <a:gd name="connsiteY1" fmla="*/ 356 h 60993"/>
                  <a:gd name="connsiteX2" fmla="*/ 61085 w 60993"/>
                  <a:gd name="connsiteY2" fmla="*/ 61349 h 60993"/>
                  <a:gd name="connsiteX3" fmla="*/ 92 w 60993"/>
                  <a:gd name="connsiteY3" fmla="*/ 61349 h 609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993" h="60993">
                    <a:moveTo>
                      <a:pt x="92" y="356"/>
                    </a:moveTo>
                    <a:lnTo>
                      <a:pt x="61085" y="356"/>
                    </a:lnTo>
                    <a:lnTo>
                      <a:pt x="61085" y="61349"/>
                    </a:lnTo>
                    <a:lnTo>
                      <a:pt x="92" y="61349"/>
                    </a:lnTo>
                    <a:close/>
                  </a:path>
                </a:pathLst>
              </a:custGeom>
              <a:solidFill>
                <a:srgbClr val="0000FF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2231F148-7DC4-DCA8-399C-D1117849CBF1}"/>
                  </a:ext>
                </a:extLst>
              </p:cNvPr>
              <p:cNvSpPr txBox="1"/>
              <p:nvPr/>
            </p:nvSpPr>
            <p:spPr>
              <a:xfrm>
                <a:off x="1785615" y="4765628"/>
                <a:ext cx="402456" cy="237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en-US" sz="900" spc="0" baseline="0">
                    <a:ln/>
                    <a:solidFill>
                      <a:srgbClr val="000000"/>
                    </a:solidFill>
                    <a:latin typeface="MYingHei_18030_C-Medium"/>
                    <a:ea typeface="MYingHei_18030_C-Medium"/>
                    <a:cs typeface="MYingHei_18030_C-Medium"/>
                    <a:sym typeface="MYingHei_18030_C-Medium"/>
                    <a:rtl val="0"/>
                  </a:rPr>
                  <a:t>CR</a:t>
                </a:r>
              </a:p>
            </p:txBody>
          </p:sp>
          <p:sp>
            <p:nvSpPr>
              <p:cNvPr id="359" name="Freeform: Shape 358">
                <a:extLst>
                  <a:ext uri="{FF2B5EF4-FFF2-40B4-BE49-F238E27FC236}">
                    <a16:creationId xmlns:a16="http://schemas.microsoft.com/office/drawing/2014/main" id="{F7FAF582-6BED-DB47-0484-9390F27068DC}"/>
                  </a:ext>
                </a:extLst>
              </p:cNvPr>
              <p:cNvSpPr/>
              <p:nvPr/>
            </p:nvSpPr>
            <p:spPr>
              <a:xfrm>
                <a:off x="1669678" y="4823547"/>
                <a:ext cx="60993" cy="60993"/>
              </a:xfrm>
              <a:custGeom>
                <a:avLst/>
                <a:gdLst>
                  <a:gd name="connsiteX0" fmla="*/ 37 w 60993"/>
                  <a:gd name="connsiteY0" fmla="*/ 356 h 60993"/>
                  <a:gd name="connsiteX1" fmla="*/ 61030 w 60993"/>
                  <a:gd name="connsiteY1" fmla="*/ 356 h 60993"/>
                  <a:gd name="connsiteX2" fmla="*/ 61030 w 60993"/>
                  <a:gd name="connsiteY2" fmla="*/ 61349 h 60993"/>
                  <a:gd name="connsiteX3" fmla="*/ 37 w 60993"/>
                  <a:gd name="connsiteY3" fmla="*/ 61349 h 609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0993" h="60993">
                    <a:moveTo>
                      <a:pt x="37" y="356"/>
                    </a:moveTo>
                    <a:lnTo>
                      <a:pt x="61030" y="356"/>
                    </a:lnTo>
                    <a:lnTo>
                      <a:pt x="61030" y="61349"/>
                    </a:lnTo>
                    <a:lnTo>
                      <a:pt x="37" y="61349"/>
                    </a:lnTo>
                    <a:close/>
                  </a:path>
                </a:pathLst>
              </a:custGeom>
              <a:solidFill>
                <a:srgbClr val="FF0000"/>
              </a:solidFill>
              <a:ln w="12185" cap="flat">
                <a:noFill/>
                <a:prstDash val="solid"/>
                <a:miter/>
              </a:ln>
            </p:spPr>
            <p:txBody>
              <a:bodyPr rtlCol="0" anchor="ctr"/>
              <a:lstStyle/>
              <a:p>
                <a:endParaRPr lang="en-US"/>
              </a:p>
            </p:txBody>
          </p:sp>
        </p:grpSp>
      </p:grpSp>
      <p:sp>
        <p:nvSpPr>
          <p:cNvPr id="360" name="Freeform: Shape 359">
            <a:extLst>
              <a:ext uri="{FF2B5EF4-FFF2-40B4-BE49-F238E27FC236}">
                <a16:creationId xmlns:a16="http://schemas.microsoft.com/office/drawing/2014/main" id="{AF8AFB34-1AC3-9A7A-3EC2-53D92BD8BE23}"/>
              </a:ext>
            </a:extLst>
          </p:cNvPr>
          <p:cNvSpPr/>
          <p:nvPr/>
        </p:nvSpPr>
        <p:spPr>
          <a:xfrm>
            <a:off x="7986260" y="6715873"/>
            <a:ext cx="7807147" cy="5855360"/>
          </a:xfrm>
          <a:custGeom>
            <a:avLst/>
            <a:gdLst>
              <a:gd name="connsiteX0" fmla="*/ 0 w 7807147"/>
              <a:gd name="connsiteY0" fmla="*/ 0 h 5855360"/>
              <a:gd name="connsiteX1" fmla="*/ 7807148 w 7807147"/>
              <a:gd name="connsiteY1" fmla="*/ 0 h 5855360"/>
              <a:gd name="connsiteX2" fmla="*/ 7807148 w 7807147"/>
              <a:gd name="connsiteY2" fmla="*/ 5855361 h 5855360"/>
              <a:gd name="connsiteX3" fmla="*/ 0 w 7807147"/>
              <a:gd name="connsiteY3" fmla="*/ 5855361 h 58553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07147" h="5855360">
                <a:moveTo>
                  <a:pt x="0" y="0"/>
                </a:moveTo>
                <a:lnTo>
                  <a:pt x="7807148" y="0"/>
                </a:lnTo>
                <a:lnTo>
                  <a:pt x="7807148" y="5855361"/>
                </a:lnTo>
                <a:lnTo>
                  <a:pt x="0" y="5855361"/>
                </a:lnTo>
                <a:close/>
              </a:path>
            </a:pathLst>
          </a:custGeom>
          <a:solidFill>
            <a:srgbClr val="FFFFFF">
              <a:alpha val="0"/>
            </a:srgbClr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1" name="Freeform: Shape 160">
            <a:extLst>
              <a:ext uri="{FF2B5EF4-FFF2-40B4-BE49-F238E27FC236}">
                <a16:creationId xmlns:a16="http://schemas.microsoft.com/office/drawing/2014/main" id="{CB39196C-8950-4604-9941-F072DA602180}"/>
              </a:ext>
            </a:extLst>
          </p:cNvPr>
          <p:cNvSpPr/>
          <p:nvPr/>
        </p:nvSpPr>
        <p:spPr>
          <a:xfrm>
            <a:off x="6182280" y="79898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3" name="Freeform: Shape 237">
            <a:extLst>
              <a:ext uri="{FF2B5EF4-FFF2-40B4-BE49-F238E27FC236}">
                <a16:creationId xmlns:a16="http://schemas.microsoft.com/office/drawing/2014/main" id="{0A5752B1-367A-4C92-9D1D-5FAD161F5065}"/>
              </a:ext>
            </a:extLst>
          </p:cNvPr>
          <p:cNvSpPr/>
          <p:nvPr/>
        </p:nvSpPr>
        <p:spPr>
          <a:xfrm>
            <a:off x="5614124" y="797078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4" name="Freeform: Shape 166">
            <a:extLst>
              <a:ext uri="{FF2B5EF4-FFF2-40B4-BE49-F238E27FC236}">
                <a16:creationId xmlns:a16="http://schemas.microsoft.com/office/drawing/2014/main" id="{C500BE6C-687E-4192-9A27-DE70FE4E2766}"/>
              </a:ext>
            </a:extLst>
          </p:cNvPr>
          <p:cNvSpPr/>
          <p:nvPr/>
        </p:nvSpPr>
        <p:spPr>
          <a:xfrm>
            <a:off x="7028011" y="795808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5" name="Freeform: Shape 169">
            <a:extLst>
              <a:ext uri="{FF2B5EF4-FFF2-40B4-BE49-F238E27FC236}">
                <a16:creationId xmlns:a16="http://schemas.microsoft.com/office/drawing/2014/main" id="{344DBB01-CC32-4095-8C75-DDE37A4DE0A1}"/>
              </a:ext>
            </a:extLst>
          </p:cNvPr>
          <p:cNvSpPr/>
          <p:nvPr/>
        </p:nvSpPr>
        <p:spPr>
          <a:xfrm>
            <a:off x="7733346" y="801484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6" name="Freeform: Shape 156">
            <a:extLst>
              <a:ext uri="{FF2B5EF4-FFF2-40B4-BE49-F238E27FC236}">
                <a16:creationId xmlns:a16="http://schemas.microsoft.com/office/drawing/2014/main" id="{8653BD68-0B7C-43CF-BB8E-AD4099AD2FFA}"/>
              </a:ext>
            </a:extLst>
          </p:cNvPr>
          <p:cNvSpPr/>
          <p:nvPr/>
        </p:nvSpPr>
        <p:spPr>
          <a:xfrm>
            <a:off x="8099324" y="1099007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7" name="Freeform: Shape 166">
            <a:extLst>
              <a:ext uri="{FF2B5EF4-FFF2-40B4-BE49-F238E27FC236}">
                <a16:creationId xmlns:a16="http://schemas.microsoft.com/office/drawing/2014/main" id="{4B6B8FD6-6895-444C-A57A-5CA53A079450}"/>
              </a:ext>
            </a:extLst>
          </p:cNvPr>
          <p:cNvSpPr/>
          <p:nvPr/>
        </p:nvSpPr>
        <p:spPr>
          <a:xfrm>
            <a:off x="7341274" y="109583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8" name="Freeform: Shape 169">
            <a:extLst>
              <a:ext uri="{FF2B5EF4-FFF2-40B4-BE49-F238E27FC236}">
                <a16:creationId xmlns:a16="http://schemas.microsoft.com/office/drawing/2014/main" id="{8397F475-19B3-4471-B7EB-A9DE0E5F403B}"/>
              </a:ext>
            </a:extLst>
          </p:cNvPr>
          <p:cNvSpPr/>
          <p:nvPr/>
        </p:nvSpPr>
        <p:spPr>
          <a:xfrm>
            <a:off x="7643857" y="109583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69" name="Freeform: Shape 166">
            <a:extLst>
              <a:ext uri="{FF2B5EF4-FFF2-40B4-BE49-F238E27FC236}">
                <a16:creationId xmlns:a16="http://schemas.microsoft.com/office/drawing/2014/main" id="{05BC6215-58C8-4E8C-858E-000AB8655720}"/>
              </a:ext>
            </a:extLst>
          </p:cNvPr>
          <p:cNvSpPr/>
          <p:nvPr/>
        </p:nvSpPr>
        <p:spPr>
          <a:xfrm>
            <a:off x="6796908" y="1094937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0" name="Freeform: Shape 169">
            <a:extLst>
              <a:ext uri="{FF2B5EF4-FFF2-40B4-BE49-F238E27FC236}">
                <a16:creationId xmlns:a16="http://schemas.microsoft.com/office/drawing/2014/main" id="{00D0AF95-CAD0-4E1E-9C13-449297C368C4}"/>
              </a:ext>
            </a:extLst>
          </p:cNvPr>
          <p:cNvSpPr/>
          <p:nvPr/>
        </p:nvSpPr>
        <p:spPr>
          <a:xfrm>
            <a:off x="7068726" y="1094459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1" name="Freeform: Shape 166">
            <a:extLst>
              <a:ext uri="{FF2B5EF4-FFF2-40B4-BE49-F238E27FC236}">
                <a16:creationId xmlns:a16="http://schemas.microsoft.com/office/drawing/2014/main" id="{727A4F1F-C919-4EC7-A081-C30EAD70512E}"/>
              </a:ext>
            </a:extLst>
          </p:cNvPr>
          <p:cNvSpPr/>
          <p:nvPr/>
        </p:nvSpPr>
        <p:spPr>
          <a:xfrm>
            <a:off x="6244411" y="1097143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2" name="Freeform: Shape 169">
            <a:extLst>
              <a:ext uri="{FF2B5EF4-FFF2-40B4-BE49-F238E27FC236}">
                <a16:creationId xmlns:a16="http://schemas.microsoft.com/office/drawing/2014/main" id="{CD5C3EB0-BECE-4FD0-801F-ABB80E7CD292}"/>
              </a:ext>
            </a:extLst>
          </p:cNvPr>
          <p:cNvSpPr/>
          <p:nvPr/>
        </p:nvSpPr>
        <p:spPr>
          <a:xfrm>
            <a:off x="6521698" y="1094459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3" name="Freeform: Shape 237">
            <a:extLst>
              <a:ext uri="{FF2B5EF4-FFF2-40B4-BE49-F238E27FC236}">
                <a16:creationId xmlns:a16="http://schemas.microsoft.com/office/drawing/2014/main" id="{A755101E-2949-4E2E-8640-9322E2FF21DC}"/>
              </a:ext>
            </a:extLst>
          </p:cNvPr>
          <p:cNvSpPr/>
          <p:nvPr/>
        </p:nvSpPr>
        <p:spPr>
          <a:xfrm>
            <a:off x="6001279" y="1087310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4" name="Freeform: Shape 237">
            <a:extLst>
              <a:ext uri="{FF2B5EF4-FFF2-40B4-BE49-F238E27FC236}">
                <a16:creationId xmlns:a16="http://schemas.microsoft.com/office/drawing/2014/main" id="{AAFA6029-D65C-490F-ADB9-5AD4E9595E6A}"/>
              </a:ext>
            </a:extLst>
          </p:cNvPr>
          <p:cNvSpPr/>
          <p:nvPr/>
        </p:nvSpPr>
        <p:spPr>
          <a:xfrm>
            <a:off x="5017150" y="1402109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5" name="Freeform: Shape 237">
            <a:extLst>
              <a:ext uri="{FF2B5EF4-FFF2-40B4-BE49-F238E27FC236}">
                <a16:creationId xmlns:a16="http://schemas.microsoft.com/office/drawing/2014/main" id="{D702F5CF-A6E0-4ECA-8A39-4EAF7FF761F6}"/>
              </a:ext>
            </a:extLst>
          </p:cNvPr>
          <p:cNvSpPr/>
          <p:nvPr/>
        </p:nvSpPr>
        <p:spPr>
          <a:xfrm>
            <a:off x="6146978" y="1698537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6" name="Freeform: Shape 162">
            <a:extLst>
              <a:ext uri="{FF2B5EF4-FFF2-40B4-BE49-F238E27FC236}">
                <a16:creationId xmlns:a16="http://schemas.microsoft.com/office/drawing/2014/main" id="{818F9793-FF5A-45BE-9FCD-1CB1947F761A}"/>
              </a:ext>
            </a:extLst>
          </p:cNvPr>
          <p:cNvSpPr/>
          <p:nvPr/>
        </p:nvSpPr>
        <p:spPr>
          <a:xfrm>
            <a:off x="6765104" y="1698537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7" name="Freeform: Shape 162">
            <a:extLst>
              <a:ext uri="{FF2B5EF4-FFF2-40B4-BE49-F238E27FC236}">
                <a16:creationId xmlns:a16="http://schemas.microsoft.com/office/drawing/2014/main" id="{3A703555-6648-4D3E-AA96-72E1149076DD}"/>
              </a:ext>
            </a:extLst>
          </p:cNvPr>
          <p:cNvSpPr/>
          <p:nvPr/>
        </p:nvSpPr>
        <p:spPr>
          <a:xfrm>
            <a:off x="7032862" y="1697640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8" name="Freeform: Shape 168">
            <a:extLst>
              <a:ext uri="{FF2B5EF4-FFF2-40B4-BE49-F238E27FC236}">
                <a16:creationId xmlns:a16="http://schemas.microsoft.com/office/drawing/2014/main" id="{81898644-2346-47C9-A367-CD117B697B65}"/>
              </a:ext>
            </a:extLst>
          </p:cNvPr>
          <p:cNvSpPr/>
          <p:nvPr/>
        </p:nvSpPr>
        <p:spPr>
          <a:xfrm>
            <a:off x="8154350" y="1698045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79" name="Freeform: Shape 168">
            <a:extLst>
              <a:ext uri="{FF2B5EF4-FFF2-40B4-BE49-F238E27FC236}">
                <a16:creationId xmlns:a16="http://schemas.microsoft.com/office/drawing/2014/main" id="{1CFF4772-03C7-4BF2-AB0C-786937EE1284}"/>
              </a:ext>
            </a:extLst>
          </p:cNvPr>
          <p:cNvSpPr/>
          <p:nvPr/>
        </p:nvSpPr>
        <p:spPr>
          <a:xfrm>
            <a:off x="8387234" y="1698045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0" name="Freeform: Shape 169">
            <a:extLst>
              <a:ext uri="{FF2B5EF4-FFF2-40B4-BE49-F238E27FC236}">
                <a16:creationId xmlns:a16="http://schemas.microsoft.com/office/drawing/2014/main" id="{85984816-6976-4620-A5E6-A9E4CC01AC70}"/>
              </a:ext>
            </a:extLst>
          </p:cNvPr>
          <p:cNvSpPr/>
          <p:nvPr/>
        </p:nvSpPr>
        <p:spPr>
          <a:xfrm>
            <a:off x="7896325" y="109583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5 w 60993"/>
              <a:gd name="connsiteY1" fmla="*/ 11 h 60993"/>
              <a:gd name="connsiteX2" fmla="*/ 61005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5" y="11"/>
                </a:lnTo>
                <a:lnTo>
                  <a:pt x="61005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1" name="Freeform: Shape 202">
            <a:extLst>
              <a:ext uri="{FF2B5EF4-FFF2-40B4-BE49-F238E27FC236}">
                <a16:creationId xmlns:a16="http://schemas.microsoft.com/office/drawing/2014/main" id="{4DEBAC2D-9FDF-42A3-9A05-227AB69610CC}"/>
              </a:ext>
            </a:extLst>
          </p:cNvPr>
          <p:cNvSpPr/>
          <p:nvPr/>
        </p:nvSpPr>
        <p:spPr>
          <a:xfrm>
            <a:off x="5556713" y="1395809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80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382" name="Freeform: Shape 237">
            <a:extLst>
              <a:ext uri="{FF2B5EF4-FFF2-40B4-BE49-F238E27FC236}">
                <a16:creationId xmlns:a16="http://schemas.microsoft.com/office/drawing/2014/main" id="{CA0F19DE-50B6-4AD1-834E-25749BCA1D02}"/>
              </a:ext>
            </a:extLst>
          </p:cNvPr>
          <p:cNvSpPr/>
          <p:nvPr/>
        </p:nvSpPr>
        <p:spPr>
          <a:xfrm>
            <a:off x="6199514" y="2000443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3" name="Freeform: Shape 172">
            <a:extLst>
              <a:ext uri="{FF2B5EF4-FFF2-40B4-BE49-F238E27FC236}">
                <a16:creationId xmlns:a16="http://schemas.microsoft.com/office/drawing/2014/main" id="{66D7C3CE-3B07-4C23-9983-C9A6E93BA1AC}"/>
              </a:ext>
            </a:extLst>
          </p:cNvPr>
          <p:cNvSpPr/>
          <p:nvPr/>
        </p:nvSpPr>
        <p:spPr>
          <a:xfrm>
            <a:off x="8160785" y="200679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84" name="Freeform: Shape 172">
            <a:extLst>
              <a:ext uri="{FF2B5EF4-FFF2-40B4-BE49-F238E27FC236}">
                <a16:creationId xmlns:a16="http://schemas.microsoft.com/office/drawing/2014/main" id="{52FD5209-6A78-447F-AFC8-0C02B34F1FC2}"/>
              </a:ext>
            </a:extLst>
          </p:cNvPr>
          <p:cNvSpPr/>
          <p:nvPr/>
        </p:nvSpPr>
        <p:spPr>
          <a:xfrm>
            <a:off x="8407602" y="2004864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2" name="Freeform: Shape 137">
            <a:extLst>
              <a:ext uri="{FF2B5EF4-FFF2-40B4-BE49-F238E27FC236}">
                <a16:creationId xmlns:a16="http://schemas.microsoft.com/office/drawing/2014/main" id="{21E5D2B3-CC08-E339-2A2B-D40A0CF5218D}"/>
              </a:ext>
            </a:extLst>
          </p:cNvPr>
          <p:cNvSpPr/>
          <p:nvPr/>
        </p:nvSpPr>
        <p:spPr>
          <a:xfrm>
            <a:off x="4842478" y="4445892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0000FF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4" name="Freeform: Shape 259">
            <a:extLst>
              <a:ext uri="{FF2B5EF4-FFF2-40B4-BE49-F238E27FC236}">
                <a16:creationId xmlns:a16="http://schemas.microsoft.com/office/drawing/2014/main" id="{18C90FAE-BD44-B2A8-48F4-F987CC5C573B}"/>
              </a:ext>
            </a:extLst>
          </p:cNvPr>
          <p:cNvSpPr/>
          <p:nvPr/>
        </p:nvSpPr>
        <p:spPr>
          <a:xfrm>
            <a:off x="5093240" y="4395117"/>
            <a:ext cx="97589" cy="109788"/>
          </a:xfrm>
          <a:custGeom>
            <a:avLst/>
            <a:gdLst>
              <a:gd name="connsiteX0" fmla="*/ 48806 w 97589"/>
              <a:gd name="connsiteY0" fmla="*/ 11 h 109788"/>
              <a:gd name="connsiteX1" fmla="*/ 61004 w 97589"/>
              <a:gd name="connsiteY1" fmla="*/ 36607 h 109788"/>
              <a:gd name="connsiteX2" fmla="*/ 97600 w 97589"/>
              <a:gd name="connsiteY2" fmla="*/ 36607 h 109788"/>
              <a:gd name="connsiteX3" fmla="*/ 73203 w 97589"/>
              <a:gd name="connsiteY3" fmla="*/ 61004 h 109788"/>
              <a:gd name="connsiteX4" fmla="*/ 85402 w 97589"/>
              <a:gd name="connsiteY4" fmla="*/ 109799 h 109788"/>
              <a:gd name="connsiteX5" fmla="*/ 48806 w 97589"/>
              <a:gd name="connsiteY5" fmla="*/ 73203 h 109788"/>
              <a:gd name="connsiteX6" fmla="*/ 12210 w 97589"/>
              <a:gd name="connsiteY6" fmla="*/ 109799 h 109788"/>
              <a:gd name="connsiteX7" fmla="*/ 24408 w 97589"/>
              <a:gd name="connsiteY7" fmla="*/ 61004 h 109788"/>
              <a:gd name="connsiteX8" fmla="*/ 11 w 97589"/>
              <a:gd name="connsiteY8" fmla="*/ 36607 h 109788"/>
              <a:gd name="connsiteX9" fmla="*/ 36607 w 97589"/>
              <a:gd name="connsiteY9" fmla="*/ 36607 h 109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7589" h="109788">
                <a:moveTo>
                  <a:pt x="48806" y="11"/>
                </a:moveTo>
                <a:lnTo>
                  <a:pt x="61004" y="36607"/>
                </a:lnTo>
                <a:lnTo>
                  <a:pt x="97600" y="36607"/>
                </a:lnTo>
                <a:lnTo>
                  <a:pt x="73203" y="61004"/>
                </a:lnTo>
                <a:lnTo>
                  <a:pt x="85402" y="109799"/>
                </a:lnTo>
                <a:lnTo>
                  <a:pt x="48806" y="73203"/>
                </a:lnTo>
                <a:lnTo>
                  <a:pt x="12210" y="109799"/>
                </a:lnTo>
                <a:lnTo>
                  <a:pt x="24408" y="61004"/>
                </a:lnTo>
                <a:lnTo>
                  <a:pt x="11" y="36607"/>
                </a:lnTo>
                <a:lnTo>
                  <a:pt x="36607" y="36607"/>
                </a:lnTo>
                <a:close/>
              </a:path>
            </a:pathLst>
          </a:custGeom>
          <a:solidFill>
            <a:srgbClr val="808080"/>
          </a:solidFill>
          <a:ln w="12185" cap="sq">
            <a:solidFill>
              <a:srgbClr val="80808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5" name="Freeform: Shape 253">
            <a:extLst>
              <a:ext uri="{FF2B5EF4-FFF2-40B4-BE49-F238E27FC236}">
                <a16:creationId xmlns:a16="http://schemas.microsoft.com/office/drawing/2014/main" id="{519D24CC-F3D2-9F09-B308-7E930FCA222F}"/>
              </a:ext>
            </a:extLst>
          </p:cNvPr>
          <p:cNvSpPr/>
          <p:nvPr/>
        </p:nvSpPr>
        <p:spPr>
          <a:xfrm>
            <a:off x="4901904" y="3798022"/>
            <a:ext cx="97589" cy="109788"/>
          </a:xfrm>
          <a:custGeom>
            <a:avLst/>
            <a:gdLst>
              <a:gd name="connsiteX0" fmla="*/ 48806 w 97589"/>
              <a:gd name="connsiteY0" fmla="*/ 11 h 109788"/>
              <a:gd name="connsiteX1" fmla="*/ 61004 w 97589"/>
              <a:gd name="connsiteY1" fmla="*/ 36607 h 109788"/>
              <a:gd name="connsiteX2" fmla="*/ 97600 w 97589"/>
              <a:gd name="connsiteY2" fmla="*/ 36607 h 109788"/>
              <a:gd name="connsiteX3" fmla="*/ 73203 w 97589"/>
              <a:gd name="connsiteY3" fmla="*/ 61004 h 109788"/>
              <a:gd name="connsiteX4" fmla="*/ 85402 w 97589"/>
              <a:gd name="connsiteY4" fmla="*/ 109799 h 109788"/>
              <a:gd name="connsiteX5" fmla="*/ 48806 w 97589"/>
              <a:gd name="connsiteY5" fmla="*/ 73203 h 109788"/>
              <a:gd name="connsiteX6" fmla="*/ 12210 w 97589"/>
              <a:gd name="connsiteY6" fmla="*/ 109799 h 109788"/>
              <a:gd name="connsiteX7" fmla="*/ 24408 w 97589"/>
              <a:gd name="connsiteY7" fmla="*/ 61004 h 109788"/>
              <a:gd name="connsiteX8" fmla="*/ 11 w 97589"/>
              <a:gd name="connsiteY8" fmla="*/ 36607 h 109788"/>
              <a:gd name="connsiteX9" fmla="*/ 36607 w 97589"/>
              <a:gd name="connsiteY9" fmla="*/ 36607 h 109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7589" h="109788">
                <a:moveTo>
                  <a:pt x="48806" y="11"/>
                </a:moveTo>
                <a:lnTo>
                  <a:pt x="61004" y="36607"/>
                </a:lnTo>
                <a:lnTo>
                  <a:pt x="97600" y="36607"/>
                </a:lnTo>
                <a:lnTo>
                  <a:pt x="73203" y="61004"/>
                </a:lnTo>
                <a:lnTo>
                  <a:pt x="85402" y="109799"/>
                </a:lnTo>
                <a:lnTo>
                  <a:pt x="48806" y="73203"/>
                </a:lnTo>
                <a:lnTo>
                  <a:pt x="12210" y="109799"/>
                </a:lnTo>
                <a:lnTo>
                  <a:pt x="24408" y="61004"/>
                </a:lnTo>
                <a:lnTo>
                  <a:pt x="11" y="36607"/>
                </a:lnTo>
                <a:lnTo>
                  <a:pt x="36607" y="36607"/>
                </a:lnTo>
                <a:close/>
              </a:path>
            </a:pathLst>
          </a:custGeom>
          <a:solidFill>
            <a:srgbClr val="808080"/>
          </a:solidFill>
          <a:ln w="12185" cap="sq">
            <a:solidFill>
              <a:srgbClr val="80808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6" name="Freeform: Shape 225">
            <a:extLst>
              <a:ext uri="{FF2B5EF4-FFF2-40B4-BE49-F238E27FC236}">
                <a16:creationId xmlns:a16="http://schemas.microsoft.com/office/drawing/2014/main" id="{F9AC8951-13F6-466F-5DC5-3B029ADE693B}"/>
              </a:ext>
            </a:extLst>
          </p:cNvPr>
          <p:cNvSpPr/>
          <p:nvPr/>
        </p:nvSpPr>
        <p:spPr>
          <a:xfrm>
            <a:off x="4478202" y="3527974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7" name="Freeform: Shape 253">
            <a:extLst>
              <a:ext uri="{FF2B5EF4-FFF2-40B4-BE49-F238E27FC236}">
                <a16:creationId xmlns:a16="http://schemas.microsoft.com/office/drawing/2014/main" id="{7F5F4700-F8C9-EC22-0C75-A95C2863629A}"/>
              </a:ext>
            </a:extLst>
          </p:cNvPr>
          <p:cNvSpPr/>
          <p:nvPr/>
        </p:nvSpPr>
        <p:spPr>
          <a:xfrm>
            <a:off x="4741884" y="2898862"/>
            <a:ext cx="97589" cy="109788"/>
          </a:xfrm>
          <a:custGeom>
            <a:avLst/>
            <a:gdLst>
              <a:gd name="connsiteX0" fmla="*/ 48806 w 97589"/>
              <a:gd name="connsiteY0" fmla="*/ 11 h 109788"/>
              <a:gd name="connsiteX1" fmla="*/ 61004 w 97589"/>
              <a:gd name="connsiteY1" fmla="*/ 36607 h 109788"/>
              <a:gd name="connsiteX2" fmla="*/ 97600 w 97589"/>
              <a:gd name="connsiteY2" fmla="*/ 36607 h 109788"/>
              <a:gd name="connsiteX3" fmla="*/ 73203 w 97589"/>
              <a:gd name="connsiteY3" fmla="*/ 61004 h 109788"/>
              <a:gd name="connsiteX4" fmla="*/ 85402 w 97589"/>
              <a:gd name="connsiteY4" fmla="*/ 109799 h 109788"/>
              <a:gd name="connsiteX5" fmla="*/ 48806 w 97589"/>
              <a:gd name="connsiteY5" fmla="*/ 73203 h 109788"/>
              <a:gd name="connsiteX6" fmla="*/ 12210 w 97589"/>
              <a:gd name="connsiteY6" fmla="*/ 109799 h 109788"/>
              <a:gd name="connsiteX7" fmla="*/ 24408 w 97589"/>
              <a:gd name="connsiteY7" fmla="*/ 61004 h 109788"/>
              <a:gd name="connsiteX8" fmla="*/ 11 w 97589"/>
              <a:gd name="connsiteY8" fmla="*/ 36607 h 109788"/>
              <a:gd name="connsiteX9" fmla="*/ 36607 w 97589"/>
              <a:gd name="connsiteY9" fmla="*/ 36607 h 109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7589" h="109788">
                <a:moveTo>
                  <a:pt x="48806" y="11"/>
                </a:moveTo>
                <a:lnTo>
                  <a:pt x="61004" y="36607"/>
                </a:lnTo>
                <a:lnTo>
                  <a:pt x="97600" y="36607"/>
                </a:lnTo>
                <a:lnTo>
                  <a:pt x="73203" y="61004"/>
                </a:lnTo>
                <a:lnTo>
                  <a:pt x="85402" y="109799"/>
                </a:lnTo>
                <a:lnTo>
                  <a:pt x="48806" y="73203"/>
                </a:lnTo>
                <a:lnTo>
                  <a:pt x="12210" y="109799"/>
                </a:lnTo>
                <a:lnTo>
                  <a:pt x="24408" y="61004"/>
                </a:lnTo>
                <a:lnTo>
                  <a:pt x="11" y="36607"/>
                </a:lnTo>
                <a:lnTo>
                  <a:pt x="36607" y="36607"/>
                </a:lnTo>
                <a:close/>
              </a:path>
            </a:pathLst>
          </a:custGeom>
          <a:solidFill>
            <a:srgbClr val="808080"/>
          </a:solidFill>
          <a:ln w="12185" cap="sq">
            <a:solidFill>
              <a:srgbClr val="80808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8" name="Freeform: Shape 253">
            <a:extLst>
              <a:ext uri="{FF2B5EF4-FFF2-40B4-BE49-F238E27FC236}">
                <a16:creationId xmlns:a16="http://schemas.microsoft.com/office/drawing/2014/main" id="{4E76FBF9-166A-FEFF-18B1-9E1552EA0869}"/>
              </a:ext>
            </a:extLst>
          </p:cNvPr>
          <p:cNvSpPr/>
          <p:nvPr/>
        </p:nvSpPr>
        <p:spPr>
          <a:xfrm>
            <a:off x="4802844" y="2586442"/>
            <a:ext cx="97589" cy="109788"/>
          </a:xfrm>
          <a:custGeom>
            <a:avLst/>
            <a:gdLst>
              <a:gd name="connsiteX0" fmla="*/ 48806 w 97589"/>
              <a:gd name="connsiteY0" fmla="*/ 11 h 109788"/>
              <a:gd name="connsiteX1" fmla="*/ 61004 w 97589"/>
              <a:gd name="connsiteY1" fmla="*/ 36607 h 109788"/>
              <a:gd name="connsiteX2" fmla="*/ 97600 w 97589"/>
              <a:gd name="connsiteY2" fmla="*/ 36607 h 109788"/>
              <a:gd name="connsiteX3" fmla="*/ 73203 w 97589"/>
              <a:gd name="connsiteY3" fmla="*/ 61004 h 109788"/>
              <a:gd name="connsiteX4" fmla="*/ 85402 w 97589"/>
              <a:gd name="connsiteY4" fmla="*/ 109799 h 109788"/>
              <a:gd name="connsiteX5" fmla="*/ 48806 w 97589"/>
              <a:gd name="connsiteY5" fmla="*/ 73203 h 109788"/>
              <a:gd name="connsiteX6" fmla="*/ 12210 w 97589"/>
              <a:gd name="connsiteY6" fmla="*/ 109799 h 109788"/>
              <a:gd name="connsiteX7" fmla="*/ 24408 w 97589"/>
              <a:gd name="connsiteY7" fmla="*/ 61004 h 109788"/>
              <a:gd name="connsiteX8" fmla="*/ 11 w 97589"/>
              <a:gd name="connsiteY8" fmla="*/ 36607 h 109788"/>
              <a:gd name="connsiteX9" fmla="*/ 36607 w 97589"/>
              <a:gd name="connsiteY9" fmla="*/ 36607 h 109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7589" h="109788">
                <a:moveTo>
                  <a:pt x="48806" y="11"/>
                </a:moveTo>
                <a:lnTo>
                  <a:pt x="61004" y="36607"/>
                </a:lnTo>
                <a:lnTo>
                  <a:pt x="97600" y="36607"/>
                </a:lnTo>
                <a:lnTo>
                  <a:pt x="73203" y="61004"/>
                </a:lnTo>
                <a:lnTo>
                  <a:pt x="85402" y="109799"/>
                </a:lnTo>
                <a:lnTo>
                  <a:pt x="48806" y="73203"/>
                </a:lnTo>
                <a:lnTo>
                  <a:pt x="12210" y="109799"/>
                </a:lnTo>
                <a:lnTo>
                  <a:pt x="24408" y="61004"/>
                </a:lnTo>
                <a:lnTo>
                  <a:pt x="11" y="36607"/>
                </a:lnTo>
                <a:lnTo>
                  <a:pt x="36607" y="36607"/>
                </a:lnTo>
                <a:close/>
              </a:path>
            </a:pathLst>
          </a:custGeom>
          <a:solidFill>
            <a:srgbClr val="808080"/>
          </a:solidFill>
          <a:ln w="12185" cap="sq">
            <a:solidFill>
              <a:srgbClr val="80808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97" name="Freeform: Shape 253">
            <a:extLst>
              <a:ext uri="{FF2B5EF4-FFF2-40B4-BE49-F238E27FC236}">
                <a16:creationId xmlns:a16="http://schemas.microsoft.com/office/drawing/2014/main" id="{8D6D2CA2-A2ED-8C3F-E2A9-F99631068E93}"/>
              </a:ext>
            </a:extLst>
          </p:cNvPr>
          <p:cNvSpPr/>
          <p:nvPr/>
        </p:nvSpPr>
        <p:spPr>
          <a:xfrm>
            <a:off x="4901904" y="2289262"/>
            <a:ext cx="97589" cy="109788"/>
          </a:xfrm>
          <a:custGeom>
            <a:avLst/>
            <a:gdLst>
              <a:gd name="connsiteX0" fmla="*/ 48806 w 97589"/>
              <a:gd name="connsiteY0" fmla="*/ 11 h 109788"/>
              <a:gd name="connsiteX1" fmla="*/ 61004 w 97589"/>
              <a:gd name="connsiteY1" fmla="*/ 36607 h 109788"/>
              <a:gd name="connsiteX2" fmla="*/ 97600 w 97589"/>
              <a:gd name="connsiteY2" fmla="*/ 36607 h 109788"/>
              <a:gd name="connsiteX3" fmla="*/ 73203 w 97589"/>
              <a:gd name="connsiteY3" fmla="*/ 61004 h 109788"/>
              <a:gd name="connsiteX4" fmla="*/ 85402 w 97589"/>
              <a:gd name="connsiteY4" fmla="*/ 109799 h 109788"/>
              <a:gd name="connsiteX5" fmla="*/ 48806 w 97589"/>
              <a:gd name="connsiteY5" fmla="*/ 73203 h 109788"/>
              <a:gd name="connsiteX6" fmla="*/ 12210 w 97589"/>
              <a:gd name="connsiteY6" fmla="*/ 109799 h 109788"/>
              <a:gd name="connsiteX7" fmla="*/ 24408 w 97589"/>
              <a:gd name="connsiteY7" fmla="*/ 61004 h 109788"/>
              <a:gd name="connsiteX8" fmla="*/ 11 w 97589"/>
              <a:gd name="connsiteY8" fmla="*/ 36607 h 109788"/>
              <a:gd name="connsiteX9" fmla="*/ 36607 w 97589"/>
              <a:gd name="connsiteY9" fmla="*/ 36607 h 1097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7589" h="109788">
                <a:moveTo>
                  <a:pt x="48806" y="11"/>
                </a:moveTo>
                <a:lnTo>
                  <a:pt x="61004" y="36607"/>
                </a:lnTo>
                <a:lnTo>
                  <a:pt x="97600" y="36607"/>
                </a:lnTo>
                <a:lnTo>
                  <a:pt x="73203" y="61004"/>
                </a:lnTo>
                <a:lnTo>
                  <a:pt x="85402" y="109799"/>
                </a:lnTo>
                <a:lnTo>
                  <a:pt x="48806" y="73203"/>
                </a:lnTo>
                <a:lnTo>
                  <a:pt x="12210" y="109799"/>
                </a:lnTo>
                <a:lnTo>
                  <a:pt x="24408" y="61004"/>
                </a:lnTo>
                <a:lnTo>
                  <a:pt x="11" y="36607"/>
                </a:lnTo>
                <a:lnTo>
                  <a:pt x="36607" y="36607"/>
                </a:lnTo>
                <a:close/>
              </a:path>
            </a:pathLst>
          </a:custGeom>
          <a:solidFill>
            <a:srgbClr val="808080"/>
          </a:solidFill>
          <a:ln w="12185" cap="sq">
            <a:solidFill>
              <a:srgbClr val="808080"/>
            </a:solidFill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3" name="Freeform: Shape 225">
            <a:extLst>
              <a:ext uri="{FF2B5EF4-FFF2-40B4-BE49-F238E27FC236}">
                <a16:creationId xmlns:a16="http://schemas.microsoft.com/office/drawing/2014/main" id="{E132BCF1-BFB6-1B7B-C8C0-5F48575826BB}"/>
              </a:ext>
            </a:extLst>
          </p:cNvPr>
          <p:cNvSpPr/>
          <p:nvPr/>
        </p:nvSpPr>
        <p:spPr>
          <a:xfrm>
            <a:off x="5803592" y="3237029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>
              <a:highlight>
                <a:srgbClr val="FFFF00"/>
              </a:highlight>
            </a:endParaRPr>
          </a:p>
        </p:txBody>
      </p:sp>
      <p:sp>
        <p:nvSpPr>
          <p:cNvPr id="88" name="Freeform: Shape 225">
            <a:extLst>
              <a:ext uri="{FF2B5EF4-FFF2-40B4-BE49-F238E27FC236}">
                <a16:creationId xmlns:a16="http://schemas.microsoft.com/office/drawing/2014/main" id="{B8F1F9A0-D6F5-ED1E-2ADD-4117A276CC43}"/>
              </a:ext>
            </a:extLst>
          </p:cNvPr>
          <p:cNvSpPr/>
          <p:nvPr/>
        </p:nvSpPr>
        <p:spPr>
          <a:xfrm>
            <a:off x="5078553" y="2299550"/>
            <a:ext cx="60993" cy="60993"/>
          </a:xfrm>
          <a:custGeom>
            <a:avLst/>
            <a:gdLst>
              <a:gd name="connsiteX0" fmla="*/ 11 w 60993"/>
              <a:gd name="connsiteY0" fmla="*/ 11 h 60993"/>
              <a:gd name="connsiteX1" fmla="*/ 61004 w 60993"/>
              <a:gd name="connsiteY1" fmla="*/ 11 h 60993"/>
              <a:gd name="connsiteX2" fmla="*/ 61004 w 60993"/>
              <a:gd name="connsiteY2" fmla="*/ 61004 h 60993"/>
              <a:gd name="connsiteX3" fmla="*/ 11 w 60993"/>
              <a:gd name="connsiteY3" fmla="*/ 61004 h 60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0993" h="60993">
                <a:moveTo>
                  <a:pt x="11" y="11"/>
                </a:moveTo>
                <a:lnTo>
                  <a:pt x="61004" y="11"/>
                </a:lnTo>
                <a:lnTo>
                  <a:pt x="61004" y="61004"/>
                </a:lnTo>
                <a:lnTo>
                  <a:pt x="11" y="61004"/>
                </a:lnTo>
                <a:close/>
              </a:path>
            </a:pathLst>
          </a:custGeom>
          <a:solidFill>
            <a:srgbClr val="FFFF00"/>
          </a:solidFill>
          <a:ln w="1218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>
              <a:highlight>
                <a:srgbClr val="FFFF00"/>
              </a:highlight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AC157B9-09F8-5485-5A5F-CA037A43EE20}"/>
              </a:ext>
            </a:extLst>
          </p:cNvPr>
          <p:cNvSpPr txBox="1"/>
          <p:nvPr/>
        </p:nvSpPr>
        <p:spPr>
          <a:xfrm>
            <a:off x="1230594" y="6293814"/>
            <a:ext cx="8503065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Supplemental Figure 1.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Swimming plot </a:t>
            </a:r>
            <a:r>
              <a:rPr lang="en-US" sz="105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about profile 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of the 13 patients who discontinued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toripalimab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therapy after 2 years of treatment. The response was evaluated by the investigators. S01039 experienced 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seudoprogression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initially. S01075 had immune unconfirmed disease progression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iuPD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) during the treatment course and immune confirmed disease progression (</a:t>
            </a:r>
            <a:r>
              <a:rPr lang="en-US" sz="105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icPD</a:t>
            </a:r>
            <a:r>
              <a:rPr lang="en-US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) eventually. </a:t>
            </a:r>
            <a:endParaRPr lang="en-US" sz="105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249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108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DengXian</vt:lpstr>
      <vt:lpstr>Aptos</vt:lpstr>
      <vt:lpstr>Arial</vt:lpstr>
      <vt:lpstr>Calibri</vt:lpstr>
      <vt:lpstr>Calibri Light</vt:lpstr>
      <vt:lpstr>MYingHei_18030_C-Medium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yang Wang</dc:creator>
  <cp:lastModifiedBy>Suzanne Watters</cp:lastModifiedBy>
  <cp:revision>24</cp:revision>
  <dcterms:created xsi:type="dcterms:W3CDTF">2023-12-22T07:09:49Z</dcterms:created>
  <dcterms:modified xsi:type="dcterms:W3CDTF">2024-03-03T17:44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5cb09a-2992-49d6-8ac9-5f63e7b1ad2f_Enabled">
    <vt:lpwstr>true</vt:lpwstr>
  </property>
  <property fmtid="{D5CDD505-2E9C-101B-9397-08002B2CF9AE}" pid="3" name="MSIP_Label_be5cb09a-2992-49d6-8ac9-5f63e7b1ad2f_SetDate">
    <vt:lpwstr>2024-03-03T17:43:47Z</vt:lpwstr>
  </property>
  <property fmtid="{D5CDD505-2E9C-101B-9397-08002B2CF9AE}" pid="4" name="MSIP_Label_be5cb09a-2992-49d6-8ac9-5f63e7b1ad2f_Method">
    <vt:lpwstr>Standard</vt:lpwstr>
  </property>
  <property fmtid="{D5CDD505-2E9C-101B-9397-08002B2CF9AE}" pid="5" name="MSIP_Label_be5cb09a-2992-49d6-8ac9-5f63e7b1ad2f_Name">
    <vt:lpwstr>Controlled</vt:lpwstr>
  </property>
  <property fmtid="{D5CDD505-2E9C-101B-9397-08002B2CF9AE}" pid="6" name="MSIP_Label_be5cb09a-2992-49d6-8ac9-5f63e7b1ad2f_SiteId">
    <vt:lpwstr>91761b62-4c45-43f5-9f0e-be8ad9b551ff</vt:lpwstr>
  </property>
  <property fmtid="{D5CDD505-2E9C-101B-9397-08002B2CF9AE}" pid="7" name="MSIP_Label_be5cb09a-2992-49d6-8ac9-5f63e7b1ad2f_ActionId">
    <vt:lpwstr>1802ab84-1e2b-4cd9-9200-e33f956e7bee</vt:lpwstr>
  </property>
  <property fmtid="{D5CDD505-2E9C-101B-9397-08002B2CF9AE}" pid="8" name="MSIP_Label_be5cb09a-2992-49d6-8ac9-5f63e7b1ad2f_ContentBits">
    <vt:lpwstr>0</vt:lpwstr>
  </property>
</Properties>
</file>